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81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  <p:sldId id="280" r:id="rId25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88C2AD0-7FBA-4ABD-A38B-2191A5A7DC24}" v="52" dt="2023-12-13T13:01:07.97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3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62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Relationship Id="rId30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tin Røssel Larsen" userId="e4500570-1497-4d24-876e-2d6b64ed7cd3" providerId="ADAL" clId="{388C2AD0-7FBA-4ABD-A38B-2191A5A7DC24}"/>
    <pc:docChg chg="undo custSel modSld">
      <pc:chgData name="Martin Røssel Larsen" userId="e4500570-1497-4d24-876e-2d6b64ed7cd3" providerId="ADAL" clId="{388C2AD0-7FBA-4ABD-A38B-2191A5A7DC24}" dt="2023-12-29T10:27:14.244" v="479" actId="1076"/>
      <pc:docMkLst>
        <pc:docMk/>
      </pc:docMkLst>
      <pc:sldChg chg="addSp delSp modSp mod">
        <pc:chgData name="Martin Røssel Larsen" userId="e4500570-1497-4d24-876e-2d6b64ed7cd3" providerId="ADAL" clId="{388C2AD0-7FBA-4ABD-A38B-2191A5A7DC24}" dt="2023-12-13T11:36:13.829" v="221" actId="1076"/>
        <pc:sldMkLst>
          <pc:docMk/>
          <pc:sldMk cId="4271762004" sldId="258"/>
        </pc:sldMkLst>
        <pc:spChg chg="add mod">
          <ac:chgData name="Martin Røssel Larsen" userId="e4500570-1497-4d24-876e-2d6b64ed7cd3" providerId="ADAL" clId="{388C2AD0-7FBA-4ABD-A38B-2191A5A7DC24}" dt="2023-12-13T11:36:13.829" v="221" actId="1076"/>
          <ac:spMkLst>
            <pc:docMk/>
            <pc:sldMk cId="4271762004" sldId="258"/>
            <ac:spMk id="4" creationId="{5A6C31FE-0DCD-3816-5777-1EC937AE6234}"/>
          </ac:spMkLst>
        </pc:spChg>
        <pc:spChg chg="mod">
          <ac:chgData name="Martin Røssel Larsen" userId="e4500570-1497-4d24-876e-2d6b64ed7cd3" providerId="ADAL" clId="{388C2AD0-7FBA-4ABD-A38B-2191A5A7DC24}" dt="2023-12-13T11:31:45.392" v="62" actId="1076"/>
          <ac:spMkLst>
            <pc:docMk/>
            <pc:sldMk cId="4271762004" sldId="258"/>
            <ac:spMk id="5" creationId="{40A0C8FE-9EA4-148C-B3FA-9DE2C1F7974F}"/>
          </ac:spMkLst>
        </pc:spChg>
        <pc:spChg chg="add del mod">
          <ac:chgData name="Martin Røssel Larsen" userId="e4500570-1497-4d24-876e-2d6b64ed7cd3" providerId="ADAL" clId="{388C2AD0-7FBA-4ABD-A38B-2191A5A7DC24}" dt="2023-12-13T11:35:20.126" v="179" actId="478"/>
          <ac:spMkLst>
            <pc:docMk/>
            <pc:sldMk cId="4271762004" sldId="258"/>
            <ac:spMk id="6" creationId="{4CD46F65-4ADB-072F-5FB7-0BC5ABCA6F55}"/>
          </ac:spMkLst>
        </pc:spChg>
        <pc:spChg chg="add mod">
          <ac:chgData name="Martin Røssel Larsen" userId="e4500570-1497-4d24-876e-2d6b64ed7cd3" providerId="ADAL" clId="{388C2AD0-7FBA-4ABD-A38B-2191A5A7DC24}" dt="2023-12-13T11:35:52.342" v="219" actId="1035"/>
          <ac:spMkLst>
            <pc:docMk/>
            <pc:sldMk cId="4271762004" sldId="258"/>
            <ac:spMk id="7" creationId="{1B40E8EA-AD62-920E-EB98-F27F587F7206}"/>
          </ac:spMkLst>
        </pc:spChg>
        <pc:spChg chg="mod">
          <ac:chgData name="Martin Røssel Larsen" userId="e4500570-1497-4d24-876e-2d6b64ed7cd3" providerId="ADAL" clId="{388C2AD0-7FBA-4ABD-A38B-2191A5A7DC24}" dt="2023-11-20T14:38:19.484" v="27" actId="1076"/>
          <ac:spMkLst>
            <pc:docMk/>
            <pc:sldMk cId="4271762004" sldId="258"/>
            <ac:spMk id="16" creationId="{F3A91954-6A39-F9A4-A39B-3291951D9B1F}"/>
          </ac:spMkLst>
        </pc:spChg>
        <pc:spChg chg="mod">
          <ac:chgData name="Martin Røssel Larsen" userId="e4500570-1497-4d24-876e-2d6b64ed7cd3" providerId="ADAL" clId="{388C2AD0-7FBA-4ABD-A38B-2191A5A7DC24}" dt="2023-12-13T11:31:45.392" v="62" actId="1076"/>
          <ac:spMkLst>
            <pc:docMk/>
            <pc:sldMk cId="4271762004" sldId="258"/>
            <ac:spMk id="17" creationId="{7136C541-D225-79B3-5CC1-2A0E3383498F}"/>
          </ac:spMkLst>
        </pc:spChg>
        <pc:spChg chg="mod">
          <ac:chgData name="Martin Røssel Larsen" userId="e4500570-1497-4d24-876e-2d6b64ed7cd3" providerId="ADAL" clId="{388C2AD0-7FBA-4ABD-A38B-2191A5A7DC24}" dt="2023-12-13T11:31:45.392" v="62" actId="1076"/>
          <ac:spMkLst>
            <pc:docMk/>
            <pc:sldMk cId="4271762004" sldId="258"/>
            <ac:spMk id="18" creationId="{499A4775-7A98-8010-2B9A-A3AA7B1BF2A7}"/>
          </ac:spMkLst>
        </pc:spChg>
        <pc:spChg chg="mod">
          <ac:chgData name="Martin Røssel Larsen" userId="e4500570-1497-4d24-876e-2d6b64ed7cd3" providerId="ADAL" clId="{388C2AD0-7FBA-4ABD-A38B-2191A5A7DC24}" dt="2023-12-13T11:31:45.392" v="62" actId="1076"/>
          <ac:spMkLst>
            <pc:docMk/>
            <pc:sldMk cId="4271762004" sldId="258"/>
            <ac:spMk id="21" creationId="{32F5FA7B-84E3-001C-4E61-508750BEA60C}"/>
          </ac:spMkLst>
        </pc:spChg>
        <pc:spChg chg="mod">
          <ac:chgData name="Martin Røssel Larsen" userId="e4500570-1497-4d24-876e-2d6b64ed7cd3" providerId="ADAL" clId="{388C2AD0-7FBA-4ABD-A38B-2191A5A7DC24}" dt="2023-12-13T11:31:45.392" v="62" actId="1076"/>
          <ac:spMkLst>
            <pc:docMk/>
            <pc:sldMk cId="4271762004" sldId="258"/>
            <ac:spMk id="24" creationId="{47A76BE0-859B-E812-99BB-5C3EE2CFEB6F}"/>
          </ac:spMkLst>
        </pc:spChg>
        <pc:picChg chg="add mod modCrop">
          <ac:chgData name="Martin Røssel Larsen" userId="e4500570-1497-4d24-876e-2d6b64ed7cd3" providerId="ADAL" clId="{388C2AD0-7FBA-4ABD-A38B-2191A5A7DC24}" dt="2023-12-13T11:36:11.518" v="220" actId="1076"/>
          <ac:picMkLst>
            <pc:docMk/>
            <pc:sldMk cId="4271762004" sldId="258"/>
            <ac:picMk id="3" creationId="{2CDE91C1-CC2E-4D34-4417-282A3455BC15}"/>
          </ac:picMkLst>
        </pc:picChg>
        <pc:picChg chg="mod">
          <ac:chgData name="Martin Røssel Larsen" userId="e4500570-1497-4d24-876e-2d6b64ed7cd3" providerId="ADAL" clId="{388C2AD0-7FBA-4ABD-A38B-2191A5A7DC24}" dt="2023-12-13T11:31:45.392" v="62" actId="1076"/>
          <ac:picMkLst>
            <pc:docMk/>
            <pc:sldMk cId="4271762004" sldId="258"/>
            <ac:picMk id="15" creationId="{B535C5C2-8C2E-686B-3C85-78DA544D2917}"/>
          </ac:picMkLst>
        </pc:picChg>
        <pc:cxnChg chg="mod">
          <ac:chgData name="Martin Røssel Larsen" userId="e4500570-1497-4d24-876e-2d6b64ed7cd3" providerId="ADAL" clId="{388C2AD0-7FBA-4ABD-A38B-2191A5A7DC24}" dt="2023-12-13T11:31:45.392" v="62" actId="1076"/>
          <ac:cxnSpMkLst>
            <pc:docMk/>
            <pc:sldMk cId="4271762004" sldId="258"/>
            <ac:cxnSpMk id="20" creationId="{7DCEE478-57A0-6324-D201-77ED881F6752}"/>
          </ac:cxnSpMkLst>
        </pc:cxnChg>
        <pc:cxnChg chg="mod">
          <ac:chgData name="Martin Røssel Larsen" userId="e4500570-1497-4d24-876e-2d6b64ed7cd3" providerId="ADAL" clId="{388C2AD0-7FBA-4ABD-A38B-2191A5A7DC24}" dt="2023-12-13T11:31:45.392" v="62" actId="1076"/>
          <ac:cxnSpMkLst>
            <pc:docMk/>
            <pc:sldMk cId="4271762004" sldId="258"/>
            <ac:cxnSpMk id="27" creationId="{B275DEF2-AB69-2669-E25A-58C857148F53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1:34:47.557" v="177" actId="1076"/>
        <pc:sldMkLst>
          <pc:docMk/>
          <pc:sldMk cId="3415666730" sldId="259"/>
        </pc:sldMkLst>
        <pc:spChg chg="mod">
          <ac:chgData name="Martin Røssel Larsen" userId="e4500570-1497-4d24-876e-2d6b64ed7cd3" providerId="ADAL" clId="{388C2AD0-7FBA-4ABD-A38B-2191A5A7DC24}" dt="2023-12-13T11:33:58.752" v="151" actId="1038"/>
          <ac:spMkLst>
            <pc:docMk/>
            <pc:sldMk cId="3415666730" sldId="259"/>
            <ac:spMk id="2" creationId="{3D61D5A7-FA35-56D1-B9A4-89FBDCCF79C9}"/>
          </ac:spMkLst>
        </pc:spChg>
        <pc:spChg chg="mod">
          <ac:chgData name="Martin Røssel Larsen" userId="e4500570-1497-4d24-876e-2d6b64ed7cd3" providerId="ADAL" clId="{388C2AD0-7FBA-4ABD-A38B-2191A5A7DC24}" dt="2023-11-20T14:38:26.371" v="29" actId="1076"/>
          <ac:spMkLst>
            <pc:docMk/>
            <pc:sldMk cId="3415666730" sldId="259"/>
            <ac:spMk id="4" creationId="{323F2526-8826-B158-9A76-5F2A26C027FF}"/>
          </ac:spMkLst>
        </pc:spChg>
        <pc:spChg chg="mod">
          <ac:chgData name="Martin Røssel Larsen" userId="e4500570-1497-4d24-876e-2d6b64ed7cd3" providerId="ADAL" clId="{388C2AD0-7FBA-4ABD-A38B-2191A5A7DC24}" dt="2023-12-13T11:33:58.752" v="151" actId="1038"/>
          <ac:spMkLst>
            <pc:docMk/>
            <pc:sldMk cId="3415666730" sldId="259"/>
            <ac:spMk id="5" creationId="{37D4A72F-1B02-5300-2AC9-EBD032AFF959}"/>
          </ac:spMkLst>
        </pc:spChg>
        <pc:spChg chg="mod">
          <ac:chgData name="Martin Røssel Larsen" userId="e4500570-1497-4d24-876e-2d6b64ed7cd3" providerId="ADAL" clId="{388C2AD0-7FBA-4ABD-A38B-2191A5A7DC24}" dt="2023-12-13T11:33:58.752" v="151" actId="1038"/>
          <ac:spMkLst>
            <pc:docMk/>
            <pc:sldMk cId="3415666730" sldId="259"/>
            <ac:spMk id="6" creationId="{DAF1DF87-3E2F-DD33-AD36-44E8C1D4B247}"/>
          </ac:spMkLst>
        </pc:spChg>
        <pc:spChg chg="mod">
          <ac:chgData name="Martin Røssel Larsen" userId="e4500570-1497-4d24-876e-2d6b64ed7cd3" providerId="ADAL" clId="{388C2AD0-7FBA-4ABD-A38B-2191A5A7DC24}" dt="2023-12-13T11:34:40.926" v="172" actId="1038"/>
          <ac:spMkLst>
            <pc:docMk/>
            <pc:sldMk cId="3415666730" sldId="259"/>
            <ac:spMk id="8" creationId="{CC9FD6E0-DCAB-5513-BBEF-EF2126B8AAD5}"/>
          </ac:spMkLst>
        </pc:spChg>
        <pc:spChg chg="mod">
          <ac:chgData name="Martin Røssel Larsen" userId="e4500570-1497-4d24-876e-2d6b64ed7cd3" providerId="ADAL" clId="{388C2AD0-7FBA-4ABD-A38B-2191A5A7DC24}" dt="2023-12-13T11:34:40.926" v="172" actId="1038"/>
          <ac:spMkLst>
            <pc:docMk/>
            <pc:sldMk cId="3415666730" sldId="259"/>
            <ac:spMk id="9" creationId="{09475843-532B-5003-954C-57E9C2CFCEAF}"/>
          </ac:spMkLst>
        </pc:spChg>
        <pc:spChg chg="add mod">
          <ac:chgData name="Martin Røssel Larsen" userId="e4500570-1497-4d24-876e-2d6b64ed7cd3" providerId="ADAL" clId="{388C2AD0-7FBA-4ABD-A38B-2191A5A7DC24}" dt="2023-12-13T11:34:46.045" v="176" actId="1076"/>
          <ac:spMkLst>
            <pc:docMk/>
            <pc:sldMk cId="3415666730" sldId="259"/>
            <ac:spMk id="10" creationId="{2271E5F9-AB63-D66A-EB21-DDEF433868E1}"/>
          </ac:spMkLst>
        </pc:spChg>
        <pc:picChg chg="mod ord">
          <ac:chgData name="Martin Røssel Larsen" userId="e4500570-1497-4d24-876e-2d6b64ed7cd3" providerId="ADAL" clId="{388C2AD0-7FBA-4ABD-A38B-2191A5A7DC24}" dt="2023-12-13T11:34:42.239" v="175" actId="1038"/>
          <ac:picMkLst>
            <pc:docMk/>
            <pc:sldMk cId="3415666730" sldId="259"/>
            <ac:picMk id="3" creationId="{844D539C-DD69-54FC-F2DB-279CBFD54F1C}"/>
          </ac:picMkLst>
        </pc:picChg>
        <pc:picChg chg="add mod ord modCrop">
          <ac:chgData name="Martin Røssel Larsen" userId="e4500570-1497-4d24-876e-2d6b64ed7cd3" providerId="ADAL" clId="{388C2AD0-7FBA-4ABD-A38B-2191A5A7DC24}" dt="2023-12-13T11:34:47.557" v="177" actId="1076"/>
          <ac:picMkLst>
            <pc:docMk/>
            <pc:sldMk cId="3415666730" sldId="259"/>
            <ac:picMk id="13" creationId="{169224E5-5BFF-8A7D-B40C-A6F415E30460}"/>
          </ac:picMkLst>
        </pc:picChg>
        <pc:cxnChg chg="mod">
          <ac:chgData name="Martin Røssel Larsen" userId="e4500570-1497-4d24-876e-2d6b64ed7cd3" providerId="ADAL" clId="{388C2AD0-7FBA-4ABD-A38B-2191A5A7DC24}" dt="2023-12-13T11:34:40.926" v="172" actId="1038"/>
          <ac:cxnSpMkLst>
            <pc:docMk/>
            <pc:sldMk cId="3415666730" sldId="259"/>
            <ac:cxnSpMk id="7" creationId="{3CBB0BFD-5898-7C5D-F4A7-3A60F3C87272}"/>
          </ac:cxnSpMkLst>
        </pc:cxnChg>
        <pc:cxnChg chg="mod">
          <ac:chgData name="Martin Røssel Larsen" userId="e4500570-1497-4d24-876e-2d6b64ed7cd3" providerId="ADAL" clId="{388C2AD0-7FBA-4ABD-A38B-2191A5A7DC24}" dt="2023-12-13T11:34:40.926" v="172" actId="1038"/>
          <ac:cxnSpMkLst>
            <pc:docMk/>
            <pc:sldMk cId="3415666730" sldId="259"/>
            <ac:cxnSpMk id="11" creationId="{6E91E86F-D56F-DA05-8166-0DFC2052F922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1:37:51.484" v="239" actId="1076"/>
        <pc:sldMkLst>
          <pc:docMk/>
          <pc:sldMk cId="1396748838" sldId="260"/>
        </pc:sldMkLst>
        <pc:spChg chg="add mod">
          <ac:chgData name="Martin Røssel Larsen" userId="e4500570-1497-4d24-876e-2d6b64ed7cd3" providerId="ADAL" clId="{388C2AD0-7FBA-4ABD-A38B-2191A5A7DC24}" dt="2023-12-13T11:37:51.484" v="239" actId="1076"/>
          <ac:spMkLst>
            <pc:docMk/>
            <pc:sldMk cId="1396748838" sldId="260"/>
            <ac:spMk id="2" creationId="{00726100-AB9C-F376-7F92-FE8F2F31DF39}"/>
          </ac:spMkLst>
        </pc:spChg>
        <pc:spChg chg="mod">
          <ac:chgData name="Martin Røssel Larsen" userId="e4500570-1497-4d24-876e-2d6b64ed7cd3" providerId="ADAL" clId="{388C2AD0-7FBA-4ABD-A38B-2191A5A7DC24}" dt="2023-11-20T14:38:37.691" v="33" actId="1076"/>
          <ac:spMkLst>
            <pc:docMk/>
            <pc:sldMk cId="1396748838" sldId="260"/>
            <ac:spMk id="7" creationId="{053D151F-BA7E-C25E-CD59-659E8F04F98C}"/>
          </ac:spMkLst>
        </pc:spChg>
        <pc:picChg chg="add mod modCrop">
          <ac:chgData name="Martin Røssel Larsen" userId="e4500570-1497-4d24-876e-2d6b64ed7cd3" providerId="ADAL" clId="{388C2AD0-7FBA-4ABD-A38B-2191A5A7DC24}" dt="2023-12-13T11:37:48.380" v="238" actId="1076"/>
          <ac:picMkLst>
            <pc:docMk/>
            <pc:sldMk cId="1396748838" sldId="260"/>
            <ac:picMk id="4" creationId="{0364EA77-6193-0AD3-60A1-404BC6E58838}"/>
          </ac:picMkLst>
        </pc:picChg>
      </pc:sldChg>
      <pc:sldChg chg="addSp modSp mod">
        <pc:chgData name="Martin Røssel Larsen" userId="e4500570-1497-4d24-876e-2d6b64ed7cd3" providerId="ADAL" clId="{388C2AD0-7FBA-4ABD-A38B-2191A5A7DC24}" dt="2023-12-13T11:50:49.843" v="250" actId="1076"/>
        <pc:sldMkLst>
          <pc:docMk/>
          <pc:sldMk cId="1275352322" sldId="261"/>
        </pc:sldMkLst>
        <pc:spChg chg="mod">
          <ac:chgData name="Martin Røssel Larsen" userId="e4500570-1497-4d24-876e-2d6b64ed7cd3" providerId="ADAL" clId="{388C2AD0-7FBA-4ABD-A38B-2191A5A7DC24}" dt="2023-11-20T14:38:50.272" v="34" actId="20577"/>
          <ac:spMkLst>
            <pc:docMk/>
            <pc:sldMk cId="1275352322" sldId="261"/>
            <ac:spMk id="3" creationId="{95361C0C-B409-8CAB-9853-AF321D8E76BA}"/>
          </ac:spMkLst>
        </pc:spChg>
        <pc:spChg chg="mod">
          <ac:chgData name="Martin Røssel Larsen" userId="e4500570-1497-4d24-876e-2d6b64ed7cd3" providerId="ADAL" clId="{388C2AD0-7FBA-4ABD-A38B-2191A5A7DC24}" dt="2023-12-13T11:50:42.970" v="248" actId="1076"/>
          <ac:spMkLst>
            <pc:docMk/>
            <pc:sldMk cId="1275352322" sldId="261"/>
            <ac:spMk id="4" creationId="{79E8B1DA-C784-A792-2E03-32159EDAFE66}"/>
          </ac:spMkLst>
        </pc:spChg>
        <pc:spChg chg="add mod">
          <ac:chgData name="Martin Røssel Larsen" userId="e4500570-1497-4d24-876e-2d6b64ed7cd3" providerId="ADAL" clId="{388C2AD0-7FBA-4ABD-A38B-2191A5A7DC24}" dt="2023-12-13T11:50:49.843" v="250" actId="1076"/>
          <ac:spMkLst>
            <pc:docMk/>
            <pc:sldMk cId="1275352322" sldId="261"/>
            <ac:spMk id="6" creationId="{E37D4992-F3D4-D360-632C-BF3806411779}"/>
          </ac:spMkLst>
        </pc:spChg>
        <pc:spChg chg="mod">
          <ac:chgData name="Martin Røssel Larsen" userId="e4500570-1497-4d24-876e-2d6b64ed7cd3" providerId="ADAL" clId="{388C2AD0-7FBA-4ABD-A38B-2191A5A7DC24}" dt="2023-12-13T11:50:42.970" v="248" actId="1076"/>
          <ac:spMkLst>
            <pc:docMk/>
            <pc:sldMk cId="1275352322" sldId="261"/>
            <ac:spMk id="15" creationId="{F1216898-96D6-D39B-4E7B-27902099443C}"/>
          </ac:spMkLst>
        </pc:spChg>
        <pc:spChg chg="mod">
          <ac:chgData name="Martin Røssel Larsen" userId="e4500570-1497-4d24-876e-2d6b64ed7cd3" providerId="ADAL" clId="{388C2AD0-7FBA-4ABD-A38B-2191A5A7DC24}" dt="2023-12-13T11:50:42.970" v="248" actId="1076"/>
          <ac:spMkLst>
            <pc:docMk/>
            <pc:sldMk cId="1275352322" sldId="261"/>
            <ac:spMk id="17" creationId="{94516012-0663-EAD0-7CAA-CC5B81239638}"/>
          </ac:spMkLst>
        </pc:spChg>
        <pc:spChg chg="mod">
          <ac:chgData name="Martin Røssel Larsen" userId="e4500570-1497-4d24-876e-2d6b64ed7cd3" providerId="ADAL" clId="{388C2AD0-7FBA-4ABD-A38B-2191A5A7DC24}" dt="2023-12-13T11:50:42.970" v="248" actId="1076"/>
          <ac:spMkLst>
            <pc:docMk/>
            <pc:sldMk cId="1275352322" sldId="261"/>
            <ac:spMk id="18" creationId="{212C07D4-8BE7-1CEC-C566-D5FDB094DF7E}"/>
          </ac:spMkLst>
        </pc:spChg>
        <pc:spChg chg="mod">
          <ac:chgData name="Martin Røssel Larsen" userId="e4500570-1497-4d24-876e-2d6b64ed7cd3" providerId="ADAL" clId="{388C2AD0-7FBA-4ABD-A38B-2191A5A7DC24}" dt="2023-12-13T11:50:42.970" v="248" actId="1076"/>
          <ac:spMkLst>
            <pc:docMk/>
            <pc:sldMk cId="1275352322" sldId="261"/>
            <ac:spMk id="19" creationId="{C81E295E-A344-4E94-ED7C-FC172C770CCC}"/>
          </ac:spMkLst>
        </pc:spChg>
        <pc:picChg chg="mod">
          <ac:chgData name="Martin Røssel Larsen" userId="e4500570-1497-4d24-876e-2d6b64ed7cd3" providerId="ADAL" clId="{388C2AD0-7FBA-4ABD-A38B-2191A5A7DC24}" dt="2023-12-13T11:50:42.970" v="248" actId="1076"/>
          <ac:picMkLst>
            <pc:docMk/>
            <pc:sldMk cId="1275352322" sldId="261"/>
            <ac:picMk id="2" creationId="{7A670AD5-274B-E995-82F3-A1E90E78F913}"/>
          </ac:picMkLst>
        </pc:picChg>
        <pc:picChg chg="add mod modCrop">
          <ac:chgData name="Martin Røssel Larsen" userId="e4500570-1497-4d24-876e-2d6b64ed7cd3" providerId="ADAL" clId="{388C2AD0-7FBA-4ABD-A38B-2191A5A7DC24}" dt="2023-12-13T11:50:45.905" v="249" actId="1076"/>
          <ac:picMkLst>
            <pc:docMk/>
            <pc:sldMk cId="1275352322" sldId="261"/>
            <ac:picMk id="7" creationId="{982C7DAC-4CB5-9ED6-CE15-96E6C0007ABD}"/>
          </ac:picMkLst>
        </pc:picChg>
        <pc:picChg chg="mod">
          <ac:chgData name="Martin Røssel Larsen" userId="e4500570-1497-4d24-876e-2d6b64ed7cd3" providerId="ADAL" clId="{388C2AD0-7FBA-4ABD-A38B-2191A5A7DC24}" dt="2023-12-13T11:50:42.970" v="248" actId="1076"/>
          <ac:picMkLst>
            <pc:docMk/>
            <pc:sldMk cId="1275352322" sldId="261"/>
            <ac:picMk id="9" creationId="{717FF546-92D6-4980-D0BC-8BA65E6DC0F1}"/>
          </ac:picMkLst>
        </pc:picChg>
        <pc:cxnChg chg="mod">
          <ac:chgData name="Martin Røssel Larsen" userId="e4500570-1497-4d24-876e-2d6b64ed7cd3" providerId="ADAL" clId="{388C2AD0-7FBA-4ABD-A38B-2191A5A7DC24}" dt="2023-12-13T11:50:42.970" v="248" actId="1076"/>
          <ac:cxnSpMkLst>
            <pc:docMk/>
            <pc:sldMk cId="1275352322" sldId="261"/>
            <ac:cxnSpMk id="5" creationId="{B3A3E633-05CD-D133-2EB5-76D71F4DE574}"/>
          </ac:cxnSpMkLst>
        </pc:cxnChg>
        <pc:cxnChg chg="mod">
          <ac:chgData name="Martin Røssel Larsen" userId="e4500570-1497-4d24-876e-2d6b64ed7cd3" providerId="ADAL" clId="{388C2AD0-7FBA-4ABD-A38B-2191A5A7DC24}" dt="2023-12-13T11:50:42.970" v="248" actId="1076"/>
          <ac:cxnSpMkLst>
            <pc:docMk/>
            <pc:sldMk cId="1275352322" sldId="261"/>
            <ac:cxnSpMk id="16" creationId="{F33E079A-7776-4510-9C7A-5226FAF660BF}"/>
          </ac:cxnSpMkLst>
        </pc:cxnChg>
        <pc:cxnChg chg="mod">
          <ac:chgData name="Martin Røssel Larsen" userId="e4500570-1497-4d24-876e-2d6b64ed7cd3" providerId="ADAL" clId="{388C2AD0-7FBA-4ABD-A38B-2191A5A7DC24}" dt="2023-12-13T11:50:42.970" v="248" actId="1076"/>
          <ac:cxnSpMkLst>
            <pc:docMk/>
            <pc:sldMk cId="1275352322" sldId="261"/>
            <ac:cxnSpMk id="20" creationId="{11F83475-4A46-E2EF-124C-85B8E01D9104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1:57:50.976" v="265" actId="1076"/>
        <pc:sldMkLst>
          <pc:docMk/>
          <pc:sldMk cId="268047142" sldId="262"/>
        </pc:sldMkLst>
        <pc:spChg chg="add mod">
          <ac:chgData name="Martin Røssel Larsen" userId="e4500570-1497-4d24-876e-2d6b64ed7cd3" providerId="ADAL" clId="{388C2AD0-7FBA-4ABD-A38B-2191A5A7DC24}" dt="2023-12-13T11:57:43.511" v="264" actId="1076"/>
          <ac:spMkLst>
            <pc:docMk/>
            <pc:sldMk cId="268047142" sldId="262"/>
            <ac:spMk id="2" creationId="{9F320E8D-0C9E-B4D0-8597-E5E82C324ADA}"/>
          </ac:spMkLst>
        </pc:spChg>
        <pc:spChg chg="mod">
          <ac:chgData name="Martin Røssel Larsen" userId="e4500570-1497-4d24-876e-2d6b64ed7cd3" providerId="ADAL" clId="{388C2AD0-7FBA-4ABD-A38B-2191A5A7DC24}" dt="2023-12-13T11:57:50.976" v="265" actId="1076"/>
          <ac:spMkLst>
            <pc:docMk/>
            <pc:sldMk cId="268047142" sldId="262"/>
            <ac:spMk id="7" creationId="{B1B6493A-E35A-349D-A5AE-E9AA4D507726}"/>
          </ac:spMkLst>
        </pc:spChg>
        <pc:spChg chg="mod">
          <ac:chgData name="Martin Røssel Larsen" userId="e4500570-1497-4d24-876e-2d6b64ed7cd3" providerId="ADAL" clId="{388C2AD0-7FBA-4ABD-A38B-2191A5A7DC24}" dt="2023-12-13T11:57:50.976" v="265" actId="1076"/>
          <ac:spMkLst>
            <pc:docMk/>
            <pc:sldMk cId="268047142" sldId="262"/>
            <ac:spMk id="8" creationId="{6FDEC5B6-66D3-2E5F-983A-0610ED9C3005}"/>
          </ac:spMkLst>
        </pc:spChg>
        <pc:spChg chg="mod">
          <ac:chgData name="Martin Røssel Larsen" userId="e4500570-1497-4d24-876e-2d6b64ed7cd3" providerId="ADAL" clId="{388C2AD0-7FBA-4ABD-A38B-2191A5A7DC24}" dt="2023-12-13T11:57:50.976" v="265" actId="1076"/>
          <ac:spMkLst>
            <pc:docMk/>
            <pc:sldMk cId="268047142" sldId="262"/>
            <ac:spMk id="10" creationId="{77588AEB-5FC4-0765-7B4C-2CD1C2D154E4}"/>
          </ac:spMkLst>
        </pc:spChg>
        <pc:spChg chg="mod">
          <ac:chgData name="Martin Røssel Larsen" userId="e4500570-1497-4d24-876e-2d6b64ed7cd3" providerId="ADAL" clId="{388C2AD0-7FBA-4ABD-A38B-2191A5A7DC24}" dt="2023-12-13T11:57:50.976" v="265" actId="1076"/>
          <ac:spMkLst>
            <pc:docMk/>
            <pc:sldMk cId="268047142" sldId="262"/>
            <ac:spMk id="11" creationId="{9C78A935-4AE8-954A-1A86-73601F90B31B}"/>
          </ac:spMkLst>
        </pc:spChg>
        <pc:spChg chg="mod">
          <ac:chgData name="Martin Røssel Larsen" userId="e4500570-1497-4d24-876e-2d6b64ed7cd3" providerId="ADAL" clId="{388C2AD0-7FBA-4ABD-A38B-2191A5A7DC24}" dt="2023-12-13T11:57:50.976" v="265" actId="1076"/>
          <ac:spMkLst>
            <pc:docMk/>
            <pc:sldMk cId="268047142" sldId="262"/>
            <ac:spMk id="12" creationId="{79863846-10C3-E118-8F42-E846F84F1098}"/>
          </ac:spMkLst>
        </pc:spChg>
        <pc:spChg chg="mod">
          <ac:chgData name="Martin Røssel Larsen" userId="e4500570-1497-4d24-876e-2d6b64ed7cd3" providerId="ADAL" clId="{388C2AD0-7FBA-4ABD-A38B-2191A5A7DC24}" dt="2023-12-13T11:57:50.976" v="265" actId="1076"/>
          <ac:spMkLst>
            <pc:docMk/>
            <pc:sldMk cId="268047142" sldId="262"/>
            <ac:spMk id="16" creationId="{E357F945-B30B-0F94-0AE3-EF9A0587265F}"/>
          </ac:spMkLst>
        </pc:spChg>
        <pc:spChg chg="mod">
          <ac:chgData name="Martin Røssel Larsen" userId="e4500570-1497-4d24-876e-2d6b64ed7cd3" providerId="ADAL" clId="{388C2AD0-7FBA-4ABD-A38B-2191A5A7DC24}" dt="2023-12-13T11:57:50.976" v="265" actId="1076"/>
          <ac:spMkLst>
            <pc:docMk/>
            <pc:sldMk cId="268047142" sldId="262"/>
            <ac:spMk id="17" creationId="{B075F0E0-9F49-930A-56E0-67A1981B22E6}"/>
          </ac:spMkLst>
        </pc:spChg>
        <pc:spChg chg="mod">
          <ac:chgData name="Martin Røssel Larsen" userId="e4500570-1497-4d24-876e-2d6b64ed7cd3" providerId="ADAL" clId="{388C2AD0-7FBA-4ABD-A38B-2191A5A7DC24}" dt="2023-12-13T11:57:50.976" v="265" actId="1076"/>
          <ac:spMkLst>
            <pc:docMk/>
            <pc:sldMk cId="268047142" sldId="262"/>
            <ac:spMk id="18" creationId="{13FA66AF-4709-C1BD-3893-ABC307A224C4}"/>
          </ac:spMkLst>
        </pc:spChg>
        <pc:picChg chg="mod">
          <ac:chgData name="Martin Røssel Larsen" userId="e4500570-1497-4d24-876e-2d6b64ed7cd3" providerId="ADAL" clId="{388C2AD0-7FBA-4ABD-A38B-2191A5A7DC24}" dt="2023-12-13T11:57:50.976" v="265" actId="1076"/>
          <ac:picMkLst>
            <pc:docMk/>
            <pc:sldMk cId="268047142" sldId="262"/>
            <ac:picMk id="3" creationId="{73856982-7B6E-6632-4FD7-E3AFBF5A5D5E}"/>
          </ac:picMkLst>
        </pc:picChg>
        <pc:picChg chg="add mod modCrop">
          <ac:chgData name="Martin Røssel Larsen" userId="e4500570-1497-4d24-876e-2d6b64ed7cd3" providerId="ADAL" clId="{388C2AD0-7FBA-4ABD-A38B-2191A5A7DC24}" dt="2023-12-13T11:57:39.759" v="263" actId="1076"/>
          <ac:picMkLst>
            <pc:docMk/>
            <pc:sldMk cId="268047142" sldId="262"/>
            <ac:picMk id="4" creationId="{A037B785-9A90-917D-01ED-409E1CD74751}"/>
          </ac:picMkLst>
        </pc:picChg>
        <pc:cxnChg chg="mod">
          <ac:chgData name="Martin Røssel Larsen" userId="e4500570-1497-4d24-876e-2d6b64ed7cd3" providerId="ADAL" clId="{388C2AD0-7FBA-4ABD-A38B-2191A5A7DC24}" dt="2023-12-13T11:57:50.976" v="265" actId="1076"/>
          <ac:cxnSpMkLst>
            <pc:docMk/>
            <pc:sldMk cId="268047142" sldId="262"/>
            <ac:cxnSpMk id="9" creationId="{29635BCA-C331-2E48-47B8-35D96D32F64C}"/>
          </ac:cxnSpMkLst>
        </pc:cxnChg>
        <pc:cxnChg chg="mod">
          <ac:chgData name="Martin Røssel Larsen" userId="e4500570-1497-4d24-876e-2d6b64ed7cd3" providerId="ADAL" clId="{388C2AD0-7FBA-4ABD-A38B-2191A5A7DC24}" dt="2023-12-13T11:57:50.976" v="265" actId="1076"/>
          <ac:cxnSpMkLst>
            <pc:docMk/>
            <pc:sldMk cId="268047142" sldId="262"/>
            <ac:cxnSpMk id="13" creationId="{08C41F74-1E02-90C4-E37B-577A824AEDB1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1:59:03.415" v="276" actId="14100"/>
        <pc:sldMkLst>
          <pc:docMk/>
          <pc:sldMk cId="132793540" sldId="263"/>
        </pc:sldMkLst>
        <pc:spChg chg="add mod">
          <ac:chgData name="Martin Røssel Larsen" userId="e4500570-1497-4d24-876e-2d6b64ed7cd3" providerId="ADAL" clId="{388C2AD0-7FBA-4ABD-A38B-2191A5A7DC24}" dt="2023-12-13T11:58:59.632" v="275" actId="1076"/>
          <ac:spMkLst>
            <pc:docMk/>
            <pc:sldMk cId="132793540" sldId="263"/>
            <ac:spMk id="2" creationId="{59619311-EB08-D154-667E-1C30E06B5E98}"/>
          </ac:spMkLst>
        </pc:spChg>
        <pc:spChg chg="mod">
          <ac:chgData name="Martin Røssel Larsen" userId="e4500570-1497-4d24-876e-2d6b64ed7cd3" providerId="ADAL" clId="{388C2AD0-7FBA-4ABD-A38B-2191A5A7DC24}" dt="2023-11-20T14:39:09.879" v="36" actId="20577"/>
          <ac:spMkLst>
            <pc:docMk/>
            <pc:sldMk cId="132793540" sldId="263"/>
            <ac:spMk id="7" creationId="{1240CEA9-641C-454D-23C1-C869935B3035}"/>
          </ac:spMkLst>
        </pc:spChg>
        <pc:picChg chg="add mod modCrop">
          <ac:chgData name="Martin Røssel Larsen" userId="e4500570-1497-4d24-876e-2d6b64ed7cd3" providerId="ADAL" clId="{388C2AD0-7FBA-4ABD-A38B-2191A5A7DC24}" dt="2023-12-13T11:59:03.415" v="276" actId="14100"/>
          <ac:picMkLst>
            <pc:docMk/>
            <pc:sldMk cId="132793540" sldId="263"/>
            <ac:picMk id="4" creationId="{40BE3299-2C25-56F5-8A3F-4F854F55594B}"/>
          </ac:picMkLst>
        </pc:picChg>
      </pc:sldChg>
      <pc:sldChg chg="addSp modSp mod">
        <pc:chgData name="Martin Røssel Larsen" userId="e4500570-1497-4d24-876e-2d6b64ed7cd3" providerId="ADAL" clId="{388C2AD0-7FBA-4ABD-A38B-2191A5A7DC24}" dt="2023-12-13T12:00:22.335" v="285" actId="1076"/>
        <pc:sldMkLst>
          <pc:docMk/>
          <pc:sldMk cId="2082008688" sldId="264"/>
        </pc:sldMkLst>
        <pc:spChg chg="add mod">
          <ac:chgData name="Martin Røssel Larsen" userId="e4500570-1497-4d24-876e-2d6b64ed7cd3" providerId="ADAL" clId="{388C2AD0-7FBA-4ABD-A38B-2191A5A7DC24}" dt="2023-12-13T11:32:39.148" v="105"/>
          <ac:spMkLst>
            <pc:docMk/>
            <pc:sldMk cId="2082008688" sldId="264"/>
            <ac:spMk id="2" creationId="{831BDECC-1173-B29E-739F-1429DC6CFD19}"/>
          </ac:spMkLst>
        </pc:spChg>
        <pc:spChg chg="mod">
          <ac:chgData name="Martin Røssel Larsen" userId="e4500570-1497-4d24-876e-2d6b64ed7cd3" providerId="ADAL" clId="{388C2AD0-7FBA-4ABD-A38B-2191A5A7DC24}" dt="2023-11-20T14:39:21.272" v="37" actId="20577"/>
          <ac:spMkLst>
            <pc:docMk/>
            <pc:sldMk cId="2082008688" sldId="264"/>
            <ac:spMk id="7" creationId="{F13B9EFC-3ACF-1AA5-EE40-6988806F7981}"/>
          </ac:spMkLst>
        </pc:spChg>
        <pc:spChg chg="mod">
          <ac:chgData name="Martin Røssel Larsen" userId="e4500570-1497-4d24-876e-2d6b64ed7cd3" providerId="ADAL" clId="{388C2AD0-7FBA-4ABD-A38B-2191A5A7DC24}" dt="2023-12-13T11:59:56.454" v="277" actId="1076"/>
          <ac:spMkLst>
            <pc:docMk/>
            <pc:sldMk cId="2082008688" sldId="264"/>
            <ac:spMk id="8" creationId="{8CE0DF08-0D87-7905-776C-D29CF10DEF30}"/>
          </ac:spMkLst>
        </pc:spChg>
        <pc:spChg chg="mod">
          <ac:chgData name="Martin Røssel Larsen" userId="e4500570-1497-4d24-876e-2d6b64ed7cd3" providerId="ADAL" clId="{388C2AD0-7FBA-4ABD-A38B-2191A5A7DC24}" dt="2023-12-13T11:59:56.454" v="277" actId="1076"/>
          <ac:spMkLst>
            <pc:docMk/>
            <pc:sldMk cId="2082008688" sldId="264"/>
            <ac:spMk id="10" creationId="{6951EC2E-ACB3-4BA3-B104-604C7D6FEBE8}"/>
          </ac:spMkLst>
        </pc:spChg>
        <pc:spChg chg="mod">
          <ac:chgData name="Martin Røssel Larsen" userId="e4500570-1497-4d24-876e-2d6b64ed7cd3" providerId="ADAL" clId="{388C2AD0-7FBA-4ABD-A38B-2191A5A7DC24}" dt="2023-12-13T11:59:56.454" v="277" actId="1076"/>
          <ac:spMkLst>
            <pc:docMk/>
            <pc:sldMk cId="2082008688" sldId="264"/>
            <ac:spMk id="11" creationId="{25F4C66E-DB4E-A6F0-A29A-C39579D11187}"/>
          </ac:spMkLst>
        </pc:spChg>
        <pc:spChg chg="mod">
          <ac:chgData name="Martin Røssel Larsen" userId="e4500570-1497-4d24-876e-2d6b64ed7cd3" providerId="ADAL" clId="{388C2AD0-7FBA-4ABD-A38B-2191A5A7DC24}" dt="2023-12-13T11:59:56.454" v="277" actId="1076"/>
          <ac:spMkLst>
            <pc:docMk/>
            <pc:sldMk cId="2082008688" sldId="264"/>
            <ac:spMk id="12" creationId="{B5D40BCD-3C46-6930-D504-A75D1951BF82}"/>
          </ac:spMkLst>
        </pc:spChg>
        <pc:picChg chg="mod">
          <ac:chgData name="Martin Røssel Larsen" userId="e4500570-1497-4d24-876e-2d6b64ed7cd3" providerId="ADAL" clId="{388C2AD0-7FBA-4ABD-A38B-2191A5A7DC24}" dt="2023-12-13T11:59:56.454" v="277" actId="1076"/>
          <ac:picMkLst>
            <pc:docMk/>
            <pc:sldMk cId="2082008688" sldId="264"/>
            <ac:picMk id="3" creationId="{CFF5B96C-71E8-5C09-03A5-4577D9F3EA5C}"/>
          </ac:picMkLst>
        </pc:picChg>
        <pc:picChg chg="add mod modCrop">
          <ac:chgData name="Martin Røssel Larsen" userId="e4500570-1497-4d24-876e-2d6b64ed7cd3" providerId="ADAL" clId="{388C2AD0-7FBA-4ABD-A38B-2191A5A7DC24}" dt="2023-12-13T12:00:22.335" v="285" actId="1076"/>
          <ac:picMkLst>
            <pc:docMk/>
            <pc:sldMk cId="2082008688" sldId="264"/>
            <ac:picMk id="4" creationId="{C71C1CCF-3E0A-B166-9EB7-94190E157767}"/>
          </ac:picMkLst>
        </pc:picChg>
        <pc:cxnChg chg="mod">
          <ac:chgData name="Martin Røssel Larsen" userId="e4500570-1497-4d24-876e-2d6b64ed7cd3" providerId="ADAL" clId="{388C2AD0-7FBA-4ABD-A38B-2191A5A7DC24}" dt="2023-12-13T11:59:56.454" v="277" actId="1076"/>
          <ac:cxnSpMkLst>
            <pc:docMk/>
            <pc:sldMk cId="2082008688" sldId="264"/>
            <ac:cxnSpMk id="9" creationId="{8A7CCD11-C661-08CF-BD68-CCDDB9CD87BB}"/>
          </ac:cxnSpMkLst>
        </pc:cxnChg>
        <pc:cxnChg chg="mod">
          <ac:chgData name="Martin Røssel Larsen" userId="e4500570-1497-4d24-876e-2d6b64ed7cd3" providerId="ADAL" clId="{388C2AD0-7FBA-4ABD-A38B-2191A5A7DC24}" dt="2023-12-13T11:59:56.454" v="277" actId="1076"/>
          <ac:cxnSpMkLst>
            <pc:docMk/>
            <pc:sldMk cId="2082008688" sldId="264"/>
            <ac:cxnSpMk id="13" creationId="{8B99670F-D712-D7F5-319D-7003E15D443A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29T10:27:14.244" v="479" actId="1076"/>
        <pc:sldMkLst>
          <pc:docMk/>
          <pc:sldMk cId="327035599" sldId="265"/>
        </pc:sldMkLst>
        <pc:spChg chg="add mod">
          <ac:chgData name="Martin Røssel Larsen" userId="e4500570-1497-4d24-876e-2d6b64ed7cd3" providerId="ADAL" clId="{388C2AD0-7FBA-4ABD-A38B-2191A5A7DC24}" dt="2023-12-13T12:01:18.623" v="296" actId="1076"/>
          <ac:spMkLst>
            <pc:docMk/>
            <pc:sldMk cId="327035599" sldId="265"/>
            <ac:spMk id="2" creationId="{902B0484-D375-8265-A17D-56B20D7D0111}"/>
          </ac:spMkLst>
        </pc:spChg>
        <pc:spChg chg="mod">
          <ac:chgData name="Martin Røssel Larsen" userId="e4500570-1497-4d24-876e-2d6b64ed7cd3" providerId="ADAL" clId="{388C2AD0-7FBA-4ABD-A38B-2191A5A7DC24}" dt="2023-12-29T10:27:14.244" v="479" actId="1076"/>
          <ac:spMkLst>
            <pc:docMk/>
            <pc:sldMk cId="327035599" sldId="265"/>
            <ac:spMk id="3" creationId="{589604F8-686A-4A5D-4996-E0F8CC8DD6C9}"/>
          </ac:spMkLst>
        </pc:spChg>
        <pc:spChg chg="mod">
          <ac:chgData name="Martin Røssel Larsen" userId="e4500570-1497-4d24-876e-2d6b64ed7cd3" providerId="ADAL" clId="{388C2AD0-7FBA-4ABD-A38B-2191A5A7DC24}" dt="2023-12-13T12:01:48.128" v="297" actId="20577"/>
          <ac:spMkLst>
            <pc:docMk/>
            <pc:sldMk cId="327035599" sldId="265"/>
            <ac:spMk id="4" creationId="{DD7C68A3-7BCA-25C1-B327-C0CFB9604ACD}"/>
          </ac:spMkLst>
        </pc:spChg>
        <pc:spChg chg="mod">
          <ac:chgData name="Martin Røssel Larsen" userId="e4500570-1497-4d24-876e-2d6b64ed7cd3" providerId="ADAL" clId="{388C2AD0-7FBA-4ABD-A38B-2191A5A7DC24}" dt="2023-11-20T14:39:45.268" v="40" actId="20577"/>
          <ac:spMkLst>
            <pc:docMk/>
            <pc:sldMk cId="327035599" sldId="265"/>
            <ac:spMk id="15" creationId="{014E7998-A594-A7B2-33D4-4244B4B10D24}"/>
          </ac:spMkLst>
        </pc:spChg>
        <pc:picChg chg="add mod modCrop">
          <ac:chgData name="Martin Røssel Larsen" userId="e4500570-1497-4d24-876e-2d6b64ed7cd3" providerId="ADAL" clId="{388C2AD0-7FBA-4ABD-A38B-2191A5A7DC24}" dt="2023-12-13T12:02:05.998" v="298" actId="14100"/>
          <ac:picMkLst>
            <pc:docMk/>
            <pc:sldMk cId="327035599" sldId="265"/>
            <ac:picMk id="6" creationId="{B31AF8D2-D23E-E7EE-EF35-A022BD88FBDF}"/>
          </ac:picMkLst>
        </pc:picChg>
        <pc:cxnChg chg="mod">
          <ac:chgData name="Martin Røssel Larsen" userId="e4500570-1497-4d24-876e-2d6b64ed7cd3" providerId="ADAL" clId="{388C2AD0-7FBA-4ABD-A38B-2191A5A7DC24}" dt="2023-12-13T12:01:12.750" v="295" actId="14100"/>
          <ac:cxnSpMkLst>
            <pc:docMk/>
            <pc:sldMk cId="327035599" sldId="265"/>
            <ac:cxnSpMk id="5" creationId="{351AE6AD-2F82-B849-B04D-799C84F8A66D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03:29.645" v="317" actId="1076"/>
        <pc:sldMkLst>
          <pc:docMk/>
          <pc:sldMk cId="3441028678" sldId="266"/>
        </pc:sldMkLst>
        <pc:spChg chg="add mod">
          <ac:chgData name="Martin Røssel Larsen" userId="e4500570-1497-4d24-876e-2d6b64ed7cd3" providerId="ADAL" clId="{388C2AD0-7FBA-4ABD-A38B-2191A5A7DC24}" dt="2023-12-13T12:03:29.645" v="317" actId="1076"/>
          <ac:spMkLst>
            <pc:docMk/>
            <pc:sldMk cId="3441028678" sldId="266"/>
            <ac:spMk id="2" creationId="{F74A5366-A794-8AD0-E59A-A1A349818CD6}"/>
          </ac:spMkLst>
        </pc:spChg>
        <pc:spChg chg="mod">
          <ac:chgData name="Martin Røssel Larsen" userId="e4500570-1497-4d24-876e-2d6b64ed7cd3" providerId="ADAL" clId="{388C2AD0-7FBA-4ABD-A38B-2191A5A7DC24}" dt="2023-11-20T14:39:54.536" v="41" actId="20577"/>
          <ac:spMkLst>
            <pc:docMk/>
            <pc:sldMk cId="3441028678" sldId="266"/>
            <ac:spMk id="8" creationId="{478505E8-4320-16D0-273A-951707816E03}"/>
          </ac:spMkLst>
        </pc:spChg>
        <pc:spChg chg="mod">
          <ac:chgData name="Martin Røssel Larsen" userId="e4500570-1497-4d24-876e-2d6b64ed7cd3" providerId="ADAL" clId="{388C2AD0-7FBA-4ABD-A38B-2191A5A7DC24}" dt="2023-12-13T12:03:19.358" v="315" actId="1076"/>
          <ac:spMkLst>
            <pc:docMk/>
            <pc:sldMk cId="3441028678" sldId="266"/>
            <ac:spMk id="10" creationId="{BE99AC8E-0878-FA67-AEBB-E02DBEB71729}"/>
          </ac:spMkLst>
        </pc:spChg>
        <pc:spChg chg="mod">
          <ac:chgData name="Martin Røssel Larsen" userId="e4500570-1497-4d24-876e-2d6b64ed7cd3" providerId="ADAL" clId="{388C2AD0-7FBA-4ABD-A38B-2191A5A7DC24}" dt="2023-12-13T12:03:19.358" v="315" actId="1076"/>
          <ac:spMkLst>
            <pc:docMk/>
            <pc:sldMk cId="3441028678" sldId="266"/>
            <ac:spMk id="12" creationId="{FF679B62-9857-EDC8-E1EC-7ED0EA6B99B8}"/>
          </ac:spMkLst>
        </pc:spChg>
        <pc:spChg chg="mod">
          <ac:chgData name="Martin Røssel Larsen" userId="e4500570-1497-4d24-876e-2d6b64ed7cd3" providerId="ADAL" clId="{388C2AD0-7FBA-4ABD-A38B-2191A5A7DC24}" dt="2023-12-13T12:03:19.358" v="315" actId="1076"/>
          <ac:spMkLst>
            <pc:docMk/>
            <pc:sldMk cId="3441028678" sldId="266"/>
            <ac:spMk id="13" creationId="{8AE29235-7924-29A2-20CF-78ED792AC308}"/>
          </ac:spMkLst>
        </pc:spChg>
        <pc:spChg chg="mod">
          <ac:chgData name="Martin Røssel Larsen" userId="e4500570-1497-4d24-876e-2d6b64ed7cd3" providerId="ADAL" clId="{388C2AD0-7FBA-4ABD-A38B-2191A5A7DC24}" dt="2023-12-13T12:03:19.358" v="315" actId="1076"/>
          <ac:spMkLst>
            <pc:docMk/>
            <pc:sldMk cId="3441028678" sldId="266"/>
            <ac:spMk id="14" creationId="{1B365163-7EDD-6E36-BC4F-5C4D94BC1CD8}"/>
          </ac:spMkLst>
        </pc:spChg>
        <pc:picChg chg="add mod modCrop">
          <ac:chgData name="Martin Røssel Larsen" userId="e4500570-1497-4d24-876e-2d6b64ed7cd3" providerId="ADAL" clId="{388C2AD0-7FBA-4ABD-A38B-2191A5A7DC24}" dt="2023-12-13T12:03:26.238" v="316" actId="1076"/>
          <ac:picMkLst>
            <pc:docMk/>
            <pc:sldMk cId="3441028678" sldId="266"/>
            <ac:picMk id="3" creationId="{1650CCFF-3054-A69C-832B-AB04427003F9}"/>
          </ac:picMkLst>
        </pc:picChg>
        <pc:picChg chg="mod">
          <ac:chgData name="Martin Røssel Larsen" userId="e4500570-1497-4d24-876e-2d6b64ed7cd3" providerId="ADAL" clId="{388C2AD0-7FBA-4ABD-A38B-2191A5A7DC24}" dt="2023-12-13T12:03:19.358" v="315" actId="1076"/>
          <ac:picMkLst>
            <pc:docMk/>
            <pc:sldMk cId="3441028678" sldId="266"/>
            <ac:picMk id="5" creationId="{26BD5010-4A84-C03F-EE7C-3C375CC0230A}"/>
          </ac:picMkLst>
        </pc:picChg>
        <pc:cxnChg chg="mod">
          <ac:chgData name="Martin Røssel Larsen" userId="e4500570-1497-4d24-876e-2d6b64ed7cd3" providerId="ADAL" clId="{388C2AD0-7FBA-4ABD-A38B-2191A5A7DC24}" dt="2023-12-13T12:03:19.358" v="315" actId="1076"/>
          <ac:cxnSpMkLst>
            <pc:docMk/>
            <pc:sldMk cId="3441028678" sldId="266"/>
            <ac:cxnSpMk id="11" creationId="{5DCD5503-1D2B-0653-F0BD-606E79D1B1C9}"/>
          </ac:cxnSpMkLst>
        </pc:cxnChg>
        <pc:cxnChg chg="mod">
          <ac:chgData name="Martin Røssel Larsen" userId="e4500570-1497-4d24-876e-2d6b64ed7cd3" providerId="ADAL" clId="{388C2AD0-7FBA-4ABD-A38B-2191A5A7DC24}" dt="2023-12-13T12:03:19.358" v="315" actId="1076"/>
          <ac:cxnSpMkLst>
            <pc:docMk/>
            <pc:sldMk cId="3441028678" sldId="266"/>
            <ac:cxnSpMk id="15" creationId="{11DE9588-7868-4989-ECE4-0AC84E9453A2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04:05.781" v="326" actId="1076"/>
        <pc:sldMkLst>
          <pc:docMk/>
          <pc:sldMk cId="1928963394" sldId="267"/>
        </pc:sldMkLst>
        <pc:spChg chg="mod">
          <ac:chgData name="Martin Røssel Larsen" userId="e4500570-1497-4d24-876e-2d6b64ed7cd3" providerId="ADAL" clId="{388C2AD0-7FBA-4ABD-A38B-2191A5A7DC24}" dt="2023-12-13T12:04:05.781" v="326" actId="1076"/>
          <ac:spMkLst>
            <pc:docMk/>
            <pc:sldMk cId="1928963394" sldId="267"/>
            <ac:spMk id="2" creationId="{20DAD0FC-359F-BD7E-0D2B-2232E24DC093}"/>
          </ac:spMkLst>
        </pc:spChg>
        <pc:spChg chg="add mod">
          <ac:chgData name="Martin Røssel Larsen" userId="e4500570-1497-4d24-876e-2d6b64ed7cd3" providerId="ADAL" clId="{388C2AD0-7FBA-4ABD-A38B-2191A5A7DC24}" dt="2023-12-13T12:04:00.254" v="325" actId="1076"/>
          <ac:spMkLst>
            <pc:docMk/>
            <pc:sldMk cId="1928963394" sldId="267"/>
            <ac:spMk id="3" creationId="{08983849-8682-6846-2634-8794420D3D1B}"/>
          </ac:spMkLst>
        </pc:spChg>
        <pc:picChg chg="add mod modCrop">
          <ac:chgData name="Martin Røssel Larsen" userId="e4500570-1497-4d24-876e-2d6b64ed7cd3" providerId="ADAL" clId="{388C2AD0-7FBA-4ABD-A38B-2191A5A7DC24}" dt="2023-12-13T12:03:57.462" v="324" actId="1076"/>
          <ac:picMkLst>
            <pc:docMk/>
            <pc:sldMk cId="1928963394" sldId="267"/>
            <ac:picMk id="5" creationId="{D4FFB588-FCAA-8314-0961-505123886AE3}"/>
          </ac:picMkLst>
        </pc:picChg>
      </pc:sldChg>
      <pc:sldChg chg="addSp modSp mod">
        <pc:chgData name="Martin Røssel Larsen" userId="e4500570-1497-4d24-876e-2d6b64ed7cd3" providerId="ADAL" clId="{388C2AD0-7FBA-4ABD-A38B-2191A5A7DC24}" dt="2023-12-13T12:49:33.507" v="340" actId="1076"/>
        <pc:sldMkLst>
          <pc:docMk/>
          <pc:sldMk cId="1274154538" sldId="268"/>
        </pc:sldMkLst>
        <pc:spChg chg="mod">
          <ac:chgData name="Martin Røssel Larsen" userId="e4500570-1497-4d24-876e-2d6b64ed7cd3" providerId="ADAL" clId="{388C2AD0-7FBA-4ABD-A38B-2191A5A7DC24}" dt="2023-11-20T14:40:22.326" v="46" actId="20577"/>
          <ac:spMkLst>
            <pc:docMk/>
            <pc:sldMk cId="1274154538" sldId="268"/>
            <ac:spMk id="2" creationId="{EAE126DD-39BF-1FA6-A2DC-31A8AE2310CD}"/>
          </ac:spMkLst>
        </pc:spChg>
        <pc:spChg chg="add mod">
          <ac:chgData name="Martin Røssel Larsen" userId="e4500570-1497-4d24-876e-2d6b64ed7cd3" providerId="ADAL" clId="{388C2AD0-7FBA-4ABD-A38B-2191A5A7DC24}" dt="2023-12-13T11:32:43.280" v="109"/>
          <ac:spMkLst>
            <pc:docMk/>
            <pc:sldMk cId="1274154538" sldId="268"/>
            <ac:spMk id="3" creationId="{050CAD26-91D0-5FDA-FEBB-BEBE983B72FB}"/>
          </ac:spMkLst>
        </pc:spChg>
        <pc:spChg chg="mod">
          <ac:chgData name="Martin Røssel Larsen" userId="e4500570-1497-4d24-876e-2d6b64ed7cd3" providerId="ADAL" clId="{388C2AD0-7FBA-4ABD-A38B-2191A5A7DC24}" dt="2023-12-13T12:49:33.507" v="340" actId="1076"/>
          <ac:spMkLst>
            <pc:docMk/>
            <pc:sldMk cId="1274154538" sldId="268"/>
            <ac:spMk id="8" creationId="{520D5732-5B54-4A89-3918-6048734BD06F}"/>
          </ac:spMkLst>
        </pc:spChg>
        <pc:spChg chg="mod">
          <ac:chgData name="Martin Røssel Larsen" userId="e4500570-1497-4d24-876e-2d6b64ed7cd3" providerId="ADAL" clId="{388C2AD0-7FBA-4ABD-A38B-2191A5A7DC24}" dt="2023-12-13T12:49:33.507" v="340" actId="1076"/>
          <ac:spMkLst>
            <pc:docMk/>
            <pc:sldMk cId="1274154538" sldId="268"/>
            <ac:spMk id="10" creationId="{35315BF9-F19C-883B-69FD-27FE38DA1FCE}"/>
          </ac:spMkLst>
        </pc:spChg>
        <pc:spChg chg="mod">
          <ac:chgData name="Martin Røssel Larsen" userId="e4500570-1497-4d24-876e-2d6b64ed7cd3" providerId="ADAL" clId="{388C2AD0-7FBA-4ABD-A38B-2191A5A7DC24}" dt="2023-12-13T12:49:33.507" v="340" actId="1076"/>
          <ac:spMkLst>
            <pc:docMk/>
            <pc:sldMk cId="1274154538" sldId="268"/>
            <ac:spMk id="11" creationId="{E4807AE4-E3EC-EDAE-52B1-5EB803D61E81}"/>
          </ac:spMkLst>
        </pc:spChg>
        <pc:spChg chg="mod">
          <ac:chgData name="Martin Røssel Larsen" userId="e4500570-1497-4d24-876e-2d6b64ed7cd3" providerId="ADAL" clId="{388C2AD0-7FBA-4ABD-A38B-2191A5A7DC24}" dt="2023-12-13T12:49:33.507" v="340" actId="1076"/>
          <ac:spMkLst>
            <pc:docMk/>
            <pc:sldMk cId="1274154538" sldId="268"/>
            <ac:spMk id="12" creationId="{59CB36AB-7D5E-9B3B-3A5E-C2E235CFF99F}"/>
          </ac:spMkLst>
        </pc:spChg>
        <pc:spChg chg="mod">
          <ac:chgData name="Martin Røssel Larsen" userId="e4500570-1497-4d24-876e-2d6b64ed7cd3" providerId="ADAL" clId="{388C2AD0-7FBA-4ABD-A38B-2191A5A7DC24}" dt="2023-12-13T12:49:33.507" v="340" actId="1076"/>
          <ac:spMkLst>
            <pc:docMk/>
            <pc:sldMk cId="1274154538" sldId="268"/>
            <ac:spMk id="17" creationId="{182A6FFD-F66B-43CB-059C-68E4AFB1F6A8}"/>
          </ac:spMkLst>
        </pc:spChg>
        <pc:spChg chg="mod">
          <ac:chgData name="Martin Røssel Larsen" userId="e4500570-1497-4d24-876e-2d6b64ed7cd3" providerId="ADAL" clId="{388C2AD0-7FBA-4ABD-A38B-2191A5A7DC24}" dt="2023-12-13T12:49:33.507" v="340" actId="1076"/>
          <ac:spMkLst>
            <pc:docMk/>
            <pc:sldMk cId="1274154538" sldId="268"/>
            <ac:spMk id="18" creationId="{3DB5648C-CD35-2ACD-8668-55E5AFD8CCE4}"/>
          </ac:spMkLst>
        </pc:spChg>
        <pc:picChg chg="mod">
          <ac:chgData name="Martin Røssel Larsen" userId="e4500570-1497-4d24-876e-2d6b64ed7cd3" providerId="ADAL" clId="{388C2AD0-7FBA-4ABD-A38B-2191A5A7DC24}" dt="2023-12-13T12:49:33.507" v="340" actId="1076"/>
          <ac:picMkLst>
            <pc:docMk/>
            <pc:sldMk cId="1274154538" sldId="268"/>
            <ac:picMk id="4" creationId="{3FB60F4E-52C5-1332-D97A-DF02DA92F810}"/>
          </ac:picMkLst>
        </pc:picChg>
        <pc:picChg chg="add mod modCrop">
          <ac:chgData name="Martin Røssel Larsen" userId="e4500570-1497-4d24-876e-2d6b64ed7cd3" providerId="ADAL" clId="{388C2AD0-7FBA-4ABD-A38B-2191A5A7DC24}" dt="2023-12-13T12:49:23.490" v="339" actId="1076"/>
          <ac:picMkLst>
            <pc:docMk/>
            <pc:sldMk cId="1274154538" sldId="268"/>
            <ac:picMk id="5" creationId="{0E811A99-CA34-905F-2712-C244FE689252}"/>
          </ac:picMkLst>
        </pc:picChg>
        <pc:cxnChg chg="mod">
          <ac:chgData name="Martin Røssel Larsen" userId="e4500570-1497-4d24-876e-2d6b64ed7cd3" providerId="ADAL" clId="{388C2AD0-7FBA-4ABD-A38B-2191A5A7DC24}" dt="2023-12-13T12:49:33.507" v="340" actId="1076"/>
          <ac:cxnSpMkLst>
            <pc:docMk/>
            <pc:sldMk cId="1274154538" sldId="268"/>
            <ac:cxnSpMk id="9" creationId="{6B6A4990-F7DA-330E-232B-F821DB9E5EFE}"/>
          </ac:cxnSpMkLst>
        </pc:cxnChg>
        <pc:cxnChg chg="mod">
          <ac:chgData name="Martin Røssel Larsen" userId="e4500570-1497-4d24-876e-2d6b64ed7cd3" providerId="ADAL" clId="{388C2AD0-7FBA-4ABD-A38B-2191A5A7DC24}" dt="2023-12-13T12:49:33.507" v="340" actId="1076"/>
          <ac:cxnSpMkLst>
            <pc:docMk/>
            <pc:sldMk cId="1274154538" sldId="268"/>
            <ac:cxnSpMk id="13" creationId="{6976A951-376B-1A4B-3D17-11C0C72B2EDA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50:56.544" v="354" actId="1076"/>
        <pc:sldMkLst>
          <pc:docMk/>
          <pc:sldMk cId="3368359846" sldId="269"/>
        </pc:sldMkLst>
        <pc:spChg chg="mod">
          <ac:chgData name="Martin Røssel Larsen" userId="e4500570-1497-4d24-876e-2d6b64ed7cd3" providerId="ADAL" clId="{388C2AD0-7FBA-4ABD-A38B-2191A5A7DC24}" dt="2023-11-20T14:40:38.011" v="49" actId="1076"/>
          <ac:spMkLst>
            <pc:docMk/>
            <pc:sldMk cId="3368359846" sldId="269"/>
            <ac:spMk id="2" creationId="{B243D229-5FCA-372B-0E52-21FB699B1DC4}"/>
          </ac:spMkLst>
        </pc:spChg>
        <pc:spChg chg="add mod">
          <ac:chgData name="Martin Røssel Larsen" userId="e4500570-1497-4d24-876e-2d6b64ed7cd3" providerId="ADAL" clId="{388C2AD0-7FBA-4ABD-A38B-2191A5A7DC24}" dt="2023-12-13T12:50:56.544" v="354" actId="1076"/>
          <ac:spMkLst>
            <pc:docMk/>
            <pc:sldMk cId="3368359846" sldId="269"/>
            <ac:spMk id="3" creationId="{BD185690-16EE-2D85-228D-E6DD21C22EA2}"/>
          </ac:spMkLst>
        </pc:spChg>
        <pc:spChg chg="mod">
          <ac:chgData name="Martin Røssel Larsen" userId="e4500570-1497-4d24-876e-2d6b64ed7cd3" providerId="ADAL" clId="{388C2AD0-7FBA-4ABD-A38B-2191A5A7DC24}" dt="2023-12-13T12:50:49.201" v="351" actId="1076"/>
          <ac:spMkLst>
            <pc:docMk/>
            <pc:sldMk cId="3368359846" sldId="269"/>
            <ac:spMk id="6" creationId="{ACD44A17-FDA1-7E77-8481-364090D7B41C}"/>
          </ac:spMkLst>
        </pc:spChg>
        <pc:spChg chg="mod">
          <ac:chgData name="Martin Røssel Larsen" userId="e4500570-1497-4d24-876e-2d6b64ed7cd3" providerId="ADAL" clId="{388C2AD0-7FBA-4ABD-A38B-2191A5A7DC24}" dt="2023-12-13T12:50:40.498" v="349" actId="1076"/>
          <ac:spMkLst>
            <pc:docMk/>
            <pc:sldMk cId="3368359846" sldId="269"/>
            <ac:spMk id="10" creationId="{B89A58F7-F5AC-AD13-2F11-E8E73601DD67}"/>
          </ac:spMkLst>
        </pc:spChg>
        <pc:spChg chg="mod">
          <ac:chgData name="Martin Røssel Larsen" userId="e4500570-1497-4d24-876e-2d6b64ed7cd3" providerId="ADAL" clId="{388C2AD0-7FBA-4ABD-A38B-2191A5A7DC24}" dt="2023-12-13T12:50:40.498" v="349" actId="1076"/>
          <ac:spMkLst>
            <pc:docMk/>
            <pc:sldMk cId="3368359846" sldId="269"/>
            <ac:spMk id="13" creationId="{87566E33-3E02-34A7-5FD2-E070BFA06B77}"/>
          </ac:spMkLst>
        </pc:spChg>
        <pc:spChg chg="mod">
          <ac:chgData name="Martin Røssel Larsen" userId="e4500570-1497-4d24-876e-2d6b64ed7cd3" providerId="ADAL" clId="{388C2AD0-7FBA-4ABD-A38B-2191A5A7DC24}" dt="2023-12-13T12:50:49.201" v="351" actId="1076"/>
          <ac:spMkLst>
            <pc:docMk/>
            <pc:sldMk cId="3368359846" sldId="269"/>
            <ac:spMk id="14" creationId="{8B90F300-78B1-3787-98C1-5E66DEC9B3F6}"/>
          </ac:spMkLst>
        </pc:spChg>
        <pc:spChg chg="mod">
          <ac:chgData name="Martin Røssel Larsen" userId="e4500570-1497-4d24-876e-2d6b64ed7cd3" providerId="ADAL" clId="{388C2AD0-7FBA-4ABD-A38B-2191A5A7DC24}" dt="2023-12-13T12:50:40.498" v="349" actId="1076"/>
          <ac:spMkLst>
            <pc:docMk/>
            <pc:sldMk cId="3368359846" sldId="269"/>
            <ac:spMk id="15" creationId="{415D3C28-6163-BCAD-2A65-2C2133D7C5F9}"/>
          </ac:spMkLst>
        </pc:spChg>
        <pc:spChg chg="mod">
          <ac:chgData name="Martin Røssel Larsen" userId="e4500570-1497-4d24-876e-2d6b64ed7cd3" providerId="ADAL" clId="{388C2AD0-7FBA-4ABD-A38B-2191A5A7DC24}" dt="2023-12-13T12:50:40.498" v="349" actId="1076"/>
          <ac:spMkLst>
            <pc:docMk/>
            <pc:sldMk cId="3368359846" sldId="269"/>
            <ac:spMk id="19" creationId="{DB31EB5B-3A24-127F-A28B-6D87D2B15DDE}"/>
          </ac:spMkLst>
        </pc:spChg>
        <pc:spChg chg="mod">
          <ac:chgData name="Martin Røssel Larsen" userId="e4500570-1497-4d24-876e-2d6b64ed7cd3" providerId="ADAL" clId="{388C2AD0-7FBA-4ABD-A38B-2191A5A7DC24}" dt="2023-12-13T12:50:40.498" v="349" actId="1076"/>
          <ac:spMkLst>
            <pc:docMk/>
            <pc:sldMk cId="3368359846" sldId="269"/>
            <ac:spMk id="25" creationId="{516506BE-CF3F-7B15-D78D-4FD0B31B425E}"/>
          </ac:spMkLst>
        </pc:spChg>
        <pc:spChg chg="mod">
          <ac:chgData name="Martin Røssel Larsen" userId="e4500570-1497-4d24-876e-2d6b64ed7cd3" providerId="ADAL" clId="{388C2AD0-7FBA-4ABD-A38B-2191A5A7DC24}" dt="2023-12-13T12:50:40.498" v="349" actId="1076"/>
          <ac:spMkLst>
            <pc:docMk/>
            <pc:sldMk cId="3368359846" sldId="269"/>
            <ac:spMk id="27" creationId="{6709CBC2-5070-525F-F903-92CBF72FA0E0}"/>
          </ac:spMkLst>
        </pc:spChg>
        <pc:spChg chg="mod">
          <ac:chgData name="Martin Røssel Larsen" userId="e4500570-1497-4d24-876e-2d6b64ed7cd3" providerId="ADAL" clId="{388C2AD0-7FBA-4ABD-A38B-2191A5A7DC24}" dt="2023-12-13T12:50:40.498" v="349" actId="1076"/>
          <ac:spMkLst>
            <pc:docMk/>
            <pc:sldMk cId="3368359846" sldId="269"/>
            <ac:spMk id="28" creationId="{1CB784D1-0A0A-C79A-F52E-D19DF077DC82}"/>
          </ac:spMkLst>
        </pc:spChg>
        <pc:spChg chg="mod">
          <ac:chgData name="Martin Røssel Larsen" userId="e4500570-1497-4d24-876e-2d6b64ed7cd3" providerId="ADAL" clId="{388C2AD0-7FBA-4ABD-A38B-2191A5A7DC24}" dt="2023-12-13T12:50:40.498" v="349" actId="1076"/>
          <ac:spMkLst>
            <pc:docMk/>
            <pc:sldMk cId="3368359846" sldId="269"/>
            <ac:spMk id="29" creationId="{0C40DD3D-54DC-F912-3954-36A9E9C6F411}"/>
          </ac:spMkLst>
        </pc:spChg>
        <pc:picChg chg="mod">
          <ac:chgData name="Martin Røssel Larsen" userId="e4500570-1497-4d24-876e-2d6b64ed7cd3" providerId="ADAL" clId="{388C2AD0-7FBA-4ABD-A38B-2191A5A7DC24}" dt="2023-12-13T12:50:40.498" v="349" actId="1076"/>
          <ac:picMkLst>
            <pc:docMk/>
            <pc:sldMk cId="3368359846" sldId="269"/>
            <ac:picMk id="4" creationId="{52DBC8E4-C1D8-E8C3-DE3D-AC9229C51A23}"/>
          </ac:picMkLst>
        </pc:picChg>
        <pc:picChg chg="add mod modCrop">
          <ac:chgData name="Martin Røssel Larsen" userId="e4500570-1497-4d24-876e-2d6b64ed7cd3" providerId="ADAL" clId="{388C2AD0-7FBA-4ABD-A38B-2191A5A7DC24}" dt="2023-12-13T12:50:52.873" v="353" actId="1076"/>
          <ac:picMkLst>
            <pc:docMk/>
            <pc:sldMk cId="3368359846" sldId="269"/>
            <ac:picMk id="5" creationId="{65E4D7FD-509A-13E6-F007-43021E88916D}"/>
          </ac:picMkLst>
        </pc:picChg>
        <pc:picChg chg="mod">
          <ac:chgData name="Martin Røssel Larsen" userId="e4500570-1497-4d24-876e-2d6b64ed7cd3" providerId="ADAL" clId="{388C2AD0-7FBA-4ABD-A38B-2191A5A7DC24}" dt="2023-12-13T12:50:40.498" v="349" actId="1076"/>
          <ac:picMkLst>
            <pc:docMk/>
            <pc:sldMk cId="3368359846" sldId="269"/>
            <ac:picMk id="18" creationId="{A1503782-F831-96D4-DC03-C591C17ADB68}"/>
          </ac:picMkLst>
        </pc:picChg>
        <pc:cxnChg chg="mod">
          <ac:chgData name="Martin Røssel Larsen" userId="e4500570-1497-4d24-876e-2d6b64ed7cd3" providerId="ADAL" clId="{388C2AD0-7FBA-4ABD-A38B-2191A5A7DC24}" dt="2023-12-13T12:50:40.498" v="349" actId="1076"/>
          <ac:cxnSpMkLst>
            <pc:docMk/>
            <pc:sldMk cId="3368359846" sldId="269"/>
            <ac:cxnSpMk id="11" creationId="{E9CD8160-D9D2-21FA-9CC8-BC1ED88574D1}"/>
          </ac:cxnSpMkLst>
        </pc:cxnChg>
        <pc:cxnChg chg="mod">
          <ac:chgData name="Martin Røssel Larsen" userId="e4500570-1497-4d24-876e-2d6b64ed7cd3" providerId="ADAL" clId="{388C2AD0-7FBA-4ABD-A38B-2191A5A7DC24}" dt="2023-12-13T12:50:40.498" v="349" actId="1076"/>
          <ac:cxnSpMkLst>
            <pc:docMk/>
            <pc:sldMk cId="3368359846" sldId="269"/>
            <ac:cxnSpMk id="20" creationId="{230E94D0-0B3A-DCBE-C9EC-6E7AC498E299}"/>
          </ac:cxnSpMkLst>
        </pc:cxnChg>
        <pc:cxnChg chg="mod">
          <ac:chgData name="Martin Røssel Larsen" userId="e4500570-1497-4d24-876e-2d6b64ed7cd3" providerId="ADAL" clId="{388C2AD0-7FBA-4ABD-A38B-2191A5A7DC24}" dt="2023-12-13T12:50:40.498" v="349" actId="1076"/>
          <ac:cxnSpMkLst>
            <pc:docMk/>
            <pc:sldMk cId="3368359846" sldId="269"/>
            <ac:cxnSpMk id="26" creationId="{7BF162B4-298C-8B84-509F-41C8559195A5}"/>
          </ac:cxnSpMkLst>
        </pc:cxnChg>
        <pc:cxnChg chg="mod">
          <ac:chgData name="Martin Røssel Larsen" userId="e4500570-1497-4d24-876e-2d6b64ed7cd3" providerId="ADAL" clId="{388C2AD0-7FBA-4ABD-A38B-2191A5A7DC24}" dt="2023-12-13T12:50:40.498" v="349" actId="1076"/>
          <ac:cxnSpMkLst>
            <pc:docMk/>
            <pc:sldMk cId="3368359846" sldId="269"/>
            <ac:cxnSpMk id="30" creationId="{2256032D-89DF-3C6A-4C6E-3E98DDA15FE2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51:42.585" v="364" actId="1076"/>
        <pc:sldMkLst>
          <pc:docMk/>
          <pc:sldMk cId="55901586" sldId="270"/>
        </pc:sldMkLst>
        <pc:spChg chg="add mod">
          <ac:chgData name="Martin Røssel Larsen" userId="e4500570-1497-4d24-876e-2d6b64ed7cd3" providerId="ADAL" clId="{388C2AD0-7FBA-4ABD-A38B-2191A5A7DC24}" dt="2023-12-13T12:51:42.585" v="364" actId="1076"/>
          <ac:spMkLst>
            <pc:docMk/>
            <pc:sldMk cId="55901586" sldId="270"/>
            <ac:spMk id="2" creationId="{0BA0C752-20BD-5136-A2AC-6D6ADAA80047}"/>
          </ac:spMkLst>
        </pc:spChg>
        <pc:spChg chg="mod">
          <ac:chgData name="Martin Røssel Larsen" userId="e4500570-1497-4d24-876e-2d6b64ed7cd3" providerId="ADAL" clId="{388C2AD0-7FBA-4ABD-A38B-2191A5A7DC24}" dt="2023-11-20T14:40:54.554" v="51" actId="1076"/>
          <ac:spMkLst>
            <pc:docMk/>
            <pc:sldMk cId="55901586" sldId="270"/>
            <ac:spMk id="8" creationId="{F2EB788B-5140-3120-B628-F81D5A9C9FFF}"/>
          </ac:spMkLst>
        </pc:spChg>
        <pc:spChg chg="mod">
          <ac:chgData name="Martin Røssel Larsen" userId="e4500570-1497-4d24-876e-2d6b64ed7cd3" providerId="ADAL" clId="{388C2AD0-7FBA-4ABD-A38B-2191A5A7DC24}" dt="2023-12-13T12:51:37.946" v="362" actId="1076"/>
          <ac:spMkLst>
            <pc:docMk/>
            <pc:sldMk cId="55901586" sldId="270"/>
            <ac:spMk id="15" creationId="{AD69251D-B4CA-6A43-B1B8-3D474D9BCB7E}"/>
          </ac:spMkLst>
        </pc:spChg>
        <pc:spChg chg="mod">
          <ac:chgData name="Martin Røssel Larsen" userId="e4500570-1497-4d24-876e-2d6b64ed7cd3" providerId="ADAL" clId="{388C2AD0-7FBA-4ABD-A38B-2191A5A7DC24}" dt="2023-12-13T12:51:37.946" v="362" actId="1076"/>
          <ac:spMkLst>
            <pc:docMk/>
            <pc:sldMk cId="55901586" sldId="270"/>
            <ac:spMk id="17" creationId="{3210DBCB-7766-B5C8-1684-BA232F567217}"/>
          </ac:spMkLst>
        </pc:spChg>
        <pc:spChg chg="mod">
          <ac:chgData name="Martin Røssel Larsen" userId="e4500570-1497-4d24-876e-2d6b64ed7cd3" providerId="ADAL" clId="{388C2AD0-7FBA-4ABD-A38B-2191A5A7DC24}" dt="2023-12-13T12:51:37.946" v="362" actId="1076"/>
          <ac:spMkLst>
            <pc:docMk/>
            <pc:sldMk cId="55901586" sldId="270"/>
            <ac:spMk id="18" creationId="{54E7A156-D062-BEDC-1A59-672AA88D567B}"/>
          </ac:spMkLst>
        </pc:spChg>
        <pc:spChg chg="mod">
          <ac:chgData name="Martin Røssel Larsen" userId="e4500570-1497-4d24-876e-2d6b64ed7cd3" providerId="ADAL" clId="{388C2AD0-7FBA-4ABD-A38B-2191A5A7DC24}" dt="2023-12-13T12:51:37.946" v="362" actId="1076"/>
          <ac:spMkLst>
            <pc:docMk/>
            <pc:sldMk cId="55901586" sldId="270"/>
            <ac:spMk id="19" creationId="{ED0B1175-A6D4-2B21-0704-5008A5CFBAAA}"/>
          </ac:spMkLst>
        </pc:spChg>
        <pc:spChg chg="mod">
          <ac:chgData name="Martin Røssel Larsen" userId="e4500570-1497-4d24-876e-2d6b64ed7cd3" providerId="ADAL" clId="{388C2AD0-7FBA-4ABD-A38B-2191A5A7DC24}" dt="2023-12-13T12:51:37.946" v="362" actId="1076"/>
          <ac:spMkLst>
            <pc:docMk/>
            <pc:sldMk cId="55901586" sldId="270"/>
            <ac:spMk id="26" creationId="{A59031DA-5C90-F75F-1425-FB97599DD137}"/>
          </ac:spMkLst>
        </pc:spChg>
        <pc:spChg chg="mod">
          <ac:chgData name="Martin Røssel Larsen" userId="e4500570-1497-4d24-876e-2d6b64ed7cd3" providerId="ADAL" clId="{388C2AD0-7FBA-4ABD-A38B-2191A5A7DC24}" dt="2023-12-13T12:51:37.946" v="362" actId="1076"/>
          <ac:spMkLst>
            <pc:docMk/>
            <pc:sldMk cId="55901586" sldId="270"/>
            <ac:spMk id="27" creationId="{FFDFE05B-2480-55FC-15FB-21BB782B12D5}"/>
          </ac:spMkLst>
        </pc:spChg>
        <pc:picChg chg="add mod modCrop">
          <ac:chgData name="Martin Røssel Larsen" userId="e4500570-1497-4d24-876e-2d6b64ed7cd3" providerId="ADAL" clId="{388C2AD0-7FBA-4ABD-A38B-2191A5A7DC24}" dt="2023-12-13T12:51:39.809" v="363" actId="1076"/>
          <ac:picMkLst>
            <pc:docMk/>
            <pc:sldMk cId="55901586" sldId="270"/>
            <ac:picMk id="3" creationId="{EF36E88F-3342-B462-9C8E-816ADA4CDF5B}"/>
          </ac:picMkLst>
        </pc:picChg>
        <pc:picChg chg="mod">
          <ac:chgData name="Martin Røssel Larsen" userId="e4500570-1497-4d24-876e-2d6b64ed7cd3" providerId="ADAL" clId="{388C2AD0-7FBA-4ABD-A38B-2191A5A7DC24}" dt="2023-12-13T12:51:37.946" v="362" actId="1076"/>
          <ac:picMkLst>
            <pc:docMk/>
            <pc:sldMk cId="55901586" sldId="270"/>
            <ac:picMk id="11" creationId="{8C323BBC-7B7B-5107-F948-4DD4A85B8471}"/>
          </ac:picMkLst>
        </pc:picChg>
        <pc:cxnChg chg="mod">
          <ac:chgData name="Martin Røssel Larsen" userId="e4500570-1497-4d24-876e-2d6b64ed7cd3" providerId="ADAL" clId="{388C2AD0-7FBA-4ABD-A38B-2191A5A7DC24}" dt="2023-12-13T12:51:37.946" v="362" actId="1076"/>
          <ac:cxnSpMkLst>
            <pc:docMk/>
            <pc:sldMk cId="55901586" sldId="270"/>
            <ac:cxnSpMk id="16" creationId="{9268F066-858D-0F4F-66FE-EADB7A330872}"/>
          </ac:cxnSpMkLst>
        </pc:cxnChg>
        <pc:cxnChg chg="mod">
          <ac:chgData name="Martin Røssel Larsen" userId="e4500570-1497-4d24-876e-2d6b64ed7cd3" providerId="ADAL" clId="{388C2AD0-7FBA-4ABD-A38B-2191A5A7DC24}" dt="2023-12-13T12:51:37.946" v="362" actId="1076"/>
          <ac:cxnSpMkLst>
            <pc:docMk/>
            <pc:sldMk cId="55901586" sldId="270"/>
            <ac:cxnSpMk id="20" creationId="{00EA1D81-FD54-B88D-4CDC-8E03B784FC1D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52:36.009" v="372" actId="1076"/>
        <pc:sldMkLst>
          <pc:docMk/>
          <pc:sldMk cId="3456121498" sldId="271"/>
        </pc:sldMkLst>
        <pc:spChg chg="add mod">
          <ac:chgData name="Martin Røssel Larsen" userId="e4500570-1497-4d24-876e-2d6b64ed7cd3" providerId="ADAL" clId="{388C2AD0-7FBA-4ABD-A38B-2191A5A7DC24}" dt="2023-12-13T12:52:36.009" v="372" actId="1076"/>
          <ac:spMkLst>
            <pc:docMk/>
            <pc:sldMk cId="3456121498" sldId="271"/>
            <ac:spMk id="2" creationId="{C59F83CA-9C21-E903-9D81-64E871E9ABDB}"/>
          </ac:spMkLst>
        </pc:spChg>
        <pc:spChg chg="mod">
          <ac:chgData name="Martin Røssel Larsen" userId="e4500570-1497-4d24-876e-2d6b64ed7cd3" providerId="ADAL" clId="{388C2AD0-7FBA-4ABD-A38B-2191A5A7DC24}" dt="2023-11-20T14:41:07.099" v="53" actId="1076"/>
          <ac:spMkLst>
            <pc:docMk/>
            <pc:sldMk cId="3456121498" sldId="271"/>
            <ac:spMk id="4" creationId="{2B74B953-23C0-D591-AD8D-F41CE30CD5A3}"/>
          </ac:spMkLst>
        </pc:spChg>
        <pc:spChg chg="mod">
          <ac:chgData name="Martin Røssel Larsen" userId="e4500570-1497-4d24-876e-2d6b64ed7cd3" providerId="ADAL" clId="{388C2AD0-7FBA-4ABD-A38B-2191A5A7DC24}" dt="2023-12-13T12:52:28.771" v="369" actId="1076"/>
          <ac:spMkLst>
            <pc:docMk/>
            <pc:sldMk cId="3456121498" sldId="271"/>
            <ac:spMk id="8" creationId="{FEC2946D-9DE9-D75A-087F-60DB98B06F6E}"/>
          </ac:spMkLst>
        </pc:spChg>
        <pc:spChg chg="mod">
          <ac:chgData name="Martin Røssel Larsen" userId="e4500570-1497-4d24-876e-2d6b64ed7cd3" providerId="ADAL" clId="{388C2AD0-7FBA-4ABD-A38B-2191A5A7DC24}" dt="2023-12-13T12:52:28.771" v="369" actId="1076"/>
          <ac:spMkLst>
            <pc:docMk/>
            <pc:sldMk cId="3456121498" sldId="271"/>
            <ac:spMk id="10" creationId="{79213F83-48F6-3F4C-DDAE-3CF09F1842C9}"/>
          </ac:spMkLst>
        </pc:spChg>
        <pc:spChg chg="mod">
          <ac:chgData name="Martin Røssel Larsen" userId="e4500570-1497-4d24-876e-2d6b64ed7cd3" providerId="ADAL" clId="{388C2AD0-7FBA-4ABD-A38B-2191A5A7DC24}" dt="2023-12-13T12:52:28.771" v="369" actId="1076"/>
          <ac:spMkLst>
            <pc:docMk/>
            <pc:sldMk cId="3456121498" sldId="271"/>
            <ac:spMk id="11" creationId="{3D03EAFC-1DDA-C7F0-7BC8-3D3EA00C4F69}"/>
          </ac:spMkLst>
        </pc:spChg>
        <pc:spChg chg="mod">
          <ac:chgData name="Martin Røssel Larsen" userId="e4500570-1497-4d24-876e-2d6b64ed7cd3" providerId="ADAL" clId="{388C2AD0-7FBA-4ABD-A38B-2191A5A7DC24}" dt="2023-12-13T12:52:28.771" v="369" actId="1076"/>
          <ac:spMkLst>
            <pc:docMk/>
            <pc:sldMk cId="3456121498" sldId="271"/>
            <ac:spMk id="12" creationId="{309EC0DE-9B5B-7517-299E-5F0E081FF72E}"/>
          </ac:spMkLst>
        </pc:spChg>
        <pc:picChg chg="mod">
          <ac:chgData name="Martin Røssel Larsen" userId="e4500570-1497-4d24-876e-2d6b64ed7cd3" providerId="ADAL" clId="{388C2AD0-7FBA-4ABD-A38B-2191A5A7DC24}" dt="2023-12-13T12:52:28.771" v="369" actId="1076"/>
          <ac:picMkLst>
            <pc:docMk/>
            <pc:sldMk cId="3456121498" sldId="271"/>
            <ac:picMk id="3" creationId="{5C14647F-257E-7DE8-D7CD-177D6DE52883}"/>
          </ac:picMkLst>
        </pc:picChg>
        <pc:picChg chg="add mod modCrop">
          <ac:chgData name="Martin Røssel Larsen" userId="e4500570-1497-4d24-876e-2d6b64ed7cd3" providerId="ADAL" clId="{388C2AD0-7FBA-4ABD-A38B-2191A5A7DC24}" dt="2023-12-13T12:52:33.281" v="371" actId="1076"/>
          <ac:picMkLst>
            <pc:docMk/>
            <pc:sldMk cId="3456121498" sldId="271"/>
            <ac:picMk id="5" creationId="{B9BAAD9E-8E80-6B6E-35F9-A73103E6877A}"/>
          </ac:picMkLst>
        </pc:picChg>
        <pc:cxnChg chg="mod">
          <ac:chgData name="Martin Røssel Larsen" userId="e4500570-1497-4d24-876e-2d6b64ed7cd3" providerId="ADAL" clId="{388C2AD0-7FBA-4ABD-A38B-2191A5A7DC24}" dt="2023-12-13T12:52:28.771" v="369" actId="1076"/>
          <ac:cxnSpMkLst>
            <pc:docMk/>
            <pc:sldMk cId="3456121498" sldId="271"/>
            <ac:cxnSpMk id="9" creationId="{307F6634-FA14-34EC-1FBE-94FCFB2748AC}"/>
          </ac:cxnSpMkLst>
        </pc:cxnChg>
        <pc:cxnChg chg="mod">
          <ac:chgData name="Martin Røssel Larsen" userId="e4500570-1497-4d24-876e-2d6b64ed7cd3" providerId="ADAL" clId="{388C2AD0-7FBA-4ABD-A38B-2191A5A7DC24}" dt="2023-12-13T12:52:28.771" v="369" actId="1076"/>
          <ac:cxnSpMkLst>
            <pc:docMk/>
            <pc:sldMk cId="3456121498" sldId="271"/>
            <ac:cxnSpMk id="13" creationId="{105650EF-2383-A081-8086-E2DBF2B570E1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53:39.712" v="384" actId="1076"/>
        <pc:sldMkLst>
          <pc:docMk/>
          <pc:sldMk cId="2664089804" sldId="272"/>
        </pc:sldMkLst>
        <pc:spChg chg="mod">
          <ac:chgData name="Martin Røssel Larsen" userId="e4500570-1497-4d24-876e-2d6b64ed7cd3" providerId="ADAL" clId="{388C2AD0-7FBA-4ABD-A38B-2191A5A7DC24}" dt="2023-11-20T14:41:19.674" v="55" actId="1076"/>
          <ac:spMkLst>
            <pc:docMk/>
            <pc:sldMk cId="2664089804" sldId="272"/>
            <ac:spMk id="2" creationId="{26ED15C2-060E-778D-0492-2CF329517053}"/>
          </ac:spMkLst>
        </pc:spChg>
        <pc:spChg chg="add mod">
          <ac:chgData name="Martin Røssel Larsen" userId="e4500570-1497-4d24-876e-2d6b64ed7cd3" providerId="ADAL" clId="{388C2AD0-7FBA-4ABD-A38B-2191A5A7DC24}" dt="2023-12-13T11:32:47.363" v="113"/>
          <ac:spMkLst>
            <pc:docMk/>
            <pc:sldMk cId="2664089804" sldId="272"/>
            <ac:spMk id="3" creationId="{077A57F2-91F0-18DA-EF31-D5B648843260}"/>
          </ac:spMkLst>
        </pc:spChg>
        <pc:spChg chg="mod">
          <ac:chgData name="Martin Røssel Larsen" userId="e4500570-1497-4d24-876e-2d6b64ed7cd3" providerId="ADAL" clId="{388C2AD0-7FBA-4ABD-A38B-2191A5A7DC24}" dt="2023-12-13T12:53:39.712" v="384" actId="1076"/>
          <ac:spMkLst>
            <pc:docMk/>
            <pc:sldMk cId="2664089804" sldId="272"/>
            <ac:spMk id="6" creationId="{CEED48EC-FA1A-C4EA-4217-0CC375E38285}"/>
          </ac:spMkLst>
        </pc:spChg>
        <pc:spChg chg="mod">
          <ac:chgData name="Martin Røssel Larsen" userId="e4500570-1497-4d24-876e-2d6b64ed7cd3" providerId="ADAL" clId="{388C2AD0-7FBA-4ABD-A38B-2191A5A7DC24}" dt="2023-12-13T12:53:39.712" v="384" actId="1076"/>
          <ac:spMkLst>
            <pc:docMk/>
            <pc:sldMk cId="2664089804" sldId="272"/>
            <ac:spMk id="7" creationId="{50F25EE7-00C8-9429-79D8-16F0621A731F}"/>
          </ac:spMkLst>
        </pc:spChg>
        <pc:spChg chg="mod">
          <ac:chgData name="Martin Røssel Larsen" userId="e4500570-1497-4d24-876e-2d6b64ed7cd3" providerId="ADAL" clId="{388C2AD0-7FBA-4ABD-A38B-2191A5A7DC24}" dt="2023-12-13T12:53:27.993" v="381" actId="1076"/>
          <ac:spMkLst>
            <pc:docMk/>
            <pc:sldMk cId="2664089804" sldId="272"/>
            <ac:spMk id="8" creationId="{9BCD36FA-85B9-439E-D568-8B1CB55B2B6C}"/>
          </ac:spMkLst>
        </pc:spChg>
        <pc:spChg chg="mod">
          <ac:chgData name="Martin Røssel Larsen" userId="e4500570-1497-4d24-876e-2d6b64ed7cd3" providerId="ADAL" clId="{388C2AD0-7FBA-4ABD-A38B-2191A5A7DC24}" dt="2023-12-13T12:53:27.993" v="381" actId="1076"/>
          <ac:spMkLst>
            <pc:docMk/>
            <pc:sldMk cId="2664089804" sldId="272"/>
            <ac:spMk id="10" creationId="{732211E1-9573-5008-16E0-121B81C50A55}"/>
          </ac:spMkLst>
        </pc:spChg>
        <pc:spChg chg="mod">
          <ac:chgData name="Martin Røssel Larsen" userId="e4500570-1497-4d24-876e-2d6b64ed7cd3" providerId="ADAL" clId="{388C2AD0-7FBA-4ABD-A38B-2191A5A7DC24}" dt="2023-12-13T12:53:27.993" v="381" actId="1076"/>
          <ac:spMkLst>
            <pc:docMk/>
            <pc:sldMk cId="2664089804" sldId="272"/>
            <ac:spMk id="11" creationId="{82A1520E-BA6D-C619-BFB9-50D34BA3BFB7}"/>
          </ac:spMkLst>
        </pc:spChg>
        <pc:spChg chg="mod">
          <ac:chgData name="Martin Røssel Larsen" userId="e4500570-1497-4d24-876e-2d6b64ed7cd3" providerId="ADAL" clId="{388C2AD0-7FBA-4ABD-A38B-2191A5A7DC24}" dt="2023-12-13T12:53:27.993" v="381" actId="1076"/>
          <ac:spMkLst>
            <pc:docMk/>
            <pc:sldMk cId="2664089804" sldId="272"/>
            <ac:spMk id="12" creationId="{116FDF4A-FBAE-363C-6068-790CF98153A2}"/>
          </ac:spMkLst>
        </pc:spChg>
        <pc:spChg chg="mod">
          <ac:chgData name="Martin Røssel Larsen" userId="e4500570-1497-4d24-876e-2d6b64ed7cd3" providerId="ADAL" clId="{388C2AD0-7FBA-4ABD-A38B-2191A5A7DC24}" dt="2023-12-13T12:53:27.993" v="381" actId="1076"/>
          <ac:spMkLst>
            <pc:docMk/>
            <pc:sldMk cId="2664089804" sldId="272"/>
            <ac:spMk id="18" creationId="{4D98FF19-5CEF-F53A-11A1-F0155301C2F0}"/>
          </ac:spMkLst>
        </pc:spChg>
        <pc:spChg chg="mod">
          <ac:chgData name="Martin Røssel Larsen" userId="e4500570-1497-4d24-876e-2d6b64ed7cd3" providerId="ADAL" clId="{388C2AD0-7FBA-4ABD-A38B-2191A5A7DC24}" dt="2023-12-13T12:53:27.993" v="381" actId="1076"/>
          <ac:spMkLst>
            <pc:docMk/>
            <pc:sldMk cId="2664089804" sldId="272"/>
            <ac:spMk id="19" creationId="{8C7EFDED-5BDF-CDA3-9787-62E663B8244B}"/>
          </ac:spMkLst>
        </pc:spChg>
        <pc:picChg chg="mod">
          <ac:chgData name="Martin Røssel Larsen" userId="e4500570-1497-4d24-876e-2d6b64ed7cd3" providerId="ADAL" clId="{388C2AD0-7FBA-4ABD-A38B-2191A5A7DC24}" dt="2023-12-13T12:53:27.993" v="381" actId="1076"/>
          <ac:picMkLst>
            <pc:docMk/>
            <pc:sldMk cId="2664089804" sldId="272"/>
            <ac:picMk id="4" creationId="{1D9DE7A0-0EC9-B211-0694-3CC40BBC4D2F}"/>
          </ac:picMkLst>
        </pc:picChg>
        <pc:picChg chg="add mod modCrop">
          <ac:chgData name="Martin Røssel Larsen" userId="e4500570-1497-4d24-876e-2d6b64ed7cd3" providerId="ADAL" clId="{388C2AD0-7FBA-4ABD-A38B-2191A5A7DC24}" dt="2023-12-13T12:53:32.440" v="383" actId="1076"/>
          <ac:picMkLst>
            <pc:docMk/>
            <pc:sldMk cId="2664089804" sldId="272"/>
            <ac:picMk id="5" creationId="{B0F0809C-BA73-E11A-2674-1A45FDA0E0E0}"/>
          </ac:picMkLst>
        </pc:picChg>
        <pc:cxnChg chg="mod">
          <ac:chgData name="Martin Røssel Larsen" userId="e4500570-1497-4d24-876e-2d6b64ed7cd3" providerId="ADAL" clId="{388C2AD0-7FBA-4ABD-A38B-2191A5A7DC24}" dt="2023-12-13T12:53:27.993" v="381" actId="1076"/>
          <ac:cxnSpMkLst>
            <pc:docMk/>
            <pc:sldMk cId="2664089804" sldId="272"/>
            <ac:cxnSpMk id="9" creationId="{3CDAC6BC-6AF0-A5BF-6C42-7102F1204342}"/>
          </ac:cxnSpMkLst>
        </pc:cxnChg>
        <pc:cxnChg chg="mod">
          <ac:chgData name="Martin Røssel Larsen" userId="e4500570-1497-4d24-876e-2d6b64ed7cd3" providerId="ADAL" clId="{388C2AD0-7FBA-4ABD-A38B-2191A5A7DC24}" dt="2023-12-13T12:53:27.993" v="381" actId="1076"/>
          <ac:cxnSpMkLst>
            <pc:docMk/>
            <pc:sldMk cId="2664089804" sldId="272"/>
            <ac:cxnSpMk id="13" creationId="{2B90C7AF-C7E4-8989-8B14-03B544D83040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54:29.216" v="393" actId="1076"/>
        <pc:sldMkLst>
          <pc:docMk/>
          <pc:sldMk cId="1786942064" sldId="273"/>
        </pc:sldMkLst>
        <pc:spChg chg="add mod">
          <ac:chgData name="Martin Røssel Larsen" userId="e4500570-1497-4d24-876e-2d6b64ed7cd3" providerId="ADAL" clId="{388C2AD0-7FBA-4ABD-A38B-2191A5A7DC24}" dt="2023-12-13T12:53:52.608" v="386" actId="1076"/>
          <ac:spMkLst>
            <pc:docMk/>
            <pc:sldMk cId="1786942064" sldId="273"/>
            <ac:spMk id="3" creationId="{6FEDCAB9-4876-319B-B88B-EBCFF5588B27}"/>
          </ac:spMkLst>
        </pc:spChg>
        <pc:spChg chg="mod">
          <ac:chgData name="Martin Røssel Larsen" userId="e4500570-1497-4d24-876e-2d6b64ed7cd3" providerId="ADAL" clId="{388C2AD0-7FBA-4ABD-A38B-2191A5A7DC24}" dt="2023-12-13T12:53:47.864" v="385" actId="1076"/>
          <ac:spMkLst>
            <pc:docMk/>
            <pc:sldMk cId="1786942064" sldId="273"/>
            <ac:spMk id="14" creationId="{89EAABD6-4438-309A-E69E-0DF7EFB61AF4}"/>
          </ac:spMkLst>
        </pc:spChg>
        <pc:spChg chg="mod">
          <ac:chgData name="Martin Røssel Larsen" userId="e4500570-1497-4d24-876e-2d6b64ed7cd3" providerId="ADAL" clId="{388C2AD0-7FBA-4ABD-A38B-2191A5A7DC24}" dt="2023-12-13T12:53:47.864" v="385" actId="1076"/>
          <ac:spMkLst>
            <pc:docMk/>
            <pc:sldMk cId="1786942064" sldId="273"/>
            <ac:spMk id="15" creationId="{380AF26B-8247-933A-1402-107A43443182}"/>
          </ac:spMkLst>
        </pc:spChg>
        <pc:picChg chg="add mod modCrop">
          <ac:chgData name="Martin Røssel Larsen" userId="e4500570-1497-4d24-876e-2d6b64ed7cd3" providerId="ADAL" clId="{388C2AD0-7FBA-4ABD-A38B-2191A5A7DC24}" dt="2023-12-13T12:54:29.216" v="393" actId="1076"/>
          <ac:picMkLst>
            <pc:docMk/>
            <pc:sldMk cId="1786942064" sldId="273"/>
            <ac:picMk id="5" creationId="{594E647F-4C7E-02C4-6DDE-F8FEFE5F1404}"/>
          </ac:picMkLst>
        </pc:picChg>
      </pc:sldChg>
      <pc:sldChg chg="addSp modSp mod">
        <pc:chgData name="Martin Røssel Larsen" userId="e4500570-1497-4d24-876e-2d6b64ed7cd3" providerId="ADAL" clId="{388C2AD0-7FBA-4ABD-A38B-2191A5A7DC24}" dt="2023-12-13T12:55:24.599" v="404" actId="14100"/>
        <pc:sldMkLst>
          <pc:docMk/>
          <pc:sldMk cId="3205160232" sldId="274"/>
        </pc:sldMkLst>
        <pc:spChg chg="add mod">
          <ac:chgData name="Martin Røssel Larsen" userId="e4500570-1497-4d24-876e-2d6b64ed7cd3" providerId="ADAL" clId="{388C2AD0-7FBA-4ABD-A38B-2191A5A7DC24}" dt="2023-12-13T12:55:20.264" v="402" actId="1076"/>
          <ac:spMkLst>
            <pc:docMk/>
            <pc:sldMk cId="3205160232" sldId="274"/>
            <ac:spMk id="2" creationId="{0DE19487-4121-0905-23F6-8D2394916FB3}"/>
          </ac:spMkLst>
        </pc:spChg>
        <pc:spChg chg="mod">
          <ac:chgData name="Martin Røssel Larsen" userId="e4500570-1497-4d24-876e-2d6b64ed7cd3" providerId="ADAL" clId="{388C2AD0-7FBA-4ABD-A38B-2191A5A7DC24}" dt="2023-12-13T12:54:44.879" v="394" actId="1076"/>
          <ac:spMkLst>
            <pc:docMk/>
            <pc:sldMk cId="3205160232" sldId="274"/>
            <ac:spMk id="14" creationId="{384581E1-FA6F-F629-362F-674B81EA37D9}"/>
          </ac:spMkLst>
        </pc:spChg>
        <pc:spChg chg="mod">
          <ac:chgData name="Martin Røssel Larsen" userId="e4500570-1497-4d24-876e-2d6b64ed7cd3" providerId="ADAL" clId="{388C2AD0-7FBA-4ABD-A38B-2191A5A7DC24}" dt="2023-12-13T12:54:44.879" v="394" actId="1076"/>
          <ac:spMkLst>
            <pc:docMk/>
            <pc:sldMk cId="3205160232" sldId="274"/>
            <ac:spMk id="16" creationId="{7477C246-6C93-3EDA-608C-F356A22751FD}"/>
          </ac:spMkLst>
        </pc:spChg>
        <pc:spChg chg="mod">
          <ac:chgData name="Martin Røssel Larsen" userId="e4500570-1497-4d24-876e-2d6b64ed7cd3" providerId="ADAL" clId="{388C2AD0-7FBA-4ABD-A38B-2191A5A7DC24}" dt="2023-12-13T12:54:44.879" v="394" actId="1076"/>
          <ac:spMkLst>
            <pc:docMk/>
            <pc:sldMk cId="3205160232" sldId="274"/>
            <ac:spMk id="17" creationId="{723DF796-A036-D6C8-8583-F61E21373ACA}"/>
          </ac:spMkLst>
        </pc:spChg>
        <pc:spChg chg="mod">
          <ac:chgData name="Martin Røssel Larsen" userId="e4500570-1497-4d24-876e-2d6b64ed7cd3" providerId="ADAL" clId="{388C2AD0-7FBA-4ABD-A38B-2191A5A7DC24}" dt="2023-12-13T12:54:44.879" v="394" actId="1076"/>
          <ac:spMkLst>
            <pc:docMk/>
            <pc:sldMk cId="3205160232" sldId="274"/>
            <ac:spMk id="18" creationId="{8B63B93B-6E2E-1DDE-B6C2-9396B791BDE9}"/>
          </ac:spMkLst>
        </pc:spChg>
        <pc:picChg chg="add mod modCrop">
          <ac:chgData name="Martin Røssel Larsen" userId="e4500570-1497-4d24-876e-2d6b64ed7cd3" providerId="ADAL" clId="{388C2AD0-7FBA-4ABD-A38B-2191A5A7DC24}" dt="2023-12-13T12:55:24.599" v="404" actId="14100"/>
          <ac:picMkLst>
            <pc:docMk/>
            <pc:sldMk cId="3205160232" sldId="274"/>
            <ac:picMk id="4" creationId="{99B41C83-371C-D6D3-F960-589E13FCBBBF}"/>
          </ac:picMkLst>
        </pc:picChg>
        <pc:picChg chg="mod">
          <ac:chgData name="Martin Røssel Larsen" userId="e4500570-1497-4d24-876e-2d6b64ed7cd3" providerId="ADAL" clId="{388C2AD0-7FBA-4ABD-A38B-2191A5A7DC24}" dt="2023-12-13T12:54:44.879" v="394" actId="1076"/>
          <ac:picMkLst>
            <pc:docMk/>
            <pc:sldMk cId="3205160232" sldId="274"/>
            <ac:picMk id="10" creationId="{2E9507FD-8B48-598C-EA01-2B25C597D57D}"/>
          </ac:picMkLst>
        </pc:picChg>
        <pc:cxnChg chg="mod">
          <ac:chgData name="Martin Røssel Larsen" userId="e4500570-1497-4d24-876e-2d6b64ed7cd3" providerId="ADAL" clId="{388C2AD0-7FBA-4ABD-A38B-2191A5A7DC24}" dt="2023-12-13T12:54:44.879" v="394" actId="1076"/>
          <ac:cxnSpMkLst>
            <pc:docMk/>
            <pc:sldMk cId="3205160232" sldId="274"/>
            <ac:cxnSpMk id="15" creationId="{051346AF-F7D9-D8BC-3FFB-480848C33F11}"/>
          </ac:cxnSpMkLst>
        </pc:cxnChg>
        <pc:cxnChg chg="mod">
          <ac:chgData name="Martin Røssel Larsen" userId="e4500570-1497-4d24-876e-2d6b64ed7cd3" providerId="ADAL" clId="{388C2AD0-7FBA-4ABD-A38B-2191A5A7DC24}" dt="2023-12-13T12:54:44.879" v="394" actId="1076"/>
          <ac:cxnSpMkLst>
            <pc:docMk/>
            <pc:sldMk cId="3205160232" sldId="274"/>
            <ac:cxnSpMk id="19" creationId="{A3C2B84C-5556-8094-A6A1-F3C678DA5124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56:19.384" v="418" actId="1076"/>
        <pc:sldMkLst>
          <pc:docMk/>
          <pc:sldMk cId="2017378835" sldId="275"/>
        </pc:sldMkLst>
        <pc:spChg chg="mod">
          <ac:chgData name="Martin Røssel Larsen" userId="e4500570-1497-4d24-876e-2d6b64ed7cd3" providerId="ADAL" clId="{388C2AD0-7FBA-4ABD-A38B-2191A5A7DC24}" dt="2023-12-13T12:56:19.384" v="418" actId="1076"/>
          <ac:spMkLst>
            <pc:docMk/>
            <pc:sldMk cId="2017378835" sldId="275"/>
            <ac:spMk id="2" creationId="{EE0A8DC1-6CD0-3DE4-C1B5-EEAFCDBC2696}"/>
          </ac:spMkLst>
        </pc:spChg>
        <pc:spChg chg="add mod">
          <ac:chgData name="Martin Røssel Larsen" userId="e4500570-1497-4d24-876e-2d6b64ed7cd3" providerId="ADAL" clId="{388C2AD0-7FBA-4ABD-A38B-2191A5A7DC24}" dt="2023-12-13T12:56:17.288" v="417" actId="1076"/>
          <ac:spMkLst>
            <pc:docMk/>
            <pc:sldMk cId="2017378835" sldId="275"/>
            <ac:spMk id="3" creationId="{46DD9360-6B56-9FB4-100F-76FFC81FE3B5}"/>
          </ac:spMkLst>
        </pc:spChg>
        <pc:spChg chg="mod">
          <ac:chgData name="Martin Røssel Larsen" userId="e4500570-1497-4d24-876e-2d6b64ed7cd3" providerId="ADAL" clId="{388C2AD0-7FBA-4ABD-A38B-2191A5A7DC24}" dt="2023-12-13T12:56:11.281" v="416" actId="1076"/>
          <ac:spMkLst>
            <pc:docMk/>
            <pc:sldMk cId="2017378835" sldId="275"/>
            <ac:spMk id="8" creationId="{800760F8-410E-5F4C-2869-C8317EFE8AAC}"/>
          </ac:spMkLst>
        </pc:spChg>
        <pc:spChg chg="mod">
          <ac:chgData name="Martin Røssel Larsen" userId="e4500570-1497-4d24-876e-2d6b64ed7cd3" providerId="ADAL" clId="{388C2AD0-7FBA-4ABD-A38B-2191A5A7DC24}" dt="2023-12-13T12:56:11.281" v="416" actId="1076"/>
          <ac:spMkLst>
            <pc:docMk/>
            <pc:sldMk cId="2017378835" sldId="275"/>
            <ac:spMk id="10" creationId="{FE3A293B-FC62-0126-9981-E24C1D5BB859}"/>
          </ac:spMkLst>
        </pc:spChg>
        <pc:spChg chg="mod">
          <ac:chgData name="Martin Røssel Larsen" userId="e4500570-1497-4d24-876e-2d6b64ed7cd3" providerId="ADAL" clId="{388C2AD0-7FBA-4ABD-A38B-2191A5A7DC24}" dt="2023-12-13T12:56:11.281" v="416" actId="1076"/>
          <ac:spMkLst>
            <pc:docMk/>
            <pc:sldMk cId="2017378835" sldId="275"/>
            <ac:spMk id="11" creationId="{1498565C-9E66-36BC-C4B1-7D312EE0E2B7}"/>
          </ac:spMkLst>
        </pc:spChg>
        <pc:spChg chg="mod">
          <ac:chgData name="Martin Røssel Larsen" userId="e4500570-1497-4d24-876e-2d6b64ed7cd3" providerId="ADAL" clId="{388C2AD0-7FBA-4ABD-A38B-2191A5A7DC24}" dt="2023-12-13T12:56:11.281" v="416" actId="1076"/>
          <ac:spMkLst>
            <pc:docMk/>
            <pc:sldMk cId="2017378835" sldId="275"/>
            <ac:spMk id="12" creationId="{0A800457-43CB-1218-9959-B0494508FE6F}"/>
          </ac:spMkLst>
        </pc:spChg>
        <pc:spChg chg="mod">
          <ac:chgData name="Martin Røssel Larsen" userId="e4500570-1497-4d24-876e-2d6b64ed7cd3" providerId="ADAL" clId="{388C2AD0-7FBA-4ABD-A38B-2191A5A7DC24}" dt="2023-12-13T12:56:11.281" v="416" actId="1076"/>
          <ac:spMkLst>
            <pc:docMk/>
            <pc:sldMk cId="2017378835" sldId="275"/>
            <ac:spMk id="15" creationId="{521A062A-FE86-24E2-1ACC-53B4C8CA4F5B}"/>
          </ac:spMkLst>
        </pc:spChg>
        <pc:spChg chg="mod">
          <ac:chgData name="Martin Røssel Larsen" userId="e4500570-1497-4d24-876e-2d6b64ed7cd3" providerId="ADAL" clId="{388C2AD0-7FBA-4ABD-A38B-2191A5A7DC24}" dt="2023-12-13T12:56:11.281" v="416" actId="1076"/>
          <ac:spMkLst>
            <pc:docMk/>
            <pc:sldMk cId="2017378835" sldId="275"/>
            <ac:spMk id="16" creationId="{7E8A7E5D-2220-AF27-54BA-6D5E5868151F}"/>
          </ac:spMkLst>
        </pc:spChg>
        <pc:picChg chg="mod">
          <ac:chgData name="Martin Røssel Larsen" userId="e4500570-1497-4d24-876e-2d6b64ed7cd3" providerId="ADAL" clId="{388C2AD0-7FBA-4ABD-A38B-2191A5A7DC24}" dt="2023-12-13T12:56:11.281" v="416" actId="1076"/>
          <ac:picMkLst>
            <pc:docMk/>
            <pc:sldMk cId="2017378835" sldId="275"/>
            <ac:picMk id="4" creationId="{939FE4D8-9B63-95D4-3B68-9A168BA94D2F}"/>
          </ac:picMkLst>
        </pc:picChg>
        <pc:picChg chg="add mod modCrop">
          <ac:chgData name="Martin Røssel Larsen" userId="e4500570-1497-4d24-876e-2d6b64ed7cd3" providerId="ADAL" clId="{388C2AD0-7FBA-4ABD-A38B-2191A5A7DC24}" dt="2023-12-13T12:55:59.040" v="413" actId="14100"/>
          <ac:picMkLst>
            <pc:docMk/>
            <pc:sldMk cId="2017378835" sldId="275"/>
            <ac:picMk id="5" creationId="{D05145D2-F6ED-27D5-3A9A-9D8A25DA2A2C}"/>
          </ac:picMkLst>
        </pc:picChg>
        <pc:cxnChg chg="mod">
          <ac:chgData name="Martin Røssel Larsen" userId="e4500570-1497-4d24-876e-2d6b64ed7cd3" providerId="ADAL" clId="{388C2AD0-7FBA-4ABD-A38B-2191A5A7DC24}" dt="2023-12-13T12:56:11.281" v="416" actId="1076"/>
          <ac:cxnSpMkLst>
            <pc:docMk/>
            <pc:sldMk cId="2017378835" sldId="275"/>
            <ac:cxnSpMk id="9" creationId="{316C0CF5-3287-3765-388A-B8953E77BB7F}"/>
          </ac:cxnSpMkLst>
        </pc:cxnChg>
        <pc:cxnChg chg="mod">
          <ac:chgData name="Martin Røssel Larsen" userId="e4500570-1497-4d24-876e-2d6b64ed7cd3" providerId="ADAL" clId="{388C2AD0-7FBA-4ABD-A38B-2191A5A7DC24}" dt="2023-12-13T12:56:11.281" v="416" actId="1076"/>
          <ac:cxnSpMkLst>
            <pc:docMk/>
            <pc:sldMk cId="2017378835" sldId="275"/>
            <ac:cxnSpMk id="13" creationId="{F371A474-6777-21E6-8586-7EC998EFBAC0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57:17.112" v="430" actId="1076"/>
        <pc:sldMkLst>
          <pc:docMk/>
          <pc:sldMk cId="1357204555" sldId="276"/>
        </pc:sldMkLst>
        <pc:spChg chg="add mod">
          <ac:chgData name="Martin Røssel Larsen" userId="e4500570-1497-4d24-876e-2d6b64ed7cd3" providerId="ADAL" clId="{388C2AD0-7FBA-4ABD-A38B-2191A5A7DC24}" dt="2023-12-13T12:57:17.112" v="430" actId="1076"/>
          <ac:spMkLst>
            <pc:docMk/>
            <pc:sldMk cId="1357204555" sldId="276"/>
            <ac:spMk id="2" creationId="{01E85711-CF7E-EDE0-E4F0-520A9D6987E4}"/>
          </ac:spMkLst>
        </pc:spChg>
        <pc:spChg chg="mod">
          <ac:chgData name="Martin Røssel Larsen" userId="e4500570-1497-4d24-876e-2d6b64ed7cd3" providerId="ADAL" clId="{388C2AD0-7FBA-4ABD-A38B-2191A5A7DC24}" dt="2023-12-13T12:57:10.465" v="428" actId="1076"/>
          <ac:spMkLst>
            <pc:docMk/>
            <pc:sldMk cId="1357204555" sldId="276"/>
            <ac:spMk id="8" creationId="{E87F1C52-38F7-212C-8436-F67B25364AF4}"/>
          </ac:spMkLst>
        </pc:spChg>
        <pc:spChg chg="mod">
          <ac:chgData name="Martin Røssel Larsen" userId="e4500570-1497-4d24-876e-2d6b64ed7cd3" providerId="ADAL" clId="{388C2AD0-7FBA-4ABD-A38B-2191A5A7DC24}" dt="2023-12-13T12:57:10.465" v="428" actId="1076"/>
          <ac:spMkLst>
            <pc:docMk/>
            <pc:sldMk cId="1357204555" sldId="276"/>
            <ac:spMk id="10" creationId="{BA19E59F-56AB-3AB1-9309-D8EF1D5F4DFE}"/>
          </ac:spMkLst>
        </pc:spChg>
        <pc:spChg chg="mod">
          <ac:chgData name="Martin Røssel Larsen" userId="e4500570-1497-4d24-876e-2d6b64ed7cd3" providerId="ADAL" clId="{388C2AD0-7FBA-4ABD-A38B-2191A5A7DC24}" dt="2023-12-13T12:57:10.465" v="428" actId="1076"/>
          <ac:spMkLst>
            <pc:docMk/>
            <pc:sldMk cId="1357204555" sldId="276"/>
            <ac:spMk id="11" creationId="{8921F14B-3248-3BDE-9476-705B365BF2E1}"/>
          </ac:spMkLst>
        </pc:spChg>
        <pc:spChg chg="mod">
          <ac:chgData name="Martin Røssel Larsen" userId="e4500570-1497-4d24-876e-2d6b64ed7cd3" providerId="ADAL" clId="{388C2AD0-7FBA-4ABD-A38B-2191A5A7DC24}" dt="2023-12-13T12:57:10.465" v="428" actId="1076"/>
          <ac:spMkLst>
            <pc:docMk/>
            <pc:sldMk cId="1357204555" sldId="276"/>
            <ac:spMk id="12" creationId="{E610DEB4-D67E-1458-AC2A-F858596AA22A}"/>
          </ac:spMkLst>
        </pc:spChg>
        <pc:picChg chg="mod">
          <ac:chgData name="Martin Røssel Larsen" userId="e4500570-1497-4d24-876e-2d6b64ed7cd3" providerId="ADAL" clId="{388C2AD0-7FBA-4ABD-A38B-2191A5A7DC24}" dt="2023-12-13T12:57:10.465" v="428" actId="1076"/>
          <ac:picMkLst>
            <pc:docMk/>
            <pc:sldMk cId="1357204555" sldId="276"/>
            <ac:picMk id="3" creationId="{927008F4-46F9-2967-BB94-C133B9C94E4F}"/>
          </ac:picMkLst>
        </pc:picChg>
        <pc:picChg chg="add mod modCrop">
          <ac:chgData name="Martin Røssel Larsen" userId="e4500570-1497-4d24-876e-2d6b64ed7cd3" providerId="ADAL" clId="{388C2AD0-7FBA-4ABD-A38B-2191A5A7DC24}" dt="2023-12-13T12:57:14.184" v="429" actId="14100"/>
          <ac:picMkLst>
            <pc:docMk/>
            <pc:sldMk cId="1357204555" sldId="276"/>
            <ac:picMk id="5" creationId="{7FCAD566-1C74-6BA5-FA66-75E43DCD75FB}"/>
          </ac:picMkLst>
        </pc:picChg>
        <pc:cxnChg chg="mod">
          <ac:chgData name="Martin Røssel Larsen" userId="e4500570-1497-4d24-876e-2d6b64ed7cd3" providerId="ADAL" clId="{388C2AD0-7FBA-4ABD-A38B-2191A5A7DC24}" dt="2023-12-13T12:57:10.465" v="428" actId="1076"/>
          <ac:cxnSpMkLst>
            <pc:docMk/>
            <pc:sldMk cId="1357204555" sldId="276"/>
            <ac:cxnSpMk id="9" creationId="{3066E581-F587-1F34-CE4D-D14471271D30}"/>
          </ac:cxnSpMkLst>
        </pc:cxnChg>
        <pc:cxnChg chg="mod">
          <ac:chgData name="Martin Røssel Larsen" userId="e4500570-1497-4d24-876e-2d6b64ed7cd3" providerId="ADAL" clId="{388C2AD0-7FBA-4ABD-A38B-2191A5A7DC24}" dt="2023-12-13T12:57:10.465" v="428" actId="1076"/>
          <ac:cxnSpMkLst>
            <pc:docMk/>
            <pc:sldMk cId="1357204555" sldId="276"/>
            <ac:cxnSpMk id="13" creationId="{23B4FC82-70DA-FC2D-12BD-3CE858F1E24E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58:27.256" v="445" actId="1076"/>
        <pc:sldMkLst>
          <pc:docMk/>
          <pc:sldMk cId="2912629474" sldId="277"/>
        </pc:sldMkLst>
        <pc:spChg chg="add mod">
          <ac:chgData name="Martin Røssel Larsen" userId="e4500570-1497-4d24-876e-2d6b64ed7cd3" providerId="ADAL" clId="{388C2AD0-7FBA-4ABD-A38B-2191A5A7DC24}" dt="2023-12-13T12:58:27.256" v="445" actId="1076"/>
          <ac:spMkLst>
            <pc:docMk/>
            <pc:sldMk cId="2912629474" sldId="277"/>
            <ac:spMk id="3" creationId="{1B66B481-F7A5-0505-5762-80B318CFDF72}"/>
          </ac:spMkLst>
        </pc:spChg>
        <pc:spChg chg="mod">
          <ac:chgData name="Martin Røssel Larsen" userId="e4500570-1497-4d24-876e-2d6b64ed7cd3" providerId="ADAL" clId="{388C2AD0-7FBA-4ABD-A38B-2191A5A7DC24}" dt="2023-12-13T12:58:14.688" v="442" actId="1076"/>
          <ac:spMkLst>
            <pc:docMk/>
            <pc:sldMk cId="2912629474" sldId="277"/>
            <ac:spMk id="9" creationId="{E573C199-DA01-9A91-FDE2-F80DDA1B1B40}"/>
          </ac:spMkLst>
        </pc:spChg>
        <pc:spChg chg="mod">
          <ac:chgData name="Martin Røssel Larsen" userId="e4500570-1497-4d24-876e-2d6b64ed7cd3" providerId="ADAL" clId="{388C2AD0-7FBA-4ABD-A38B-2191A5A7DC24}" dt="2023-12-13T12:58:14.688" v="442" actId="1076"/>
          <ac:spMkLst>
            <pc:docMk/>
            <pc:sldMk cId="2912629474" sldId="277"/>
            <ac:spMk id="11" creationId="{096FDA0B-B1CE-9FC2-421C-F194C9C1444C}"/>
          </ac:spMkLst>
        </pc:spChg>
        <pc:spChg chg="mod">
          <ac:chgData name="Martin Røssel Larsen" userId="e4500570-1497-4d24-876e-2d6b64ed7cd3" providerId="ADAL" clId="{388C2AD0-7FBA-4ABD-A38B-2191A5A7DC24}" dt="2023-12-13T12:58:14.688" v="442" actId="1076"/>
          <ac:spMkLst>
            <pc:docMk/>
            <pc:sldMk cId="2912629474" sldId="277"/>
            <ac:spMk id="12" creationId="{EEECF053-B712-4D2E-53AC-E27A54209358}"/>
          </ac:spMkLst>
        </pc:spChg>
        <pc:spChg chg="mod">
          <ac:chgData name="Martin Røssel Larsen" userId="e4500570-1497-4d24-876e-2d6b64ed7cd3" providerId="ADAL" clId="{388C2AD0-7FBA-4ABD-A38B-2191A5A7DC24}" dt="2023-12-13T12:58:21.031" v="443" actId="1076"/>
          <ac:spMkLst>
            <pc:docMk/>
            <pc:sldMk cId="2912629474" sldId="277"/>
            <ac:spMk id="13" creationId="{7807252E-34D9-3250-3647-139E8C6F94FB}"/>
          </ac:spMkLst>
        </pc:spChg>
        <pc:picChg chg="mod">
          <ac:chgData name="Martin Røssel Larsen" userId="e4500570-1497-4d24-876e-2d6b64ed7cd3" providerId="ADAL" clId="{388C2AD0-7FBA-4ABD-A38B-2191A5A7DC24}" dt="2023-12-13T12:58:14.688" v="442" actId="1076"/>
          <ac:picMkLst>
            <pc:docMk/>
            <pc:sldMk cId="2912629474" sldId="277"/>
            <ac:picMk id="4" creationId="{6D2B1184-BF03-9121-B9D2-977A9E4C1A27}"/>
          </ac:picMkLst>
        </pc:picChg>
        <pc:picChg chg="add mod modCrop">
          <ac:chgData name="Martin Røssel Larsen" userId="e4500570-1497-4d24-876e-2d6b64ed7cd3" providerId="ADAL" clId="{388C2AD0-7FBA-4ABD-A38B-2191A5A7DC24}" dt="2023-12-13T12:58:25.032" v="444" actId="1076"/>
          <ac:picMkLst>
            <pc:docMk/>
            <pc:sldMk cId="2912629474" sldId="277"/>
            <ac:picMk id="15" creationId="{76CF55A0-988C-1BFB-217A-0C9F7A76A2BE}"/>
          </ac:picMkLst>
        </pc:picChg>
        <pc:cxnChg chg="mod">
          <ac:chgData name="Martin Røssel Larsen" userId="e4500570-1497-4d24-876e-2d6b64ed7cd3" providerId="ADAL" clId="{388C2AD0-7FBA-4ABD-A38B-2191A5A7DC24}" dt="2023-12-13T12:58:14.688" v="442" actId="1076"/>
          <ac:cxnSpMkLst>
            <pc:docMk/>
            <pc:sldMk cId="2912629474" sldId="277"/>
            <ac:cxnSpMk id="10" creationId="{924B17BB-AC54-4E00-4A27-1FF676609729}"/>
          </ac:cxnSpMkLst>
        </pc:cxnChg>
        <pc:cxnChg chg="mod">
          <ac:chgData name="Martin Røssel Larsen" userId="e4500570-1497-4d24-876e-2d6b64ed7cd3" providerId="ADAL" clId="{388C2AD0-7FBA-4ABD-A38B-2191A5A7DC24}" dt="2023-12-13T12:58:21.031" v="443" actId="1076"/>
          <ac:cxnSpMkLst>
            <pc:docMk/>
            <pc:sldMk cId="2912629474" sldId="277"/>
            <ac:cxnSpMk id="14" creationId="{14A39E0C-5E41-0A8C-FA7C-8DF40D2F0332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2:59:41.199" v="457" actId="1076"/>
        <pc:sldMkLst>
          <pc:docMk/>
          <pc:sldMk cId="3726271634" sldId="278"/>
        </pc:sldMkLst>
        <pc:spChg chg="add mod">
          <ac:chgData name="Martin Røssel Larsen" userId="e4500570-1497-4d24-876e-2d6b64ed7cd3" providerId="ADAL" clId="{388C2AD0-7FBA-4ABD-A38B-2191A5A7DC24}" dt="2023-12-13T12:59:41.199" v="457" actId="1076"/>
          <ac:spMkLst>
            <pc:docMk/>
            <pc:sldMk cId="3726271634" sldId="278"/>
            <ac:spMk id="3" creationId="{FAAFAEE1-E916-6540-7962-DD12BCCD2385}"/>
          </ac:spMkLst>
        </pc:spChg>
        <pc:spChg chg="mod">
          <ac:chgData name="Martin Røssel Larsen" userId="e4500570-1497-4d24-876e-2d6b64ed7cd3" providerId="ADAL" clId="{388C2AD0-7FBA-4ABD-A38B-2191A5A7DC24}" dt="2023-12-13T12:58:46.407" v="446" actId="1076"/>
          <ac:spMkLst>
            <pc:docMk/>
            <pc:sldMk cId="3726271634" sldId="278"/>
            <ac:spMk id="8" creationId="{603F8E54-9C6B-E2BF-9622-9940E9C5BDB3}"/>
          </ac:spMkLst>
        </pc:spChg>
        <pc:spChg chg="mod">
          <ac:chgData name="Martin Røssel Larsen" userId="e4500570-1497-4d24-876e-2d6b64ed7cd3" providerId="ADAL" clId="{388C2AD0-7FBA-4ABD-A38B-2191A5A7DC24}" dt="2023-12-13T12:58:46.407" v="446" actId="1076"/>
          <ac:spMkLst>
            <pc:docMk/>
            <pc:sldMk cId="3726271634" sldId="278"/>
            <ac:spMk id="10" creationId="{42B665D8-4FF4-46AC-53E7-2B1652C8398F}"/>
          </ac:spMkLst>
        </pc:spChg>
        <pc:spChg chg="mod">
          <ac:chgData name="Martin Røssel Larsen" userId="e4500570-1497-4d24-876e-2d6b64ed7cd3" providerId="ADAL" clId="{388C2AD0-7FBA-4ABD-A38B-2191A5A7DC24}" dt="2023-12-13T12:58:46.407" v="446" actId="1076"/>
          <ac:spMkLst>
            <pc:docMk/>
            <pc:sldMk cId="3726271634" sldId="278"/>
            <ac:spMk id="11" creationId="{A4C248BC-95CF-B409-79AE-94C72B7CA971}"/>
          </ac:spMkLst>
        </pc:spChg>
        <pc:spChg chg="mod">
          <ac:chgData name="Martin Røssel Larsen" userId="e4500570-1497-4d24-876e-2d6b64ed7cd3" providerId="ADAL" clId="{388C2AD0-7FBA-4ABD-A38B-2191A5A7DC24}" dt="2023-12-13T12:58:46.407" v="446" actId="1076"/>
          <ac:spMkLst>
            <pc:docMk/>
            <pc:sldMk cId="3726271634" sldId="278"/>
            <ac:spMk id="12" creationId="{2A13323A-C392-677F-1AF3-74FB4D15D7BB}"/>
          </ac:spMkLst>
        </pc:spChg>
        <pc:spChg chg="mod">
          <ac:chgData name="Martin Røssel Larsen" userId="e4500570-1497-4d24-876e-2d6b64ed7cd3" providerId="ADAL" clId="{388C2AD0-7FBA-4ABD-A38B-2191A5A7DC24}" dt="2023-12-13T12:58:46.407" v="446" actId="1076"/>
          <ac:spMkLst>
            <pc:docMk/>
            <pc:sldMk cId="3726271634" sldId="278"/>
            <ac:spMk id="17" creationId="{29A67778-51A3-7874-4DA2-E4C15AE1B3AD}"/>
          </ac:spMkLst>
        </pc:spChg>
        <pc:spChg chg="mod">
          <ac:chgData name="Martin Røssel Larsen" userId="e4500570-1497-4d24-876e-2d6b64ed7cd3" providerId="ADAL" clId="{388C2AD0-7FBA-4ABD-A38B-2191A5A7DC24}" dt="2023-12-13T12:58:46.407" v="446" actId="1076"/>
          <ac:spMkLst>
            <pc:docMk/>
            <pc:sldMk cId="3726271634" sldId="278"/>
            <ac:spMk id="18" creationId="{C462219F-22A2-BA65-E517-ADFCBC429960}"/>
          </ac:spMkLst>
        </pc:spChg>
        <pc:picChg chg="mod">
          <ac:chgData name="Martin Røssel Larsen" userId="e4500570-1497-4d24-876e-2d6b64ed7cd3" providerId="ADAL" clId="{388C2AD0-7FBA-4ABD-A38B-2191A5A7DC24}" dt="2023-12-13T12:58:46.407" v="446" actId="1076"/>
          <ac:picMkLst>
            <pc:docMk/>
            <pc:sldMk cId="3726271634" sldId="278"/>
            <ac:picMk id="4" creationId="{AD7F1BA1-BEEE-438F-9269-72238352A41C}"/>
          </ac:picMkLst>
        </pc:picChg>
        <pc:picChg chg="add mod modCrop">
          <ac:chgData name="Martin Røssel Larsen" userId="e4500570-1497-4d24-876e-2d6b64ed7cd3" providerId="ADAL" clId="{388C2AD0-7FBA-4ABD-A38B-2191A5A7DC24}" dt="2023-12-13T12:59:35.071" v="456" actId="14100"/>
          <ac:picMkLst>
            <pc:docMk/>
            <pc:sldMk cId="3726271634" sldId="278"/>
            <ac:picMk id="5" creationId="{AB1581D7-D1CB-56F3-5E69-FC139F36D187}"/>
          </ac:picMkLst>
        </pc:picChg>
        <pc:cxnChg chg="mod">
          <ac:chgData name="Martin Røssel Larsen" userId="e4500570-1497-4d24-876e-2d6b64ed7cd3" providerId="ADAL" clId="{388C2AD0-7FBA-4ABD-A38B-2191A5A7DC24}" dt="2023-12-13T12:58:46.407" v="446" actId="1076"/>
          <ac:cxnSpMkLst>
            <pc:docMk/>
            <pc:sldMk cId="3726271634" sldId="278"/>
            <ac:cxnSpMk id="9" creationId="{9FE6D5F9-6498-9905-694F-06C3B1C6F9B2}"/>
          </ac:cxnSpMkLst>
        </pc:cxnChg>
        <pc:cxnChg chg="mod">
          <ac:chgData name="Martin Røssel Larsen" userId="e4500570-1497-4d24-876e-2d6b64ed7cd3" providerId="ADAL" clId="{388C2AD0-7FBA-4ABD-A38B-2191A5A7DC24}" dt="2023-12-13T12:58:46.407" v="446" actId="1076"/>
          <ac:cxnSpMkLst>
            <pc:docMk/>
            <pc:sldMk cId="3726271634" sldId="278"/>
            <ac:cxnSpMk id="13" creationId="{D6EEC7E9-95FE-A445-B84D-F8489498138B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3:00:34.806" v="468" actId="1076"/>
        <pc:sldMkLst>
          <pc:docMk/>
          <pc:sldMk cId="4052958208" sldId="279"/>
        </pc:sldMkLst>
        <pc:spChg chg="add mod">
          <ac:chgData name="Martin Røssel Larsen" userId="e4500570-1497-4d24-876e-2d6b64ed7cd3" providerId="ADAL" clId="{388C2AD0-7FBA-4ABD-A38B-2191A5A7DC24}" dt="2023-12-13T13:00:19.983" v="465" actId="1076"/>
          <ac:spMkLst>
            <pc:docMk/>
            <pc:sldMk cId="4052958208" sldId="279"/>
            <ac:spMk id="3" creationId="{30E62F21-FC7C-4732-E4BD-7A64062EE05C}"/>
          </ac:spMkLst>
        </pc:spChg>
        <pc:spChg chg="mod">
          <ac:chgData name="Martin Røssel Larsen" userId="e4500570-1497-4d24-876e-2d6b64ed7cd3" providerId="ADAL" clId="{388C2AD0-7FBA-4ABD-A38B-2191A5A7DC24}" dt="2023-12-13T13:00:29.719" v="467" actId="1076"/>
          <ac:spMkLst>
            <pc:docMk/>
            <pc:sldMk cId="4052958208" sldId="279"/>
            <ac:spMk id="8" creationId="{50E6D383-EEDE-B286-5C84-53A0E5DA936E}"/>
          </ac:spMkLst>
        </pc:spChg>
        <pc:spChg chg="mod">
          <ac:chgData name="Martin Røssel Larsen" userId="e4500570-1497-4d24-876e-2d6b64ed7cd3" providerId="ADAL" clId="{388C2AD0-7FBA-4ABD-A38B-2191A5A7DC24}" dt="2023-12-13T13:00:29.719" v="467" actId="1076"/>
          <ac:spMkLst>
            <pc:docMk/>
            <pc:sldMk cId="4052958208" sldId="279"/>
            <ac:spMk id="10" creationId="{0636E11E-E1B0-63DE-483E-CDA73480AB8E}"/>
          </ac:spMkLst>
        </pc:spChg>
        <pc:spChg chg="mod">
          <ac:chgData name="Martin Røssel Larsen" userId="e4500570-1497-4d24-876e-2d6b64ed7cd3" providerId="ADAL" clId="{388C2AD0-7FBA-4ABD-A38B-2191A5A7DC24}" dt="2023-12-13T13:00:29.719" v="467" actId="1076"/>
          <ac:spMkLst>
            <pc:docMk/>
            <pc:sldMk cId="4052958208" sldId="279"/>
            <ac:spMk id="11" creationId="{E6DAC0E1-9484-0933-CF7B-A2A972B9B731}"/>
          </ac:spMkLst>
        </pc:spChg>
        <pc:spChg chg="mod">
          <ac:chgData name="Martin Røssel Larsen" userId="e4500570-1497-4d24-876e-2d6b64ed7cd3" providerId="ADAL" clId="{388C2AD0-7FBA-4ABD-A38B-2191A5A7DC24}" dt="2023-12-13T13:00:34.806" v="468" actId="1076"/>
          <ac:spMkLst>
            <pc:docMk/>
            <pc:sldMk cId="4052958208" sldId="279"/>
            <ac:spMk id="12" creationId="{1765F9A1-2318-8835-798C-3773FFE18407}"/>
          </ac:spMkLst>
        </pc:spChg>
        <pc:picChg chg="mod">
          <ac:chgData name="Martin Røssel Larsen" userId="e4500570-1497-4d24-876e-2d6b64ed7cd3" providerId="ADAL" clId="{388C2AD0-7FBA-4ABD-A38B-2191A5A7DC24}" dt="2023-12-13T13:00:29.719" v="467" actId="1076"/>
          <ac:picMkLst>
            <pc:docMk/>
            <pc:sldMk cId="4052958208" sldId="279"/>
            <ac:picMk id="4" creationId="{0A65AE35-BA53-206E-7DF9-EEB68A5F4113}"/>
          </ac:picMkLst>
        </pc:picChg>
        <pc:picChg chg="add mod modCrop">
          <ac:chgData name="Martin Røssel Larsen" userId="e4500570-1497-4d24-876e-2d6b64ed7cd3" providerId="ADAL" clId="{388C2AD0-7FBA-4ABD-A38B-2191A5A7DC24}" dt="2023-12-13T13:00:21.718" v="466" actId="1076"/>
          <ac:picMkLst>
            <pc:docMk/>
            <pc:sldMk cId="4052958208" sldId="279"/>
            <ac:picMk id="5" creationId="{67946A3D-33F1-3F44-217C-881494307BAE}"/>
          </ac:picMkLst>
        </pc:picChg>
        <pc:cxnChg chg="mod">
          <ac:chgData name="Martin Røssel Larsen" userId="e4500570-1497-4d24-876e-2d6b64ed7cd3" providerId="ADAL" clId="{388C2AD0-7FBA-4ABD-A38B-2191A5A7DC24}" dt="2023-12-13T13:00:29.719" v="467" actId="1076"/>
          <ac:cxnSpMkLst>
            <pc:docMk/>
            <pc:sldMk cId="4052958208" sldId="279"/>
            <ac:cxnSpMk id="9" creationId="{699B5DEB-C270-6B86-DF1C-93473CBCC9D0}"/>
          </ac:cxnSpMkLst>
        </pc:cxnChg>
        <pc:cxnChg chg="mod">
          <ac:chgData name="Martin Røssel Larsen" userId="e4500570-1497-4d24-876e-2d6b64ed7cd3" providerId="ADAL" clId="{388C2AD0-7FBA-4ABD-A38B-2191A5A7DC24}" dt="2023-12-13T13:00:29.719" v="467" actId="1076"/>
          <ac:cxnSpMkLst>
            <pc:docMk/>
            <pc:sldMk cId="4052958208" sldId="279"/>
            <ac:cxnSpMk id="13" creationId="{89A45EA1-D64C-7E7C-8BF5-42CE463EC69C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5T08:43:29.216" v="478" actId="1076"/>
        <pc:sldMkLst>
          <pc:docMk/>
          <pc:sldMk cId="61995214" sldId="280"/>
        </pc:sldMkLst>
        <pc:spChg chg="add mod">
          <ac:chgData name="Martin Røssel Larsen" userId="e4500570-1497-4d24-876e-2d6b64ed7cd3" providerId="ADAL" clId="{388C2AD0-7FBA-4ABD-A38B-2191A5A7DC24}" dt="2023-12-13T13:01:29.535" v="477" actId="1076"/>
          <ac:spMkLst>
            <pc:docMk/>
            <pc:sldMk cId="61995214" sldId="280"/>
            <ac:spMk id="2" creationId="{C5D1305A-05F7-2E91-193E-75988A30D093}"/>
          </ac:spMkLst>
        </pc:spChg>
        <pc:spChg chg="mod">
          <ac:chgData name="Martin Røssel Larsen" userId="e4500570-1497-4d24-876e-2d6b64ed7cd3" providerId="ADAL" clId="{388C2AD0-7FBA-4ABD-A38B-2191A5A7DC24}" dt="2023-12-15T08:43:29.216" v="478" actId="1076"/>
          <ac:spMkLst>
            <pc:docMk/>
            <pc:sldMk cId="61995214" sldId="280"/>
            <ac:spMk id="4" creationId="{A6009E10-9C33-68B5-1C14-D640117A2595}"/>
          </ac:spMkLst>
        </pc:spChg>
        <pc:spChg chg="mod">
          <ac:chgData name="Martin Røssel Larsen" userId="e4500570-1497-4d24-876e-2d6b64ed7cd3" providerId="ADAL" clId="{388C2AD0-7FBA-4ABD-A38B-2191A5A7DC24}" dt="2023-12-13T13:00:48.199" v="469" actId="1076"/>
          <ac:spMkLst>
            <pc:docMk/>
            <pc:sldMk cId="61995214" sldId="280"/>
            <ac:spMk id="8" creationId="{A26C5E5A-BAFF-C166-7007-382EBC22DB00}"/>
          </ac:spMkLst>
        </pc:spChg>
        <pc:spChg chg="mod">
          <ac:chgData name="Martin Røssel Larsen" userId="e4500570-1497-4d24-876e-2d6b64ed7cd3" providerId="ADAL" clId="{388C2AD0-7FBA-4ABD-A38B-2191A5A7DC24}" dt="2023-12-13T13:00:48.199" v="469" actId="1076"/>
          <ac:spMkLst>
            <pc:docMk/>
            <pc:sldMk cId="61995214" sldId="280"/>
            <ac:spMk id="10" creationId="{13BFA873-0D89-03DE-BF01-302DE6202020}"/>
          </ac:spMkLst>
        </pc:spChg>
        <pc:spChg chg="mod">
          <ac:chgData name="Martin Røssel Larsen" userId="e4500570-1497-4d24-876e-2d6b64ed7cd3" providerId="ADAL" clId="{388C2AD0-7FBA-4ABD-A38B-2191A5A7DC24}" dt="2023-12-13T13:00:48.199" v="469" actId="1076"/>
          <ac:spMkLst>
            <pc:docMk/>
            <pc:sldMk cId="61995214" sldId="280"/>
            <ac:spMk id="11" creationId="{FDE79D31-D743-7D36-3A3B-CFB1E3545F3A}"/>
          </ac:spMkLst>
        </pc:spChg>
        <pc:spChg chg="mod">
          <ac:chgData name="Martin Røssel Larsen" userId="e4500570-1497-4d24-876e-2d6b64ed7cd3" providerId="ADAL" clId="{388C2AD0-7FBA-4ABD-A38B-2191A5A7DC24}" dt="2023-12-13T13:00:48.199" v="469" actId="1076"/>
          <ac:spMkLst>
            <pc:docMk/>
            <pc:sldMk cId="61995214" sldId="280"/>
            <ac:spMk id="12" creationId="{08610E49-D050-5365-76E0-C31481CAC591}"/>
          </ac:spMkLst>
        </pc:spChg>
        <pc:spChg chg="add mod">
          <ac:chgData name="Martin Røssel Larsen" userId="e4500570-1497-4d24-876e-2d6b64ed7cd3" providerId="ADAL" clId="{388C2AD0-7FBA-4ABD-A38B-2191A5A7DC24}" dt="2023-12-13T13:00:48.199" v="469" actId="1076"/>
          <ac:spMkLst>
            <pc:docMk/>
            <pc:sldMk cId="61995214" sldId="280"/>
            <ac:spMk id="14" creationId="{B4413D59-9917-2EAC-B3B8-F1C31604846F}"/>
          </ac:spMkLst>
        </pc:spChg>
        <pc:spChg chg="add mod">
          <ac:chgData name="Martin Røssel Larsen" userId="e4500570-1497-4d24-876e-2d6b64ed7cd3" providerId="ADAL" clId="{388C2AD0-7FBA-4ABD-A38B-2191A5A7DC24}" dt="2023-12-13T13:00:48.199" v="469" actId="1076"/>
          <ac:spMkLst>
            <pc:docMk/>
            <pc:sldMk cId="61995214" sldId="280"/>
            <ac:spMk id="15" creationId="{6B78F6E4-18AD-475E-E5E5-718992EBC339}"/>
          </ac:spMkLst>
        </pc:spChg>
        <pc:picChg chg="mod">
          <ac:chgData name="Martin Røssel Larsen" userId="e4500570-1497-4d24-876e-2d6b64ed7cd3" providerId="ADAL" clId="{388C2AD0-7FBA-4ABD-A38B-2191A5A7DC24}" dt="2023-12-13T13:00:48.199" v="469" actId="1076"/>
          <ac:picMkLst>
            <pc:docMk/>
            <pc:sldMk cId="61995214" sldId="280"/>
            <ac:picMk id="3" creationId="{30C9CCE9-19F8-D0F7-47F3-8CFCC2DA19AE}"/>
          </ac:picMkLst>
        </pc:picChg>
        <pc:picChg chg="add mod modCrop">
          <ac:chgData name="Martin Røssel Larsen" userId="e4500570-1497-4d24-876e-2d6b64ed7cd3" providerId="ADAL" clId="{388C2AD0-7FBA-4ABD-A38B-2191A5A7DC24}" dt="2023-12-13T13:01:26.615" v="476" actId="1076"/>
          <ac:picMkLst>
            <pc:docMk/>
            <pc:sldMk cId="61995214" sldId="280"/>
            <ac:picMk id="5" creationId="{43FE6864-4E85-C9C6-1398-EFCEC29A6EAB}"/>
          </ac:picMkLst>
        </pc:picChg>
        <pc:cxnChg chg="mod">
          <ac:chgData name="Martin Røssel Larsen" userId="e4500570-1497-4d24-876e-2d6b64ed7cd3" providerId="ADAL" clId="{388C2AD0-7FBA-4ABD-A38B-2191A5A7DC24}" dt="2023-12-13T13:00:48.199" v="469" actId="1076"/>
          <ac:cxnSpMkLst>
            <pc:docMk/>
            <pc:sldMk cId="61995214" sldId="280"/>
            <ac:cxnSpMk id="9" creationId="{E6A806FA-7D5A-749F-CBBF-169CA6056C82}"/>
          </ac:cxnSpMkLst>
        </pc:cxnChg>
        <pc:cxnChg chg="mod">
          <ac:chgData name="Martin Røssel Larsen" userId="e4500570-1497-4d24-876e-2d6b64ed7cd3" providerId="ADAL" clId="{388C2AD0-7FBA-4ABD-A38B-2191A5A7DC24}" dt="2023-12-13T13:00:48.199" v="469" actId="1076"/>
          <ac:cxnSpMkLst>
            <pc:docMk/>
            <pc:sldMk cId="61995214" sldId="280"/>
            <ac:cxnSpMk id="13" creationId="{E1E29E65-470A-E13D-0904-56043BB1A933}"/>
          </ac:cxnSpMkLst>
        </pc:cxnChg>
        <pc:cxnChg chg="add mod">
          <ac:chgData name="Martin Røssel Larsen" userId="e4500570-1497-4d24-876e-2d6b64ed7cd3" providerId="ADAL" clId="{388C2AD0-7FBA-4ABD-A38B-2191A5A7DC24}" dt="2023-12-13T13:00:48.199" v="469" actId="1076"/>
          <ac:cxnSpMkLst>
            <pc:docMk/>
            <pc:sldMk cId="61995214" sldId="280"/>
            <ac:cxnSpMk id="16" creationId="{ECB193C8-E934-0F0E-261F-BB780A470496}"/>
          </ac:cxnSpMkLst>
        </pc:cxnChg>
      </pc:sldChg>
      <pc:sldChg chg="addSp modSp mod">
        <pc:chgData name="Martin Røssel Larsen" userId="e4500570-1497-4d24-876e-2d6b64ed7cd3" providerId="ADAL" clId="{388C2AD0-7FBA-4ABD-A38B-2191A5A7DC24}" dt="2023-12-13T11:36:54.821" v="229" actId="1076"/>
        <pc:sldMkLst>
          <pc:docMk/>
          <pc:sldMk cId="1656431431" sldId="281"/>
        </pc:sldMkLst>
        <pc:spChg chg="add mod">
          <ac:chgData name="Martin Røssel Larsen" userId="e4500570-1497-4d24-876e-2d6b64ed7cd3" providerId="ADAL" clId="{388C2AD0-7FBA-4ABD-A38B-2191A5A7DC24}" dt="2023-12-13T11:32:33.701" v="100"/>
          <ac:spMkLst>
            <pc:docMk/>
            <pc:sldMk cId="1656431431" sldId="281"/>
            <ac:spMk id="2" creationId="{DFCFE387-5446-2255-804B-C7EC2AE9BB52}"/>
          </ac:spMkLst>
        </pc:spChg>
        <pc:spChg chg="mod">
          <ac:chgData name="Martin Røssel Larsen" userId="e4500570-1497-4d24-876e-2d6b64ed7cd3" providerId="ADAL" clId="{388C2AD0-7FBA-4ABD-A38B-2191A5A7DC24}" dt="2023-11-20T14:38:31.444" v="31" actId="1076"/>
          <ac:spMkLst>
            <pc:docMk/>
            <pc:sldMk cId="1656431431" sldId="281"/>
            <ac:spMk id="7" creationId="{1D1FB7C9-6362-1E6C-2DE0-BD37BE8A5469}"/>
          </ac:spMkLst>
        </pc:spChg>
        <pc:picChg chg="add mod modCrop">
          <ac:chgData name="Martin Røssel Larsen" userId="e4500570-1497-4d24-876e-2d6b64ed7cd3" providerId="ADAL" clId="{388C2AD0-7FBA-4ABD-A38B-2191A5A7DC24}" dt="2023-12-13T11:36:54.821" v="229" actId="1076"/>
          <ac:picMkLst>
            <pc:docMk/>
            <pc:sldMk cId="1656431431" sldId="281"/>
            <ac:picMk id="4" creationId="{F690F80A-1934-8A05-9B05-D5BC4ACAEC0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02638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37970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0521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793160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68585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90261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81626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19300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74512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00072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16920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302AC-1CDB-4642-A93D-B8A1177E6A38}" type="datetimeFigureOut">
              <a:rPr lang="da-DK" smtClean="0"/>
              <a:t>17-12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C58BBC-36EB-461E-973E-78D1E94AE1EE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259358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Billede 14">
            <a:extLst>
              <a:ext uri="{FF2B5EF4-FFF2-40B4-BE49-F238E27FC236}">
                <a16:creationId xmlns:a16="http://schemas.microsoft.com/office/drawing/2014/main" id="{B535C5C2-8C2E-686B-3C85-78DA544D291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111" t="45831" r="38154" b="19119"/>
          <a:stretch/>
        </p:blipFill>
        <p:spPr>
          <a:xfrm>
            <a:off x="1259446" y="898951"/>
            <a:ext cx="8229683" cy="3744885"/>
          </a:xfrm>
          <a:prstGeom prst="rect">
            <a:avLst/>
          </a:prstGeom>
        </p:spPr>
      </p:pic>
      <p:sp>
        <p:nvSpPr>
          <p:cNvPr id="16" name="TextBox 11">
            <a:extLst>
              <a:ext uri="{FF2B5EF4-FFF2-40B4-BE49-F238E27FC236}">
                <a16:creationId xmlns:a16="http://schemas.microsoft.com/office/drawing/2014/main" id="{F3A91954-6A39-F9A4-A39B-3291951D9B1F}"/>
              </a:ext>
            </a:extLst>
          </p:cNvPr>
          <p:cNvSpPr txBox="1"/>
          <p:nvPr/>
        </p:nvSpPr>
        <p:spPr>
          <a:xfrm>
            <a:off x="4422896" y="267648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</a:t>
            </a:r>
          </a:p>
        </p:txBody>
      </p:sp>
      <p:sp>
        <p:nvSpPr>
          <p:cNvPr id="17" name="TextBox 34">
            <a:extLst>
              <a:ext uri="{FF2B5EF4-FFF2-40B4-BE49-F238E27FC236}">
                <a16:creationId xmlns:a16="http://schemas.microsoft.com/office/drawing/2014/main" id="{7136C541-D225-79B3-5CC1-2A0E3383498F}"/>
              </a:ext>
            </a:extLst>
          </p:cNvPr>
          <p:cNvSpPr txBox="1"/>
          <p:nvPr/>
        </p:nvSpPr>
        <p:spPr>
          <a:xfrm>
            <a:off x="3977786" y="3935915"/>
            <a:ext cx="1719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/>
              <a:t>Helical</a:t>
            </a:r>
            <a:r>
              <a:rPr lang="da-DK" sz="1200" dirty="0"/>
              <a:t> - </a:t>
            </a:r>
            <a:r>
              <a:rPr lang="da-DK" sz="1200" dirty="0" err="1"/>
              <a:t>transmembrane</a:t>
            </a:r>
            <a:endParaRPr lang="da-DK" sz="1200" dirty="0"/>
          </a:p>
        </p:txBody>
      </p:sp>
      <p:sp>
        <p:nvSpPr>
          <p:cNvPr id="18" name="Tekstfelt 17">
            <a:extLst>
              <a:ext uri="{FF2B5EF4-FFF2-40B4-BE49-F238E27FC236}">
                <a16:creationId xmlns:a16="http://schemas.microsoft.com/office/drawing/2014/main" id="{499A4775-7A98-8010-2B9A-A3AA7B1BF2A7}"/>
              </a:ext>
            </a:extLst>
          </p:cNvPr>
          <p:cNvSpPr txBox="1"/>
          <p:nvPr/>
        </p:nvSpPr>
        <p:spPr>
          <a:xfrm>
            <a:off x="6106804" y="4459170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61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20" name="Lige pilforbindelse 19">
            <a:extLst>
              <a:ext uri="{FF2B5EF4-FFF2-40B4-BE49-F238E27FC236}">
                <a16:creationId xmlns:a16="http://schemas.microsoft.com/office/drawing/2014/main" id="{7DCEE478-57A0-6324-D201-77ED881F6752}"/>
              </a:ext>
            </a:extLst>
          </p:cNvPr>
          <p:cNvCxnSpPr/>
          <p:nvPr/>
        </p:nvCxnSpPr>
        <p:spPr>
          <a:xfrm flipH="1" flipV="1">
            <a:off x="5619353" y="3097670"/>
            <a:ext cx="977902" cy="1388225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Ellipse 20">
            <a:extLst>
              <a:ext uri="{FF2B5EF4-FFF2-40B4-BE49-F238E27FC236}">
                <a16:creationId xmlns:a16="http://schemas.microsoft.com/office/drawing/2014/main" id="{32F5FA7B-84E3-001C-4E61-508750BEA60C}"/>
              </a:ext>
            </a:extLst>
          </p:cNvPr>
          <p:cNvSpPr/>
          <p:nvPr/>
        </p:nvSpPr>
        <p:spPr>
          <a:xfrm>
            <a:off x="5374287" y="2771393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3" name="Tekstfelt 22">
            <a:extLst>
              <a:ext uri="{FF2B5EF4-FFF2-40B4-BE49-F238E27FC236}">
                <a16:creationId xmlns:a16="http://schemas.microsoft.com/office/drawing/2014/main" id="{DFEAE663-4CFF-331A-0994-F9878706A336}"/>
              </a:ext>
            </a:extLst>
          </p:cNvPr>
          <p:cNvSpPr txBox="1"/>
          <p:nvPr/>
        </p:nvSpPr>
        <p:spPr>
          <a:xfrm>
            <a:off x="2143298" y="5147957"/>
            <a:ext cx="561940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L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VDVSARSK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CGF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61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WL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24" name="Ellipse 23">
            <a:extLst>
              <a:ext uri="{FF2B5EF4-FFF2-40B4-BE49-F238E27FC236}">
                <a16:creationId xmlns:a16="http://schemas.microsoft.com/office/drawing/2014/main" id="{47A76BE0-859B-E812-99BB-5C3EE2CFEB6F}"/>
              </a:ext>
            </a:extLst>
          </p:cNvPr>
          <p:cNvSpPr/>
          <p:nvPr/>
        </p:nvSpPr>
        <p:spPr>
          <a:xfrm>
            <a:off x="5739219" y="2615531"/>
            <a:ext cx="977902" cy="656706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cxnSp>
        <p:nvCxnSpPr>
          <p:cNvPr id="27" name="Lige pilforbindelse 26">
            <a:extLst>
              <a:ext uri="{FF2B5EF4-FFF2-40B4-BE49-F238E27FC236}">
                <a16:creationId xmlns:a16="http://schemas.microsoft.com/office/drawing/2014/main" id="{B275DEF2-AB69-2669-E25A-58C857148F53}"/>
              </a:ext>
            </a:extLst>
          </p:cNvPr>
          <p:cNvCxnSpPr/>
          <p:nvPr/>
        </p:nvCxnSpPr>
        <p:spPr>
          <a:xfrm flipH="1">
            <a:off x="6717121" y="2615531"/>
            <a:ext cx="994040" cy="241070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ktangel 28">
            <a:extLst>
              <a:ext uri="{FF2B5EF4-FFF2-40B4-BE49-F238E27FC236}">
                <a16:creationId xmlns:a16="http://schemas.microsoft.com/office/drawing/2014/main" id="{F67EB62F-E7B6-1DE0-E224-9E7A3C59888B}"/>
              </a:ext>
            </a:extLst>
          </p:cNvPr>
          <p:cNvSpPr/>
          <p:nvPr/>
        </p:nvSpPr>
        <p:spPr>
          <a:xfrm>
            <a:off x="5895470" y="6021410"/>
            <a:ext cx="798022" cy="27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0" name="Tekstfelt 29">
            <a:extLst>
              <a:ext uri="{FF2B5EF4-FFF2-40B4-BE49-F238E27FC236}">
                <a16:creationId xmlns:a16="http://schemas.microsoft.com/office/drawing/2014/main" id="{86EA0492-AED6-C897-F407-3DFCBDB847EA}"/>
              </a:ext>
            </a:extLst>
          </p:cNvPr>
          <p:cNvSpPr txBox="1"/>
          <p:nvPr/>
        </p:nvSpPr>
        <p:spPr>
          <a:xfrm>
            <a:off x="6742114" y="5959925"/>
            <a:ext cx="15584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= </a:t>
            </a:r>
            <a:r>
              <a:rPr lang="da-DK" dirty="0" err="1"/>
              <a:t>zDHHC</a:t>
            </a:r>
            <a:r>
              <a:rPr lang="da-DK" dirty="0"/>
              <a:t> </a:t>
            </a:r>
            <a:r>
              <a:rPr lang="da-DK" dirty="0" err="1"/>
              <a:t>motif</a:t>
            </a:r>
            <a:endParaRPr lang="da-DK" dirty="0"/>
          </a:p>
        </p:txBody>
      </p:sp>
      <p:sp>
        <p:nvSpPr>
          <p:cNvPr id="31" name="Tekstfelt 30">
            <a:extLst>
              <a:ext uri="{FF2B5EF4-FFF2-40B4-BE49-F238E27FC236}">
                <a16:creationId xmlns:a16="http://schemas.microsoft.com/office/drawing/2014/main" id="{E41C5198-1182-A07A-6BBA-9EE904963E21}"/>
              </a:ext>
            </a:extLst>
          </p:cNvPr>
          <p:cNvSpPr txBox="1"/>
          <p:nvPr/>
        </p:nvSpPr>
        <p:spPr>
          <a:xfrm>
            <a:off x="5606344" y="6365522"/>
            <a:ext cx="42788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Underscore = </a:t>
            </a:r>
            <a:r>
              <a:rPr lang="da-DK" dirty="0" err="1"/>
              <a:t>Identified</a:t>
            </a:r>
            <a:r>
              <a:rPr lang="da-DK" dirty="0"/>
              <a:t> </a:t>
            </a:r>
            <a:r>
              <a:rPr lang="da-DK" dirty="0" err="1"/>
              <a:t>palmitoylation</a:t>
            </a:r>
            <a:r>
              <a:rPr lang="da-DK" dirty="0"/>
              <a:t> sites</a:t>
            </a:r>
          </a:p>
        </p:txBody>
      </p:sp>
      <p:sp>
        <p:nvSpPr>
          <p:cNvPr id="2" name="Rektangel 27">
            <a:extLst>
              <a:ext uri="{FF2B5EF4-FFF2-40B4-BE49-F238E27FC236}">
                <a16:creationId xmlns:a16="http://schemas.microsoft.com/office/drawing/2014/main" id="{A1832964-C619-EEC2-2A7C-D354B3A0C19F}"/>
              </a:ext>
            </a:extLst>
          </p:cNvPr>
          <p:cNvSpPr/>
          <p:nvPr/>
        </p:nvSpPr>
        <p:spPr>
          <a:xfrm>
            <a:off x="5488217" y="5170720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5" name="Tekstfelt 24">
            <a:extLst>
              <a:ext uri="{FF2B5EF4-FFF2-40B4-BE49-F238E27FC236}">
                <a16:creationId xmlns:a16="http://schemas.microsoft.com/office/drawing/2014/main" id="{40A0C8FE-9EA4-148C-B3FA-9DE2C1F7974F}"/>
              </a:ext>
            </a:extLst>
          </p:cNvPr>
          <p:cNvSpPr txBox="1"/>
          <p:nvPr/>
        </p:nvSpPr>
        <p:spPr>
          <a:xfrm>
            <a:off x="7558283" y="2068263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CDE91C1-CC2E-4D34-4417-282A3455BC1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849" r="1736" b="20699"/>
          <a:stretch/>
        </p:blipFill>
        <p:spPr>
          <a:xfrm>
            <a:off x="7060" y="562563"/>
            <a:ext cx="3995255" cy="16694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A6C31FE-0DCD-3816-5777-1EC937AE6234}"/>
              </a:ext>
            </a:extLst>
          </p:cNvPr>
          <p:cNvSpPr txBox="1"/>
          <p:nvPr/>
        </p:nvSpPr>
        <p:spPr>
          <a:xfrm>
            <a:off x="611715" y="307430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B40E8EA-AD62-920E-EB98-F27F587F7206}"/>
              </a:ext>
            </a:extLst>
          </p:cNvPr>
          <p:cNvSpPr txBox="1"/>
          <p:nvPr/>
        </p:nvSpPr>
        <p:spPr>
          <a:xfrm>
            <a:off x="-31205" y="1597833"/>
            <a:ext cx="8707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800" dirty="0"/>
              <a:t>Green – 1% FDR</a:t>
            </a:r>
          </a:p>
          <a:p>
            <a:r>
              <a:rPr lang="da-DK" sz="800" dirty="0"/>
              <a:t>Yellow – 5% FDR</a:t>
            </a:r>
          </a:p>
        </p:txBody>
      </p:sp>
    </p:spTree>
    <p:extLst>
      <p:ext uri="{BB962C8B-B14F-4D97-AF65-F5344CB8AC3E}">
        <p14:creationId xmlns:p14="http://schemas.microsoft.com/office/powerpoint/2010/main" val="42717620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6BD5010-4A84-C03F-EE7C-3C375CC0230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087" t="35031" r="38384" b="13845"/>
          <a:stretch/>
        </p:blipFill>
        <p:spPr>
          <a:xfrm>
            <a:off x="1964368" y="484840"/>
            <a:ext cx="5119830" cy="349821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3495A9E-6D9C-B043-C569-5D481B92B50A}"/>
              </a:ext>
            </a:extLst>
          </p:cNvPr>
          <p:cNvSpPr txBox="1"/>
          <p:nvPr/>
        </p:nvSpPr>
        <p:spPr>
          <a:xfrm>
            <a:off x="2227625" y="5419462"/>
            <a:ext cx="54507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L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VTASKKAK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G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8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WL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8" name="TextBox 10">
            <a:extLst>
              <a:ext uri="{FF2B5EF4-FFF2-40B4-BE49-F238E27FC236}">
                <a16:creationId xmlns:a16="http://schemas.microsoft.com/office/drawing/2014/main" id="{478505E8-4320-16D0-273A-951707816E03}"/>
              </a:ext>
            </a:extLst>
          </p:cNvPr>
          <p:cNvSpPr txBox="1"/>
          <p:nvPr/>
        </p:nvSpPr>
        <p:spPr>
          <a:xfrm>
            <a:off x="4257761" y="253658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1</a:t>
            </a:r>
          </a:p>
        </p:txBody>
      </p:sp>
      <p:sp>
        <p:nvSpPr>
          <p:cNvPr id="9" name="Rektangel 27">
            <a:extLst>
              <a:ext uri="{FF2B5EF4-FFF2-40B4-BE49-F238E27FC236}">
                <a16:creationId xmlns:a16="http://schemas.microsoft.com/office/drawing/2014/main" id="{8AE5B760-5FE9-510D-5A90-CE83D8A5BDF7}"/>
              </a:ext>
            </a:extLst>
          </p:cNvPr>
          <p:cNvSpPr/>
          <p:nvPr/>
        </p:nvSpPr>
        <p:spPr>
          <a:xfrm>
            <a:off x="5452621" y="5440327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0" name="Tekstfelt 17">
            <a:extLst>
              <a:ext uri="{FF2B5EF4-FFF2-40B4-BE49-F238E27FC236}">
                <a16:creationId xmlns:a16="http://schemas.microsoft.com/office/drawing/2014/main" id="{BE99AC8E-0878-FA67-AEBB-E02DBEB71729}"/>
              </a:ext>
            </a:extLst>
          </p:cNvPr>
          <p:cNvSpPr txBox="1"/>
          <p:nvPr/>
        </p:nvSpPr>
        <p:spPr>
          <a:xfrm>
            <a:off x="4390041" y="3532986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58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1" name="Lige pilforbindelse 19">
            <a:extLst>
              <a:ext uri="{FF2B5EF4-FFF2-40B4-BE49-F238E27FC236}">
                <a16:creationId xmlns:a16="http://schemas.microsoft.com/office/drawing/2014/main" id="{5DCD5503-1D2B-0653-F0BD-606E79D1B1C9}"/>
              </a:ext>
            </a:extLst>
          </p:cNvPr>
          <p:cNvCxnSpPr>
            <a:cxnSpLocks/>
            <a:stCxn id="10" idx="0"/>
          </p:cNvCxnSpPr>
          <p:nvPr/>
        </p:nvCxnSpPr>
        <p:spPr>
          <a:xfrm flipH="1" flipV="1">
            <a:off x="4655764" y="2459512"/>
            <a:ext cx="587267" cy="1073474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Ellipse 20">
            <a:extLst>
              <a:ext uri="{FF2B5EF4-FFF2-40B4-BE49-F238E27FC236}">
                <a16:creationId xmlns:a16="http://schemas.microsoft.com/office/drawing/2014/main" id="{FF679B62-9857-EDC8-E1EC-7ED0EA6B99B8}"/>
              </a:ext>
            </a:extLst>
          </p:cNvPr>
          <p:cNvSpPr/>
          <p:nvPr/>
        </p:nvSpPr>
        <p:spPr>
          <a:xfrm>
            <a:off x="4303770" y="2029243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3" name="Ellipse 23">
            <a:extLst>
              <a:ext uri="{FF2B5EF4-FFF2-40B4-BE49-F238E27FC236}">
                <a16:creationId xmlns:a16="http://schemas.microsoft.com/office/drawing/2014/main" id="{8AE29235-7924-29A2-20CF-78ED792AC308}"/>
              </a:ext>
            </a:extLst>
          </p:cNvPr>
          <p:cNvSpPr/>
          <p:nvPr/>
        </p:nvSpPr>
        <p:spPr>
          <a:xfrm>
            <a:off x="4524283" y="1793913"/>
            <a:ext cx="911129" cy="758147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4" name="Tekstfelt 24">
            <a:extLst>
              <a:ext uri="{FF2B5EF4-FFF2-40B4-BE49-F238E27FC236}">
                <a16:creationId xmlns:a16="http://schemas.microsoft.com/office/drawing/2014/main" id="{1B365163-7EDD-6E36-BC4F-5C4D94BC1CD8}"/>
              </a:ext>
            </a:extLst>
          </p:cNvPr>
          <p:cNvSpPr txBox="1"/>
          <p:nvPr/>
        </p:nvSpPr>
        <p:spPr>
          <a:xfrm>
            <a:off x="6682070" y="2304987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5" name="Lige pilforbindelse 26">
            <a:extLst>
              <a:ext uri="{FF2B5EF4-FFF2-40B4-BE49-F238E27FC236}">
                <a16:creationId xmlns:a16="http://schemas.microsoft.com/office/drawing/2014/main" id="{11DE9588-7868-4989-ECE4-0AC84E9453A2}"/>
              </a:ext>
            </a:extLst>
          </p:cNvPr>
          <p:cNvCxnSpPr>
            <a:cxnSpLocks/>
            <a:endCxn id="13" idx="6"/>
          </p:cNvCxnSpPr>
          <p:nvPr/>
        </p:nvCxnSpPr>
        <p:spPr>
          <a:xfrm flipH="1" flipV="1">
            <a:off x="5435412" y="2172987"/>
            <a:ext cx="1428273" cy="506485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F74A5366-A794-8AD0-E59A-A1A349818CD6}"/>
              </a:ext>
            </a:extLst>
          </p:cNvPr>
          <p:cNvSpPr txBox="1"/>
          <p:nvPr/>
        </p:nvSpPr>
        <p:spPr>
          <a:xfrm>
            <a:off x="764071" y="3564062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650CCFF-3054-A69C-832B-AB04427003F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00" t="10333" r="2445" b="32106"/>
          <a:stretch/>
        </p:blipFill>
        <p:spPr>
          <a:xfrm>
            <a:off x="60412" y="3902318"/>
            <a:ext cx="4121065" cy="14317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10286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0">
            <a:extLst>
              <a:ext uri="{FF2B5EF4-FFF2-40B4-BE49-F238E27FC236}">
                <a16:creationId xmlns:a16="http://schemas.microsoft.com/office/drawing/2014/main" id="{20DAD0FC-359F-BD7E-0D2B-2232E24DC093}"/>
              </a:ext>
            </a:extLst>
          </p:cNvPr>
          <p:cNvSpPr txBox="1"/>
          <p:nvPr/>
        </p:nvSpPr>
        <p:spPr>
          <a:xfrm>
            <a:off x="4865312" y="274493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E643E89-CBE2-55A2-0F57-45E5BA4ADAF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445" t="35187" r="41344" b="12282"/>
          <a:stretch/>
        </p:blipFill>
        <p:spPr>
          <a:xfrm>
            <a:off x="1679895" y="1040234"/>
            <a:ext cx="5408801" cy="37345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2BAD76A-9035-6BED-09CD-7E4B33768724}"/>
              </a:ext>
            </a:extLst>
          </p:cNvPr>
          <p:cNvSpPr txBox="1"/>
          <p:nvPr/>
        </p:nvSpPr>
        <p:spPr>
          <a:xfrm>
            <a:off x="1979801" y="5171242"/>
            <a:ext cx="55262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VLQPLRAR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D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RR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27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ME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7" name="Rektangel 27">
            <a:extLst>
              <a:ext uri="{FF2B5EF4-FFF2-40B4-BE49-F238E27FC236}">
                <a16:creationId xmlns:a16="http://schemas.microsoft.com/office/drawing/2014/main" id="{7956D008-8F1D-5AE5-A179-6A8536A596A4}"/>
              </a:ext>
            </a:extLst>
          </p:cNvPr>
          <p:cNvSpPr/>
          <p:nvPr/>
        </p:nvSpPr>
        <p:spPr>
          <a:xfrm>
            <a:off x="5264090" y="5183008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C49B370A-A37C-A45E-2D42-93F3D59C8097}"/>
              </a:ext>
            </a:extLst>
          </p:cNvPr>
          <p:cNvSpPr txBox="1"/>
          <p:nvPr/>
        </p:nvSpPr>
        <p:spPr>
          <a:xfrm>
            <a:off x="2558092" y="4264077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27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78B892E6-7F46-5C1C-0DAA-4D2935EF1D68}"/>
              </a:ext>
            </a:extLst>
          </p:cNvPr>
          <p:cNvCxnSpPr>
            <a:cxnSpLocks/>
          </p:cNvCxnSpPr>
          <p:nvPr/>
        </p:nvCxnSpPr>
        <p:spPr>
          <a:xfrm flipV="1">
            <a:off x="3808602" y="3429000"/>
            <a:ext cx="837031" cy="83507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2B9EAEA4-DDFB-03CD-35E4-7CF3B139FD85}"/>
              </a:ext>
            </a:extLst>
          </p:cNvPr>
          <p:cNvSpPr/>
          <p:nvPr/>
        </p:nvSpPr>
        <p:spPr>
          <a:xfrm>
            <a:off x="4591524" y="3019596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CD3DC53A-B32A-B147-0F11-13B19C2232BA}"/>
              </a:ext>
            </a:extLst>
          </p:cNvPr>
          <p:cNvSpPr/>
          <p:nvPr/>
        </p:nvSpPr>
        <p:spPr>
          <a:xfrm>
            <a:off x="4804191" y="2713224"/>
            <a:ext cx="1512719" cy="885559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D1EF6FF2-FF2F-2670-D738-5CBEF4A9C726}"/>
              </a:ext>
            </a:extLst>
          </p:cNvPr>
          <p:cNvSpPr txBox="1"/>
          <p:nvPr/>
        </p:nvSpPr>
        <p:spPr>
          <a:xfrm>
            <a:off x="6961978" y="3224298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495ED045-C7F1-BD31-7FF9-AEDAA454CDA6}"/>
              </a:ext>
            </a:extLst>
          </p:cNvPr>
          <p:cNvCxnSpPr>
            <a:cxnSpLocks/>
          </p:cNvCxnSpPr>
          <p:nvPr/>
        </p:nvCxnSpPr>
        <p:spPr>
          <a:xfrm flipH="1" flipV="1">
            <a:off x="6316910" y="3296873"/>
            <a:ext cx="826683" cy="301910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08983849-8682-6846-2634-8794420D3D1B}"/>
              </a:ext>
            </a:extLst>
          </p:cNvPr>
          <p:cNvSpPr txBox="1"/>
          <p:nvPr/>
        </p:nvSpPr>
        <p:spPr>
          <a:xfrm>
            <a:off x="890589" y="429405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4FFB588-FCAA-8314-0961-505123886A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78" t="9849" r="2111" b="38591"/>
          <a:stretch/>
        </p:blipFill>
        <p:spPr>
          <a:xfrm>
            <a:off x="173563" y="739223"/>
            <a:ext cx="4210732" cy="1302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896339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FB60F4E-52C5-1332-D97A-DF02DA92F81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425" t="32528" r="40136" b="14321"/>
          <a:stretch/>
        </p:blipFill>
        <p:spPr>
          <a:xfrm>
            <a:off x="3492098" y="608194"/>
            <a:ext cx="5545124" cy="4153103"/>
          </a:xfrm>
          <a:prstGeom prst="rect">
            <a:avLst/>
          </a:prstGeom>
        </p:spPr>
      </p:pic>
      <p:sp>
        <p:nvSpPr>
          <p:cNvPr id="2" name="TextBox 10">
            <a:extLst>
              <a:ext uri="{FF2B5EF4-FFF2-40B4-BE49-F238E27FC236}">
                <a16:creationId xmlns:a16="http://schemas.microsoft.com/office/drawing/2014/main" id="{EAE126DD-39BF-1FA6-A2DC-31A8AE2310CD}"/>
              </a:ext>
            </a:extLst>
          </p:cNvPr>
          <p:cNvSpPr txBox="1"/>
          <p:nvPr/>
        </p:nvSpPr>
        <p:spPr>
          <a:xfrm>
            <a:off x="4123152" y="320594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124629C-24A1-B437-AC89-779715BC8B3D}"/>
              </a:ext>
            </a:extLst>
          </p:cNvPr>
          <p:cNvSpPr txBox="1"/>
          <p:nvPr/>
        </p:nvSpPr>
        <p:spPr>
          <a:xfrm>
            <a:off x="2124512" y="5721184"/>
            <a:ext cx="51403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S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RKPLRSL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S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AR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Q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6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WTG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</a:t>
            </a:r>
            <a:endParaRPr lang="da-DK" dirty="0"/>
          </a:p>
        </p:txBody>
      </p:sp>
      <p:sp>
        <p:nvSpPr>
          <p:cNvPr id="7" name="Rektangel 27">
            <a:extLst>
              <a:ext uri="{FF2B5EF4-FFF2-40B4-BE49-F238E27FC236}">
                <a16:creationId xmlns:a16="http://schemas.microsoft.com/office/drawing/2014/main" id="{EAFCA3BA-7166-BD4E-534C-281D40298F41}"/>
              </a:ext>
            </a:extLst>
          </p:cNvPr>
          <p:cNvSpPr/>
          <p:nvPr/>
        </p:nvSpPr>
        <p:spPr>
          <a:xfrm>
            <a:off x="5226341" y="5742049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520D5732-5B54-4A89-3918-6048734BD06F}"/>
              </a:ext>
            </a:extLst>
          </p:cNvPr>
          <p:cNvSpPr txBox="1"/>
          <p:nvPr/>
        </p:nvSpPr>
        <p:spPr>
          <a:xfrm>
            <a:off x="3161643" y="3590057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456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6B6A4990-F7DA-330E-232B-F821DB9E5EFE}"/>
              </a:ext>
            </a:extLst>
          </p:cNvPr>
          <p:cNvCxnSpPr>
            <a:cxnSpLocks/>
            <a:endCxn id="10" idx="3"/>
          </p:cNvCxnSpPr>
          <p:nvPr/>
        </p:nvCxnSpPr>
        <p:spPr>
          <a:xfrm flipV="1">
            <a:off x="4669800" y="3012448"/>
            <a:ext cx="996704" cy="59391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35315BF9-F19C-883B-69FD-27FE38DA1FCE}"/>
              </a:ext>
            </a:extLst>
          </p:cNvPr>
          <p:cNvSpPr/>
          <p:nvPr/>
        </p:nvSpPr>
        <p:spPr>
          <a:xfrm>
            <a:off x="5604215" y="2663000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E4807AE4-E3EC-EDAE-52B1-5EB803D61E81}"/>
              </a:ext>
            </a:extLst>
          </p:cNvPr>
          <p:cNvSpPr/>
          <p:nvPr/>
        </p:nvSpPr>
        <p:spPr>
          <a:xfrm rot="1192465">
            <a:off x="5693438" y="2843070"/>
            <a:ext cx="1512719" cy="885559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59CB36AB-7D5E-9B3B-3A5E-C2E235CFF99F}"/>
              </a:ext>
            </a:extLst>
          </p:cNvPr>
          <p:cNvSpPr txBox="1"/>
          <p:nvPr/>
        </p:nvSpPr>
        <p:spPr>
          <a:xfrm>
            <a:off x="6399271" y="4457653"/>
            <a:ext cx="25324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6976A951-376B-1A4B-3D17-11C0C72B2EDA}"/>
              </a:ext>
            </a:extLst>
          </p:cNvPr>
          <p:cNvCxnSpPr>
            <a:cxnSpLocks/>
          </p:cNvCxnSpPr>
          <p:nvPr/>
        </p:nvCxnSpPr>
        <p:spPr>
          <a:xfrm flipH="1" flipV="1">
            <a:off x="6850580" y="3768690"/>
            <a:ext cx="620054" cy="669442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kstfelt 17">
            <a:extLst>
              <a:ext uri="{FF2B5EF4-FFF2-40B4-BE49-F238E27FC236}">
                <a16:creationId xmlns:a16="http://schemas.microsoft.com/office/drawing/2014/main" id="{182A6FFD-F66B-43CB-059C-68E4AFB1F6A8}"/>
              </a:ext>
            </a:extLst>
          </p:cNvPr>
          <p:cNvSpPr txBox="1"/>
          <p:nvPr/>
        </p:nvSpPr>
        <p:spPr>
          <a:xfrm>
            <a:off x="3934942" y="4081849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/>
              <a:t>C</a:t>
            </a:r>
            <a:r>
              <a:rPr lang="da-DK" sz="1200" baseline="-25000" dirty="0"/>
              <a:t>590, 592, 596</a:t>
            </a:r>
            <a:endParaRPr lang="da-DK" sz="1200" dirty="0"/>
          </a:p>
        </p:txBody>
      </p:sp>
      <p:sp>
        <p:nvSpPr>
          <p:cNvPr id="18" name="Left Brace 17">
            <a:extLst>
              <a:ext uri="{FF2B5EF4-FFF2-40B4-BE49-F238E27FC236}">
                <a16:creationId xmlns:a16="http://schemas.microsoft.com/office/drawing/2014/main" id="{3DB5648C-CD35-2ACD-8668-55E5AFD8CCE4}"/>
              </a:ext>
            </a:extLst>
          </p:cNvPr>
          <p:cNvSpPr/>
          <p:nvPr/>
        </p:nvSpPr>
        <p:spPr>
          <a:xfrm>
            <a:off x="4746777" y="3975699"/>
            <a:ext cx="189314" cy="462433"/>
          </a:xfrm>
          <a:prstGeom prst="lef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50CAD26-91D0-5FDA-FEBB-BEBE983B72FB}"/>
              </a:ext>
            </a:extLst>
          </p:cNvPr>
          <p:cNvSpPr txBox="1"/>
          <p:nvPr/>
        </p:nvSpPr>
        <p:spPr>
          <a:xfrm>
            <a:off x="540069" y="431446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E811A99-CA34-905F-2712-C244FE68925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12" t="9696" r="1555" b="8134"/>
          <a:stretch/>
        </p:blipFill>
        <p:spPr>
          <a:xfrm>
            <a:off x="68894" y="767484"/>
            <a:ext cx="3628241" cy="1785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415453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0">
            <a:extLst>
              <a:ext uri="{FF2B5EF4-FFF2-40B4-BE49-F238E27FC236}">
                <a16:creationId xmlns:a16="http://schemas.microsoft.com/office/drawing/2014/main" id="{B243D229-5FCA-372B-0E52-21FB699B1DC4}"/>
              </a:ext>
            </a:extLst>
          </p:cNvPr>
          <p:cNvSpPr txBox="1"/>
          <p:nvPr/>
        </p:nvSpPr>
        <p:spPr>
          <a:xfrm>
            <a:off x="4257762" y="220116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2DBC8E4-C1D8-E8C3-DE3D-AC9229C51A2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240" t="32527" r="40334" b="13243"/>
          <a:stretch/>
        </p:blipFill>
        <p:spPr>
          <a:xfrm>
            <a:off x="3897993" y="646982"/>
            <a:ext cx="4482018" cy="333931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CD44A17-FDA1-7E77-8481-364090D7B41C}"/>
              </a:ext>
            </a:extLst>
          </p:cNvPr>
          <p:cNvSpPr txBox="1"/>
          <p:nvPr/>
        </p:nvSpPr>
        <p:spPr>
          <a:xfrm>
            <a:off x="4087675" y="4636463"/>
            <a:ext cx="53668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T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IFRPPRAS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Q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95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G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10" name="TextBox 25">
            <a:extLst>
              <a:ext uri="{FF2B5EF4-FFF2-40B4-BE49-F238E27FC236}">
                <a16:creationId xmlns:a16="http://schemas.microsoft.com/office/drawing/2014/main" id="{B89A58F7-F5AC-AD13-2F11-E8E73601DD67}"/>
              </a:ext>
            </a:extLst>
          </p:cNvPr>
          <p:cNvSpPr txBox="1"/>
          <p:nvPr/>
        </p:nvSpPr>
        <p:spPr>
          <a:xfrm>
            <a:off x="3477371" y="1188989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/>
              <a:t>C</a:t>
            </a:r>
            <a:r>
              <a:rPr lang="da-DK" sz="1200" baseline="-25000" dirty="0"/>
              <a:t>311</a:t>
            </a:r>
            <a:r>
              <a:rPr lang="da-DK" sz="1200" dirty="0"/>
              <a:t>C</a:t>
            </a:r>
            <a:r>
              <a:rPr lang="da-DK" sz="1200" baseline="-25000" dirty="0"/>
              <a:t>312</a:t>
            </a:r>
            <a:r>
              <a:rPr lang="da-DK" sz="1200" dirty="0"/>
              <a:t>-3x-C</a:t>
            </a:r>
            <a:r>
              <a:rPr lang="da-DK" sz="1200" baseline="-25000" dirty="0"/>
              <a:t>316</a:t>
            </a:r>
          </a:p>
        </p:txBody>
      </p:sp>
      <p:cxnSp>
        <p:nvCxnSpPr>
          <p:cNvPr id="11" name="Straight Arrow Connector 26">
            <a:extLst>
              <a:ext uri="{FF2B5EF4-FFF2-40B4-BE49-F238E27FC236}">
                <a16:creationId xmlns:a16="http://schemas.microsoft.com/office/drawing/2014/main" id="{E9CD8160-D9D2-21FA-9CC8-BC1ED88574D1}"/>
              </a:ext>
            </a:extLst>
          </p:cNvPr>
          <p:cNvCxnSpPr>
            <a:cxnSpLocks/>
          </p:cNvCxnSpPr>
          <p:nvPr/>
        </p:nvCxnSpPr>
        <p:spPr>
          <a:xfrm>
            <a:off x="4193807" y="1465988"/>
            <a:ext cx="1130438" cy="634121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32">
            <a:extLst>
              <a:ext uri="{FF2B5EF4-FFF2-40B4-BE49-F238E27FC236}">
                <a16:creationId xmlns:a16="http://schemas.microsoft.com/office/drawing/2014/main" id="{87566E33-3E02-34A7-5FD2-E070BFA06B77}"/>
              </a:ext>
            </a:extLst>
          </p:cNvPr>
          <p:cNvSpPr txBox="1"/>
          <p:nvPr/>
        </p:nvSpPr>
        <p:spPr>
          <a:xfrm>
            <a:off x="4171530" y="2618422"/>
            <a:ext cx="12153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800" dirty="0" err="1"/>
              <a:t>Helical</a:t>
            </a:r>
            <a:r>
              <a:rPr lang="da-DK" sz="800" dirty="0"/>
              <a:t> - </a:t>
            </a:r>
            <a:r>
              <a:rPr lang="da-DK" sz="800" dirty="0" err="1"/>
              <a:t>transmembrane</a:t>
            </a:r>
            <a:endParaRPr lang="da-DK" sz="800" dirty="0"/>
          </a:p>
        </p:txBody>
      </p:sp>
      <p:sp>
        <p:nvSpPr>
          <p:cNvPr id="14" name="Rektangel 27">
            <a:extLst>
              <a:ext uri="{FF2B5EF4-FFF2-40B4-BE49-F238E27FC236}">
                <a16:creationId xmlns:a16="http://schemas.microsoft.com/office/drawing/2014/main" id="{8B90F300-78B1-3787-98C1-5E66DEC9B3F6}"/>
              </a:ext>
            </a:extLst>
          </p:cNvPr>
          <p:cNvSpPr/>
          <p:nvPr/>
        </p:nvSpPr>
        <p:spPr>
          <a:xfrm>
            <a:off x="7233511" y="4646895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415D3C28-6163-BCAD-2A65-2C2133D7C5F9}"/>
              </a:ext>
            </a:extLst>
          </p:cNvPr>
          <p:cNvSpPr/>
          <p:nvPr/>
        </p:nvSpPr>
        <p:spPr>
          <a:xfrm>
            <a:off x="5349412" y="1975986"/>
            <a:ext cx="251670" cy="550411"/>
          </a:xfrm>
          <a:prstGeom prst="ellipse">
            <a:avLst/>
          </a:prstGeom>
          <a:noFill/>
          <a:ln w="28575"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A1503782-F831-96D4-DC03-C591C17ADB6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240" t="34219" r="44171" b="17599"/>
          <a:stretch/>
        </p:blipFill>
        <p:spPr>
          <a:xfrm>
            <a:off x="1154044" y="1152115"/>
            <a:ext cx="2246888" cy="1647742"/>
          </a:xfrm>
          <a:prstGeom prst="rect">
            <a:avLst/>
          </a:prstGeom>
        </p:spPr>
      </p:pic>
      <p:sp>
        <p:nvSpPr>
          <p:cNvPr id="19" name="Oval 18">
            <a:extLst>
              <a:ext uri="{FF2B5EF4-FFF2-40B4-BE49-F238E27FC236}">
                <a16:creationId xmlns:a16="http://schemas.microsoft.com/office/drawing/2014/main" id="{DB31EB5B-3A24-127F-A28B-6D87D2B15DDE}"/>
              </a:ext>
            </a:extLst>
          </p:cNvPr>
          <p:cNvSpPr/>
          <p:nvPr/>
        </p:nvSpPr>
        <p:spPr>
          <a:xfrm>
            <a:off x="1953269" y="1781327"/>
            <a:ext cx="251670" cy="318782"/>
          </a:xfrm>
          <a:prstGeom prst="ellipse">
            <a:avLst/>
          </a:prstGeom>
          <a:noFill/>
          <a:ln w="28575"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cxnSp>
        <p:nvCxnSpPr>
          <p:cNvPr id="20" name="Straight Arrow Connector 26">
            <a:extLst>
              <a:ext uri="{FF2B5EF4-FFF2-40B4-BE49-F238E27FC236}">
                <a16:creationId xmlns:a16="http://schemas.microsoft.com/office/drawing/2014/main" id="{230E94D0-0B3A-DCBE-C9EC-6E7AC498E299}"/>
              </a:ext>
            </a:extLst>
          </p:cNvPr>
          <p:cNvCxnSpPr>
            <a:cxnSpLocks/>
          </p:cNvCxnSpPr>
          <p:nvPr/>
        </p:nvCxnSpPr>
        <p:spPr>
          <a:xfrm flipH="1">
            <a:off x="2204939" y="1465988"/>
            <a:ext cx="1338779" cy="398931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kstfelt 17">
            <a:extLst>
              <a:ext uri="{FF2B5EF4-FFF2-40B4-BE49-F238E27FC236}">
                <a16:creationId xmlns:a16="http://schemas.microsoft.com/office/drawing/2014/main" id="{516506BE-CF3F-7B15-D78D-4FD0B31B425E}"/>
              </a:ext>
            </a:extLst>
          </p:cNvPr>
          <p:cNvSpPr txBox="1"/>
          <p:nvPr/>
        </p:nvSpPr>
        <p:spPr>
          <a:xfrm>
            <a:off x="3543718" y="3328003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95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26" name="Lige pilforbindelse 19">
            <a:extLst>
              <a:ext uri="{FF2B5EF4-FFF2-40B4-BE49-F238E27FC236}">
                <a16:creationId xmlns:a16="http://schemas.microsoft.com/office/drawing/2014/main" id="{7BF162B4-298C-8B84-509F-41C8559195A5}"/>
              </a:ext>
            </a:extLst>
          </p:cNvPr>
          <p:cNvCxnSpPr>
            <a:cxnSpLocks/>
          </p:cNvCxnSpPr>
          <p:nvPr/>
        </p:nvCxnSpPr>
        <p:spPr>
          <a:xfrm flipV="1">
            <a:off x="4764051" y="2481827"/>
            <a:ext cx="837031" cy="83507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Ellipse 20">
            <a:extLst>
              <a:ext uri="{FF2B5EF4-FFF2-40B4-BE49-F238E27FC236}">
                <a16:creationId xmlns:a16="http://schemas.microsoft.com/office/drawing/2014/main" id="{6709CBC2-5070-525F-F903-92CBF72FA0E0}"/>
              </a:ext>
            </a:extLst>
          </p:cNvPr>
          <p:cNvSpPr/>
          <p:nvPr/>
        </p:nvSpPr>
        <p:spPr>
          <a:xfrm>
            <a:off x="5546973" y="2072423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8" name="Ellipse 23">
            <a:extLst>
              <a:ext uri="{FF2B5EF4-FFF2-40B4-BE49-F238E27FC236}">
                <a16:creationId xmlns:a16="http://schemas.microsoft.com/office/drawing/2014/main" id="{1CB784D1-0A0A-C79A-F52E-D19DF077DC82}"/>
              </a:ext>
            </a:extLst>
          </p:cNvPr>
          <p:cNvSpPr/>
          <p:nvPr/>
        </p:nvSpPr>
        <p:spPr>
          <a:xfrm>
            <a:off x="5759641" y="1766051"/>
            <a:ext cx="707500" cy="885559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9" name="Tekstfelt 24">
            <a:extLst>
              <a:ext uri="{FF2B5EF4-FFF2-40B4-BE49-F238E27FC236}">
                <a16:creationId xmlns:a16="http://schemas.microsoft.com/office/drawing/2014/main" id="{0C40DD3D-54DC-F912-3954-36A9E9C6F411}"/>
              </a:ext>
            </a:extLst>
          </p:cNvPr>
          <p:cNvSpPr txBox="1"/>
          <p:nvPr/>
        </p:nvSpPr>
        <p:spPr>
          <a:xfrm>
            <a:off x="7496708" y="1766051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30" name="Lige pilforbindelse 26">
            <a:extLst>
              <a:ext uri="{FF2B5EF4-FFF2-40B4-BE49-F238E27FC236}">
                <a16:creationId xmlns:a16="http://schemas.microsoft.com/office/drawing/2014/main" id="{2256032D-89DF-3C6A-4C6E-3E98DDA15FE2}"/>
              </a:ext>
            </a:extLst>
          </p:cNvPr>
          <p:cNvCxnSpPr>
            <a:cxnSpLocks/>
          </p:cNvCxnSpPr>
          <p:nvPr/>
        </p:nvCxnSpPr>
        <p:spPr>
          <a:xfrm flipH="1">
            <a:off x="6515401" y="2277125"/>
            <a:ext cx="1220591" cy="39516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BD185690-16EE-2D85-228D-E6DD21C22EA2}"/>
              </a:ext>
            </a:extLst>
          </p:cNvPr>
          <p:cNvSpPr txBox="1"/>
          <p:nvPr/>
        </p:nvSpPr>
        <p:spPr>
          <a:xfrm>
            <a:off x="857963" y="3904255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5E4D7FD-509A-13E6-F007-43021E88916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84" t="9666" r="2080" b="27005"/>
          <a:stretch/>
        </p:blipFill>
        <p:spPr>
          <a:xfrm>
            <a:off x="73930" y="4252600"/>
            <a:ext cx="3968660" cy="1506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835984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10">
            <a:extLst>
              <a:ext uri="{FF2B5EF4-FFF2-40B4-BE49-F238E27FC236}">
                <a16:creationId xmlns:a16="http://schemas.microsoft.com/office/drawing/2014/main" id="{F2EB788B-5140-3120-B628-F81D5A9C9FFF}"/>
              </a:ext>
            </a:extLst>
          </p:cNvPr>
          <p:cNvSpPr txBox="1"/>
          <p:nvPr/>
        </p:nvSpPr>
        <p:spPr>
          <a:xfrm>
            <a:off x="4257762" y="296342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5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C323BBC-7B7B-5107-F948-4DD4A85B84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292" t="28307" r="41561" b="6185"/>
          <a:stretch/>
        </p:blipFill>
        <p:spPr>
          <a:xfrm>
            <a:off x="3020107" y="797575"/>
            <a:ext cx="4455253" cy="3937602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180B4BA0-EF20-8417-EAC4-FF7DD4C1B775}"/>
              </a:ext>
            </a:extLst>
          </p:cNvPr>
          <p:cNvSpPr txBox="1"/>
          <p:nvPr/>
        </p:nvSpPr>
        <p:spPr>
          <a:xfrm>
            <a:off x="2212419" y="5711958"/>
            <a:ext cx="54004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LIKPD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LKM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9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</a:t>
            </a:r>
            <a:endParaRPr lang="da-DK" dirty="0"/>
          </a:p>
        </p:txBody>
      </p:sp>
      <p:sp>
        <p:nvSpPr>
          <p:cNvPr id="14" name="Rektangel 27">
            <a:extLst>
              <a:ext uri="{FF2B5EF4-FFF2-40B4-BE49-F238E27FC236}">
                <a16:creationId xmlns:a16="http://schemas.microsoft.com/office/drawing/2014/main" id="{C7107D6C-1C8F-42BA-62C5-19FA2256B386}"/>
              </a:ext>
            </a:extLst>
          </p:cNvPr>
          <p:cNvSpPr/>
          <p:nvPr/>
        </p:nvSpPr>
        <p:spPr>
          <a:xfrm>
            <a:off x="5577436" y="5711958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5" name="Tekstfelt 17">
            <a:extLst>
              <a:ext uri="{FF2B5EF4-FFF2-40B4-BE49-F238E27FC236}">
                <a16:creationId xmlns:a16="http://schemas.microsoft.com/office/drawing/2014/main" id="{AD69251D-B4CA-6A43-B1B8-3D474D9BCB7E}"/>
              </a:ext>
            </a:extLst>
          </p:cNvPr>
          <p:cNvSpPr txBox="1"/>
          <p:nvPr/>
        </p:nvSpPr>
        <p:spPr>
          <a:xfrm>
            <a:off x="5898835" y="3929508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59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6" name="Lige pilforbindelse 19">
            <a:extLst>
              <a:ext uri="{FF2B5EF4-FFF2-40B4-BE49-F238E27FC236}">
                <a16:creationId xmlns:a16="http://schemas.microsoft.com/office/drawing/2014/main" id="{9268F066-858D-0F4F-66FE-EADB7A330872}"/>
              </a:ext>
            </a:extLst>
          </p:cNvPr>
          <p:cNvCxnSpPr>
            <a:cxnSpLocks/>
            <a:endCxn id="17" idx="5"/>
          </p:cNvCxnSpPr>
          <p:nvPr/>
        </p:nvCxnSpPr>
        <p:spPr>
          <a:xfrm flipH="1" flipV="1">
            <a:off x="5819406" y="3090825"/>
            <a:ext cx="544858" cy="81836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Ellipse 20">
            <a:extLst>
              <a:ext uri="{FF2B5EF4-FFF2-40B4-BE49-F238E27FC236}">
                <a16:creationId xmlns:a16="http://schemas.microsoft.com/office/drawing/2014/main" id="{3210DBCB-7766-B5C8-1684-BA232F567217}"/>
              </a:ext>
            </a:extLst>
          </p:cNvPr>
          <p:cNvSpPr/>
          <p:nvPr/>
        </p:nvSpPr>
        <p:spPr>
          <a:xfrm>
            <a:off x="5456360" y="2741377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8" name="Ellipse 23">
            <a:extLst>
              <a:ext uri="{FF2B5EF4-FFF2-40B4-BE49-F238E27FC236}">
                <a16:creationId xmlns:a16="http://schemas.microsoft.com/office/drawing/2014/main" id="{54E7A156-D062-BEDC-1A59-672AA88D567B}"/>
              </a:ext>
            </a:extLst>
          </p:cNvPr>
          <p:cNvSpPr/>
          <p:nvPr/>
        </p:nvSpPr>
        <p:spPr>
          <a:xfrm rot="19533570">
            <a:off x="5347493" y="1978354"/>
            <a:ext cx="1311705" cy="923406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9" name="Tekstfelt 24">
            <a:extLst>
              <a:ext uri="{FF2B5EF4-FFF2-40B4-BE49-F238E27FC236}">
                <a16:creationId xmlns:a16="http://schemas.microsoft.com/office/drawing/2014/main" id="{ED0B1175-A6D4-2B21-0704-5008A5CFBAAA}"/>
              </a:ext>
            </a:extLst>
          </p:cNvPr>
          <p:cNvSpPr txBox="1"/>
          <p:nvPr/>
        </p:nvSpPr>
        <p:spPr>
          <a:xfrm>
            <a:off x="7491397" y="2063533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20" name="Lige pilforbindelse 26">
            <a:extLst>
              <a:ext uri="{FF2B5EF4-FFF2-40B4-BE49-F238E27FC236}">
                <a16:creationId xmlns:a16="http://schemas.microsoft.com/office/drawing/2014/main" id="{00EA1D81-FD54-B88D-4CDC-8E03B784FC1D}"/>
              </a:ext>
            </a:extLst>
          </p:cNvPr>
          <p:cNvCxnSpPr>
            <a:cxnSpLocks/>
            <a:endCxn id="18" idx="5"/>
          </p:cNvCxnSpPr>
          <p:nvPr/>
        </p:nvCxnSpPr>
        <p:spPr>
          <a:xfrm flipH="1" flipV="1">
            <a:off x="6570450" y="2447026"/>
            <a:ext cx="1034365" cy="20316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kstfelt 17">
            <a:extLst>
              <a:ext uri="{FF2B5EF4-FFF2-40B4-BE49-F238E27FC236}">
                <a16:creationId xmlns:a16="http://schemas.microsoft.com/office/drawing/2014/main" id="{A59031DA-5C90-F75F-1425-FB97599DD137}"/>
              </a:ext>
            </a:extLst>
          </p:cNvPr>
          <p:cNvSpPr txBox="1"/>
          <p:nvPr/>
        </p:nvSpPr>
        <p:spPr>
          <a:xfrm>
            <a:off x="6244852" y="3407045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/>
              <a:t>C</a:t>
            </a:r>
            <a:r>
              <a:rPr lang="da-DK" sz="1200" baseline="-25000" dirty="0"/>
              <a:t>15, 16</a:t>
            </a:r>
            <a:endParaRPr lang="da-DK" sz="1200" dirty="0"/>
          </a:p>
        </p:txBody>
      </p:sp>
      <p:sp>
        <p:nvSpPr>
          <p:cNvPr id="27" name="Left Brace 26">
            <a:extLst>
              <a:ext uri="{FF2B5EF4-FFF2-40B4-BE49-F238E27FC236}">
                <a16:creationId xmlns:a16="http://schemas.microsoft.com/office/drawing/2014/main" id="{FFDFE05B-2480-55FC-15FB-21BB782B12D5}"/>
              </a:ext>
            </a:extLst>
          </p:cNvPr>
          <p:cNvSpPr/>
          <p:nvPr/>
        </p:nvSpPr>
        <p:spPr>
          <a:xfrm rot="15276003">
            <a:off x="6322605" y="3202912"/>
            <a:ext cx="126408" cy="348214"/>
          </a:xfrm>
          <a:prstGeom prst="lef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BA0C752-20BD-5136-A2AC-6D6ADAA80047}"/>
              </a:ext>
            </a:extLst>
          </p:cNvPr>
          <p:cNvSpPr txBox="1"/>
          <p:nvPr/>
        </p:nvSpPr>
        <p:spPr>
          <a:xfrm>
            <a:off x="928689" y="534297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F36E88F-3342-B462-9C8E-816ADA4CDF5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22" t="9443" r="2333" b="33361"/>
          <a:stretch/>
        </p:blipFill>
        <p:spPr>
          <a:xfrm>
            <a:off x="204549" y="871124"/>
            <a:ext cx="4015740" cy="13879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90158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C14647F-257E-7DE8-D7CD-177D6DE5288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996" t="33029" r="43064" b="6200"/>
          <a:stretch/>
        </p:blipFill>
        <p:spPr>
          <a:xfrm>
            <a:off x="2940663" y="565626"/>
            <a:ext cx="4882393" cy="4471725"/>
          </a:xfrm>
          <a:prstGeom prst="rect">
            <a:avLst/>
          </a:prstGeom>
        </p:spPr>
      </p:pic>
      <p:sp>
        <p:nvSpPr>
          <p:cNvPr id="4" name="TextBox 10">
            <a:extLst>
              <a:ext uri="{FF2B5EF4-FFF2-40B4-BE49-F238E27FC236}">
                <a16:creationId xmlns:a16="http://schemas.microsoft.com/office/drawing/2014/main" id="{2B74B953-23C0-D591-AD8D-F41CE30CD5A3}"/>
              </a:ext>
            </a:extLst>
          </p:cNvPr>
          <p:cNvSpPr txBox="1"/>
          <p:nvPr/>
        </p:nvSpPr>
        <p:spPr>
          <a:xfrm>
            <a:off x="4257762" y="279780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6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D605DF5-DDFE-3B5C-A114-98B84E6372C1}"/>
              </a:ext>
            </a:extLst>
          </p:cNvPr>
          <p:cNvSpPr txBox="1"/>
          <p:nvPr/>
        </p:nvSpPr>
        <p:spPr>
          <a:xfrm>
            <a:off x="2147583" y="5725487"/>
            <a:ext cx="52598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YPKPARTH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LKM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85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L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7" name="Rektangel 27">
            <a:extLst>
              <a:ext uri="{FF2B5EF4-FFF2-40B4-BE49-F238E27FC236}">
                <a16:creationId xmlns:a16="http://schemas.microsoft.com/office/drawing/2014/main" id="{6075EE7B-9287-BBC5-1ABE-6A91539C298B}"/>
              </a:ext>
            </a:extLst>
          </p:cNvPr>
          <p:cNvSpPr/>
          <p:nvPr/>
        </p:nvSpPr>
        <p:spPr>
          <a:xfrm>
            <a:off x="5268286" y="5729574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FEC2946D-9DE9-D75A-087F-60DB98B06F6E}"/>
              </a:ext>
            </a:extLst>
          </p:cNvPr>
          <p:cNvSpPr txBox="1"/>
          <p:nvPr/>
        </p:nvSpPr>
        <p:spPr>
          <a:xfrm>
            <a:off x="6749605" y="4005538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85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307F6634-FA14-34EC-1FBE-94FCFB2748AC}"/>
              </a:ext>
            </a:extLst>
          </p:cNvPr>
          <p:cNvCxnSpPr>
            <a:cxnSpLocks/>
            <a:endCxn id="10" idx="5"/>
          </p:cNvCxnSpPr>
          <p:nvPr/>
        </p:nvCxnSpPr>
        <p:spPr>
          <a:xfrm flipH="1" flipV="1">
            <a:off x="5565348" y="2863627"/>
            <a:ext cx="1268226" cy="1153934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79213F83-48F6-3F4C-DDAE-3CF09F1842C9}"/>
              </a:ext>
            </a:extLst>
          </p:cNvPr>
          <p:cNvSpPr/>
          <p:nvPr/>
        </p:nvSpPr>
        <p:spPr>
          <a:xfrm>
            <a:off x="5202302" y="2514179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3D03EAFC-1DDA-C7F0-7BC8-3D3EA00C4F69}"/>
              </a:ext>
            </a:extLst>
          </p:cNvPr>
          <p:cNvSpPr/>
          <p:nvPr/>
        </p:nvSpPr>
        <p:spPr>
          <a:xfrm>
            <a:off x="5437900" y="2166039"/>
            <a:ext cx="1311705" cy="923406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309EC0DE-9B5B-7517-299E-5F0E081FF72E}"/>
              </a:ext>
            </a:extLst>
          </p:cNvPr>
          <p:cNvSpPr txBox="1"/>
          <p:nvPr/>
        </p:nvSpPr>
        <p:spPr>
          <a:xfrm>
            <a:off x="7602595" y="2341913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105650EF-2383-A081-8086-E2DBF2B570E1}"/>
              </a:ext>
            </a:extLst>
          </p:cNvPr>
          <p:cNvCxnSpPr>
            <a:cxnSpLocks/>
          </p:cNvCxnSpPr>
          <p:nvPr/>
        </p:nvCxnSpPr>
        <p:spPr>
          <a:xfrm flipH="1" flipV="1">
            <a:off x="6776014" y="2618460"/>
            <a:ext cx="1047042" cy="183029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C59F83CA-9C21-E903-9D81-64E871E9ABDB}"/>
              </a:ext>
            </a:extLst>
          </p:cNvPr>
          <p:cNvSpPr txBox="1"/>
          <p:nvPr/>
        </p:nvSpPr>
        <p:spPr>
          <a:xfrm>
            <a:off x="749619" y="520854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9BAAD9E-8E80-6B6E-35F9-A73103E687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23" t="9124" r="2111" b="32918"/>
          <a:stretch/>
        </p:blipFill>
        <p:spPr>
          <a:xfrm>
            <a:off x="262716" y="873403"/>
            <a:ext cx="3640455" cy="1272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61214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D9DE7A0-0EC9-B211-0694-3CC40BBC4D2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018" t="30497" r="42488" b="10957"/>
          <a:stretch/>
        </p:blipFill>
        <p:spPr>
          <a:xfrm>
            <a:off x="3345128" y="996318"/>
            <a:ext cx="5173909" cy="4622692"/>
          </a:xfrm>
          <a:prstGeom prst="rect">
            <a:avLst/>
          </a:prstGeom>
        </p:spPr>
      </p:pic>
      <p:sp>
        <p:nvSpPr>
          <p:cNvPr id="2" name="TextBox 10">
            <a:extLst>
              <a:ext uri="{FF2B5EF4-FFF2-40B4-BE49-F238E27FC236}">
                <a16:creationId xmlns:a16="http://schemas.microsoft.com/office/drawing/2014/main" id="{26ED15C2-060E-778D-0492-2CF329517053}"/>
              </a:ext>
            </a:extLst>
          </p:cNvPr>
          <p:cNvSpPr txBox="1"/>
          <p:nvPr/>
        </p:nvSpPr>
        <p:spPr>
          <a:xfrm>
            <a:off x="4257762" y="277117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EED48EC-FA1A-C4EA-4217-0CC375E38285}"/>
              </a:ext>
            </a:extLst>
          </p:cNvPr>
          <p:cNvSpPr txBox="1"/>
          <p:nvPr/>
        </p:nvSpPr>
        <p:spPr>
          <a:xfrm>
            <a:off x="2195486" y="5784213"/>
            <a:ext cx="51739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RKPVRSK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K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67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G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7" name="Rektangel 27">
            <a:extLst>
              <a:ext uri="{FF2B5EF4-FFF2-40B4-BE49-F238E27FC236}">
                <a16:creationId xmlns:a16="http://schemas.microsoft.com/office/drawing/2014/main" id="{50F25EE7-00C8-9429-79D8-16F0621A731F}"/>
              </a:ext>
            </a:extLst>
          </p:cNvPr>
          <p:cNvSpPr/>
          <p:nvPr/>
        </p:nvSpPr>
        <p:spPr>
          <a:xfrm>
            <a:off x="5305704" y="5796797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9BCD36FA-85B9-439E-D568-8B1CB55B2B6C}"/>
              </a:ext>
            </a:extLst>
          </p:cNvPr>
          <p:cNvSpPr txBox="1"/>
          <p:nvPr/>
        </p:nvSpPr>
        <p:spPr>
          <a:xfrm>
            <a:off x="3468996" y="3996989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467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3CDAC6BC-6AF0-A5BF-6C42-7102F1204342}"/>
              </a:ext>
            </a:extLst>
          </p:cNvPr>
          <p:cNvCxnSpPr>
            <a:cxnSpLocks/>
            <a:stCxn id="8" idx="0"/>
          </p:cNvCxnSpPr>
          <p:nvPr/>
        </p:nvCxnSpPr>
        <p:spPr>
          <a:xfrm flipV="1">
            <a:off x="4321986" y="2902928"/>
            <a:ext cx="1106867" cy="109406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732211E1-9573-5008-16E0-121B81C50A55}"/>
              </a:ext>
            </a:extLst>
          </p:cNvPr>
          <p:cNvSpPr/>
          <p:nvPr/>
        </p:nvSpPr>
        <p:spPr>
          <a:xfrm>
            <a:off x="5310845" y="2493524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82A1520E-BA6D-C619-BFB9-50D34BA3BFB7}"/>
              </a:ext>
            </a:extLst>
          </p:cNvPr>
          <p:cNvSpPr/>
          <p:nvPr/>
        </p:nvSpPr>
        <p:spPr>
          <a:xfrm>
            <a:off x="5546444" y="2321258"/>
            <a:ext cx="1106868" cy="747532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116FDF4A-FBAE-363C-6068-790CF98153A2}"/>
              </a:ext>
            </a:extLst>
          </p:cNvPr>
          <p:cNvSpPr txBox="1"/>
          <p:nvPr/>
        </p:nvSpPr>
        <p:spPr>
          <a:xfrm>
            <a:off x="7965016" y="3449958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2B90C7AF-C7E4-8989-8B14-03B544D83040}"/>
              </a:ext>
            </a:extLst>
          </p:cNvPr>
          <p:cNvCxnSpPr>
            <a:cxnSpLocks/>
          </p:cNvCxnSpPr>
          <p:nvPr/>
        </p:nvCxnSpPr>
        <p:spPr>
          <a:xfrm flipH="1" flipV="1">
            <a:off x="6569995" y="2860023"/>
            <a:ext cx="1598802" cy="925389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Left Brace 17">
            <a:extLst>
              <a:ext uri="{FF2B5EF4-FFF2-40B4-BE49-F238E27FC236}">
                <a16:creationId xmlns:a16="http://schemas.microsoft.com/office/drawing/2014/main" id="{4D98FF19-5CEF-F53A-11A1-F0155301C2F0}"/>
              </a:ext>
            </a:extLst>
          </p:cNvPr>
          <p:cNvSpPr/>
          <p:nvPr/>
        </p:nvSpPr>
        <p:spPr>
          <a:xfrm>
            <a:off x="5428853" y="1293913"/>
            <a:ext cx="135869" cy="304911"/>
          </a:xfrm>
          <a:prstGeom prst="leftBrac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9" name="Tekstfelt 17">
            <a:extLst>
              <a:ext uri="{FF2B5EF4-FFF2-40B4-BE49-F238E27FC236}">
                <a16:creationId xmlns:a16="http://schemas.microsoft.com/office/drawing/2014/main" id="{8C7EFDED-5BDF-CDA3-9787-62E663B8244B}"/>
              </a:ext>
            </a:extLst>
          </p:cNvPr>
          <p:cNvSpPr txBox="1"/>
          <p:nvPr/>
        </p:nvSpPr>
        <p:spPr>
          <a:xfrm>
            <a:off x="4875419" y="1280753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/>
              <a:t>C</a:t>
            </a:r>
            <a:r>
              <a:rPr lang="da-DK" sz="1200" baseline="-25000" dirty="0"/>
              <a:t>602,603</a:t>
            </a:r>
            <a:endParaRPr lang="da-DK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77A57F2-91F0-18DA-EF31-D5B648843260}"/>
              </a:ext>
            </a:extLst>
          </p:cNvPr>
          <p:cNvSpPr txBox="1"/>
          <p:nvPr/>
        </p:nvSpPr>
        <p:spPr>
          <a:xfrm>
            <a:off x="540069" y="431446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0F0809C-BA73-E11A-2674-1A45FDA0E0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89" t="9876" r="2222" b="8362"/>
          <a:stretch/>
        </p:blipFill>
        <p:spPr>
          <a:xfrm>
            <a:off x="142096" y="739223"/>
            <a:ext cx="3509842" cy="1735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408980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0">
            <a:extLst>
              <a:ext uri="{FF2B5EF4-FFF2-40B4-BE49-F238E27FC236}">
                <a16:creationId xmlns:a16="http://schemas.microsoft.com/office/drawing/2014/main" id="{C3478A92-4C82-08D1-6119-E21D6D199964}"/>
              </a:ext>
            </a:extLst>
          </p:cNvPr>
          <p:cNvSpPr txBox="1"/>
          <p:nvPr/>
        </p:nvSpPr>
        <p:spPr>
          <a:xfrm>
            <a:off x="4101167" y="276993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8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DC6397C-AD01-3CE8-C138-C911B24E02D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986" t="31903" r="41651" b="17793"/>
          <a:stretch/>
        </p:blipFill>
        <p:spPr>
          <a:xfrm>
            <a:off x="3465026" y="602209"/>
            <a:ext cx="4904681" cy="3483623"/>
          </a:xfrm>
          <a:prstGeom prst="rect">
            <a:avLst/>
          </a:prstGeom>
        </p:spPr>
      </p:pic>
      <p:pic>
        <p:nvPicPr>
          <p:cNvPr id="6" name="Picture 4">
            <a:extLst>
              <a:ext uri="{FF2B5EF4-FFF2-40B4-BE49-F238E27FC236}">
                <a16:creationId xmlns:a16="http://schemas.microsoft.com/office/drawing/2014/main" id="{66E02395-C02D-A64E-5436-9134A6234BA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494" t="31504" r="41144" b="19544"/>
          <a:stretch/>
        </p:blipFill>
        <p:spPr>
          <a:xfrm>
            <a:off x="480773" y="1759294"/>
            <a:ext cx="2497425" cy="146807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9EAABD6-4438-309A-E69E-0DF7EFB61AF4}"/>
              </a:ext>
            </a:extLst>
          </p:cNvPr>
          <p:cNvSpPr txBox="1"/>
          <p:nvPr/>
        </p:nvSpPr>
        <p:spPr>
          <a:xfrm>
            <a:off x="3808317" y="5562610"/>
            <a:ext cx="52976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T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MFRPPRTS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R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14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G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15" name="Rektangel 27">
            <a:extLst>
              <a:ext uri="{FF2B5EF4-FFF2-40B4-BE49-F238E27FC236}">
                <a16:creationId xmlns:a16="http://schemas.microsoft.com/office/drawing/2014/main" id="{380AF26B-8247-933A-1402-107A43443182}"/>
              </a:ext>
            </a:extLst>
          </p:cNvPr>
          <p:cNvSpPr/>
          <p:nvPr/>
        </p:nvSpPr>
        <p:spPr>
          <a:xfrm>
            <a:off x="7065307" y="5573042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cxnSp>
        <p:nvCxnSpPr>
          <p:cNvPr id="16" name="Straight Arrow Connector 26">
            <a:extLst>
              <a:ext uri="{FF2B5EF4-FFF2-40B4-BE49-F238E27FC236}">
                <a16:creationId xmlns:a16="http://schemas.microsoft.com/office/drawing/2014/main" id="{3BA08206-5F3E-5ED9-8994-2D42B70D960F}"/>
              </a:ext>
            </a:extLst>
          </p:cNvPr>
          <p:cNvCxnSpPr>
            <a:cxnSpLocks/>
          </p:cNvCxnSpPr>
          <p:nvPr/>
        </p:nvCxnSpPr>
        <p:spPr>
          <a:xfrm>
            <a:off x="4042454" y="1759294"/>
            <a:ext cx="1226137" cy="83204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Oval 16">
            <a:extLst>
              <a:ext uri="{FF2B5EF4-FFF2-40B4-BE49-F238E27FC236}">
                <a16:creationId xmlns:a16="http://schemas.microsoft.com/office/drawing/2014/main" id="{840547E2-9CC4-6CD2-F216-B748ECB32B0B}"/>
              </a:ext>
            </a:extLst>
          </p:cNvPr>
          <p:cNvSpPr/>
          <p:nvPr/>
        </p:nvSpPr>
        <p:spPr>
          <a:xfrm rot="19183541">
            <a:off x="5254992" y="1410467"/>
            <a:ext cx="429824" cy="685723"/>
          </a:xfrm>
          <a:prstGeom prst="ellipse">
            <a:avLst/>
          </a:prstGeom>
          <a:noFill/>
          <a:ln w="28575"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FADDE0D6-F1A3-105F-5D3D-DE791ADA85ED}"/>
              </a:ext>
            </a:extLst>
          </p:cNvPr>
          <p:cNvSpPr/>
          <p:nvPr/>
        </p:nvSpPr>
        <p:spPr>
          <a:xfrm>
            <a:off x="1500403" y="2191327"/>
            <a:ext cx="251670" cy="318782"/>
          </a:xfrm>
          <a:prstGeom prst="ellipse">
            <a:avLst/>
          </a:prstGeom>
          <a:noFill/>
          <a:ln w="28575"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cxnSp>
        <p:nvCxnSpPr>
          <p:cNvPr id="19" name="Straight Arrow Connector 26">
            <a:extLst>
              <a:ext uri="{FF2B5EF4-FFF2-40B4-BE49-F238E27FC236}">
                <a16:creationId xmlns:a16="http://schemas.microsoft.com/office/drawing/2014/main" id="{8E50402D-C27A-B99D-62CB-DC6168B1092B}"/>
              </a:ext>
            </a:extLst>
          </p:cNvPr>
          <p:cNvCxnSpPr>
            <a:cxnSpLocks/>
          </p:cNvCxnSpPr>
          <p:nvPr/>
        </p:nvCxnSpPr>
        <p:spPr>
          <a:xfrm flipH="1">
            <a:off x="1752073" y="1862318"/>
            <a:ext cx="1226126" cy="412601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21">
            <a:extLst>
              <a:ext uri="{FF2B5EF4-FFF2-40B4-BE49-F238E27FC236}">
                <a16:creationId xmlns:a16="http://schemas.microsoft.com/office/drawing/2014/main" id="{5B3C99DC-6F44-5CBC-9D70-F8213A150936}"/>
              </a:ext>
            </a:extLst>
          </p:cNvPr>
          <p:cNvSpPr txBox="1"/>
          <p:nvPr/>
        </p:nvSpPr>
        <p:spPr>
          <a:xfrm>
            <a:off x="2889600" y="1585319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/>
              <a:t>C</a:t>
            </a:r>
            <a:r>
              <a:rPr lang="da-DK" sz="1200" baseline="-25000" dirty="0"/>
              <a:t>331</a:t>
            </a:r>
            <a:r>
              <a:rPr lang="da-DK" sz="1200" dirty="0"/>
              <a:t>C</a:t>
            </a:r>
            <a:r>
              <a:rPr lang="da-DK" sz="1200" baseline="-25000" dirty="0"/>
              <a:t>332</a:t>
            </a:r>
            <a:r>
              <a:rPr lang="da-DK" sz="1200" dirty="0"/>
              <a:t>-4x-C</a:t>
            </a:r>
            <a:r>
              <a:rPr lang="da-DK" sz="1200" baseline="-25000" dirty="0"/>
              <a:t>336</a:t>
            </a:r>
          </a:p>
        </p:txBody>
      </p:sp>
      <p:sp>
        <p:nvSpPr>
          <p:cNvPr id="24" name="Tekstfelt 17">
            <a:extLst>
              <a:ext uri="{FF2B5EF4-FFF2-40B4-BE49-F238E27FC236}">
                <a16:creationId xmlns:a16="http://schemas.microsoft.com/office/drawing/2014/main" id="{D273EA7F-0DC7-D78E-E069-C115D5EAFF3D}"/>
              </a:ext>
            </a:extLst>
          </p:cNvPr>
          <p:cNvSpPr txBox="1"/>
          <p:nvPr/>
        </p:nvSpPr>
        <p:spPr>
          <a:xfrm>
            <a:off x="3498582" y="3766289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214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25" name="Lige pilforbindelse 19">
            <a:extLst>
              <a:ext uri="{FF2B5EF4-FFF2-40B4-BE49-F238E27FC236}">
                <a16:creationId xmlns:a16="http://schemas.microsoft.com/office/drawing/2014/main" id="{A9F59A55-144E-7207-EC33-3FCC4A39B504}"/>
              </a:ext>
            </a:extLst>
          </p:cNvPr>
          <p:cNvCxnSpPr>
            <a:cxnSpLocks/>
          </p:cNvCxnSpPr>
          <p:nvPr/>
        </p:nvCxnSpPr>
        <p:spPr>
          <a:xfrm flipV="1">
            <a:off x="4718915" y="2920113"/>
            <a:ext cx="837031" cy="83507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Ellipse 20">
            <a:extLst>
              <a:ext uri="{FF2B5EF4-FFF2-40B4-BE49-F238E27FC236}">
                <a16:creationId xmlns:a16="http://schemas.microsoft.com/office/drawing/2014/main" id="{36CF1896-4D5D-A506-16C9-66EDD5443AC4}"/>
              </a:ext>
            </a:extLst>
          </p:cNvPr>
          <p:cNvSpPr/>
          <p:nvPr/>
        </p:nvSpPr>
        <p:spPr>
          <a:xfrm>
            <a:off x="5501837" y="2510709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7" name="Ellipse 23">
            <a:extLst>
              <a:ext uri="{FF2B5EF4-FFF2-40B4-BE49-F238E27FC236}">
                <a16:creationId xmlns:a16="http://schemas.microsoft.com/office/drawing/2014/main" id="{24BAF5D4-F6F5-D41F-E5FB-3D76FDB11506}"/>
              </a:ext>
            </a:extLst>
          </p:cNvPr>
          <p:cNvSpPr/>
          <p:nvPr/>
        </p:nvSpPr>
        <p:spPr>
          <a:xfrm>
            <a:off x="5806578" y="2204337"/>
            <a:ext cx="707500" cy="885559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8" name="Tekstfelt 24">
            <a:extLst>
              <a:ext uri="{FF2B5EF4-FFF2-40B4-BE49-F238E27FC236}">
                <a16:creationId xmlns:a16="http://schemas.microsoft.com/office/drawing/2014/main" id="{D6A5CB30-CEA4-D78E-1473-D210358D48C7}"/>
              </a:ext>
            </a:extLst>
          </p:cNvPr>
          <p:cNvSpPr txBox="1"/>
          <p:nvPr/>
        </p:nvSpPr>
        <p:spPr>
          <a:xfrm>
            <a:off x="6457141" y="3614038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29" name="Lige pilforbindelse 26">
            <a:extLst>
              <a:ext uri="{FF2B5EF4-FFF2-40B4-BE49-F238E27FC236}">
                <a16:creationId xmlns:a16="http://schemas.microsoft.com/office/drawing/2014/main" id="{41A51EDB-B39F-5FC4-32F4-42EC7EC07BAD}"/>
              </a:ext>
            </a:extLst>
          </p:cNvPr>
          <p:cNvCxnSpPr>
            <a:cxnSpLocks/>
          </p:cNvCxnSpPr>
          <p:nvPr/>
        </p:nvCxnSpPr>
        <p:spPr>
          <a:xfrm flipH="1" flipV="1">
            <a:off x="6413016" y="3020037"/>
            <a:ext cx="474345" cy="594001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6FEDCAB9-4876-319B-B88B-EBCFF5588B27}"/>
              </a:ext>
            </a:extLst>
          </p:cNvPr>
          <p:cNvSpPr txBox="1"/>
          <p:nvPr/>
        </p:nvSpPr>
        <p:spPr>
          <a:xfrm>
            <a:off x="471699" y="3981732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94E647F-4C7E-02C4-6DDE-F8FEFE5F140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28" t="9713" r="1805" b="32414"/>
          <a:stretch/>
        </p:blipFill>
        <p:spPr>
          <a:xfrm>
            <a:off x="46062" y="4279800"/>
            <a:ext cx="3996392" cy="13943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694206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2E9507FD-8B48-598C-EA01-2B25C597D57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904" t="27526" r="42695" b="10093"/>
          <a:stretch/>
        </p:blipFill>
        <p:spPr>
          <a:xfrm rot="20792137">
            <a:off x="2965576" y="852346"/>
            <a:ext cx="5004733" cy="3988374"/>
          </a:xfrm>
          <a:prstGeom prst="rect">
            <a:avLst/>
          </a:prstGeom>
        </p:spPr>
      </p:pic>
      <p:sp>
        <p:nvSpPr>
          <p:cNvPr id="3" name="TextBox 6">
            <a:extLst>
              <a:ext uri="{FF2B5EF4-FFF2-40B4-BE49-F238E27FC236}">
                <a16:creationId xmlns:a16="http://schemas.microsoft.com/office/drawing/2014/main" id="{0615939E-2ABF-548E-3605-B7A534D6737B}"/>
              </a:ext>
            </a:extLst>
          </p:cNvPr>
          <p:cNvSpPr txBox="1"/>
          <p:nvPr/>
        </p:nvSpPr>
        <p:spPr>
          <a:xfrm>
            <a:off x="4257762" y="324503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1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50D9622-51B2-ACC8-D603-CCD0A9094183}"/>
              </a:ext>
            </a:extLst>
          </p:cNvPr>
          <p:cNvSpPr txBox="1"/>
          <p:nvPr/>
        </p:nvSpPr>
        <p:spPr>
          <a:xfrm>
            <a:off x="2211288" y="5456822"/>
            <a:ext cx="56240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FHRPPRTY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I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D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42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WV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</a:t>
            </a:r>
            <a:endParaRPr lang="da-DK" dirty="0"/>
          </a:p>
        </p:txBody>
      </p:sp>
      <p:sp>
        <p:nvSpPr>
          <p:cNvPr id="13" name="Rektangel 27">
            <a:extLst>
              <a:ext uri="{FF2B5EF4-FFF2-40B4-BE49-F238E27FC236}">
                <a16:creationId xmlns:a16="http://schemas.microsoft.com/office/drawing/2014/main" id="{BEA6B983-56E6-9D99-92C9-F00E9CB09171}"/>
              </a:ext>
            </a:extLst>
          </p:cNvPr>
          <p:cNvSpPr/>
          <p:nvPr/>
        </p:nvSpPr>
        <p:spPr>
          <a:xfrm>
            <a:off x="5549571" y="5465211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4" name="Tekstfelt 17">
            <a:extLst>
              <a:ext uri="{FF2B5EF4-FFF2-40B4-BE49-F238E27FC236}">
                <a16:creationId xmlns:a16="http://schemas.microsoft.com/office/drawing/2014/main" id="{384581E1-FA6F-F629-362F-674B81EA37D9}"/>
              </a:ext>
            </a:extLst>
          </p:cNvPr>
          <p:cNvSpPr txBox="1"/>
          <p:nvPr/>
        </p:nvSpPr>
        <p:spPr>
          <a:xfrm>
            <a:off x="3326256" y="4010379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42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5" name="Lige pilforbindelse 19">
            <a:extLst>
              <a:ext uri="{FF2B5EF4-FFF2-40B4-BE49-F238E27FC236}">
                <a16:creationId xmlns:a16="http://schemas.microsoft.com/office/drawing/2014/main" id="{051346AF-F7D9-D8BC-3FFB-480848C33F11}"/>
              </a:ext>
            </a:extLst>
          </p:cNvPr>
          <p:cNvCxnSpPr>
            <a:cxnSpLocks/>
            <a:stCxn id="14" idx="0"/>
          </p:cNvCxnSpPr>
          <p:nvPr/>
        </p:nvCxnSpPr>
        <p:spPr>
          <a:xfrm flipV="1">
            <a:off x="4179246" y="2916318"/>
            <a:ext cx="1106867" cy="109406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Ellipse 20">
            <a:extLst>
              <a:ext uri="{FF2B5EF4-FFF2-40B4-BE49-F238E27FC236}">
                <a16:creationId xmlns:a16="http://schemas.microsoft.com/office/drawing/2014/main" id="{7477C246-6C93-3EDA-608C-F356A22751FD}"/>
              </a:ext>
            </a:extLst>
          </p:cNvPr>
          <p:cNvSpPr/>
          <p:nvPr/>
        </p:nvSpPr>
        <p:spPr>
          <a:xfrm>
            <a:off x="5168105" y="2506914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7" name="Ellipse 23">
            <a:extLst>
              <a:ext uri="{FF2B5EF4-FFF2-40B4-BE49-F238E27FC236}">
                <a16:creationId xmlns:a16="http://schemas.microsoft.com/office/drawing/2014/main" id="{723DF796-A036-D6C8-8583-F61E21373ACA}"/>
              </a:ext>
            </a:extLst>
          </p:cNvPr>
          <p:cNvSpPr/>
          <p:nvPr/>
        </p:nvSpPr>
        <p:spPr>
          <a:xfrm>
            <a:off x="5447326" y="2455518"/>
            <a:ext cx="1287256" cy="747532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8" name="Tekstfelt 24">
            <a:extLst>
              <a:ext uri="{FF2B5EF4-FFF2-40B4-BE49-F238E27FC236}">
                <a16:creationId xmlns:a16="http://schemas.microsoft.com/office/drawing/2014/main" id="{8B63B93B-6E2E-1DDE-B6C2-9396B791BDE9}"/>
              </a:ext>
            </a:extLst>
          </p:cNvPr>
          <p:cNvSpPr txBox="1"/>
          <p:nvPr/>
        </p:nvSpPr>
        <p:spPr>
          <a:xfrm>
            <a:off x="7822276" y="3463348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9" name="Lige pilforbindelse 26">
            <a:extLst>
              <a:ext uri="{FF2B5EF4-FFF2-40B4-BE49-F238E27FC236}">
                <a16:creationId xmlns:a16="http://schemas.microsoft.com/office/drawing/2014/main" id="{A3C2B84C-5556-8094-A6A1-F3C678DA5124}"/>
              </a:ext>
            </a:extLst>
          </p:cNvPr>
          <p:cNvCxnSpPr>
            <a:cxnSpLocks/>
          </p:cNvCxnSpPr>
          <p:nvPr/>
        </p:nvCxnSpPr>
        <p:spPr>
          <a:xfrm flipH="1" flipV="1">
            <a:off x="6635582" y="3051270"/>
            <a:ext cx="1390475" cy="747532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0DE19487-4121-0905-23F6-8D2394916FB3}"/>
              </a:ext>
            </a:extLst>
          </p:cNvPr>
          <p:cNvSpPr txBox="1"/>
          <p:nvPr/>
        </p:nvSpPr>
        <p:spPr>
          <a:xfrm>
            <a:off x="701249" y="494259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9B41C83-371C-D6D3-F960-589E13FCBBB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12" t="9486" r="1799" b="33889"/>
          <a:stretch/>
        </p:blipFill>
        <p:spPr>
          <a:xfrm>
            <a:off x="104774" y="846166"/>
            <a:ext cx="3619525" cy="12302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516023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">
            <a:extLst>
              <a:ext uri="{FF2B5EF4-FFF2-40B4-BE49-F238E27FC236}">
                <a16:creationId xmlns:a16="http://schemas.microsoft.com/office/drawing/2014/main" id="{EE0A8DC1-6CD0-3DE4-C1B5-EEAFCDBC2696}"/>
              </a:ext>
            </a:extLst>
          </p:cNvPr>
          <p:cNvSpPr txBox="1"/>
          <p:nvPr/>
        </p:nvSpPr>
        <p:spPr>
          <a:xfrm>
            <a:off x="4901286" y="188278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20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39FE4D8-9B63-95D4-3B68-9A168BA94D2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561" t="31158" r="41652" b="17562"/>
          <a:stretch/>
        </p:blipFill>
        <p:spPr>
          <a:xfrm>
            <a:off x="2953041" y="739223"/>
            <a:ext cx="5001833" cy="35821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95CC0F9-3FA7-FD86-EEA4-6512122E6770}"/>
              </a:ext>
            </a:extLst>
          </p:cNvPr>
          <p:cNvSpPr txBox="1"/>
          <p:nvPr/>
        </p:nvSpPr>
        <p:spPr>
          <a:xfrm>
            <a:off x="1975346" y="5293345"/>
            <a:ext cx="54740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LIKPDRAH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LKM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6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7" name="Rektangel 27">
            <a:extLst>
              <a:ext uri="{FF2B5EF4-FFF2-40B4-BE49-F238E27FC236}">
                <a16:creationId xmlns:a16="http://schemas.microsoft.com/office/drawing/2014/main" id="{90B8026B-485B-7101-866E-80880BF38746}"/>
              </a:ext>
            </a:extLst>
          </p:cNvPr>
          <p:cNvSpPr/>
          <p:nvPr/>
        </p:nvSpPr>
        <p:spPr>
          <a:xfrm>
            <a:off x="5270122" y="5310124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800760F8-410E-5F4C-2869-C8317EFE8AAC}"/>
              </a:ext>
            </a:extLst>
          </p:cNvPr>
          <p:cNvSpPr txBox="1"/>
          <p:nvPr/>
        </p:nvSpPr>
        <p:spPr>
          <a:xfrm>
            <a:off x="3712897" y="3762151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56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316C0CF5-3287-3765-388A-B8953E77BB7F}"/>
              </a:ext>
            </a:extLst>
          </p:cNvPr>
          <p:cNvCxnSpPr>
            <a:cxnSpLocks/>
            <a:stCxn id="8" idx="0"/>
          </p:cNvCxnSpPr>
          <p:nvPr/>
        </p:nvCxnSpPr>
        <p:spPr>
          <a:xfrm flipV="1">
            <a:off x="4565887" y="2668090"/>
            <a:ext cx="1106867" cy="109406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FE3A293B-FC62-0126-9981-E24C1D5BB859}"/>
              </a:ext>
            </a:extLst>
          </p:cNvPr>
          <p:cNvSpPr/>
          <p:nvPr/>
        </p:nvSpPr>
        <p:spPr>
          <a:xfrm>
            <a:off x="5554746" y="2258686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1498565C-9E66-36BC-C4B1-7D312EE0E2B7}"/>
              </a:ext>
            </a:extLst>
          </p:cNvPr>
          <p:cNvSpPr/>
          <p:nvPr/>
        </p:nvSpPr>
        <p:spPr>
          <a:xfrm rot="21004595">
            <a:off x="5822195" y="1884920"/>
            <a:ext cx="1287256" cy="747532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0A800457-43CB-1218-9959-B0494508FE6F}"/>
              </a:ext>
            </a:extLst>
          </p:cNvPr>
          <p:cNvSpPr txBox="1"/>
          <p:nvPr/>
        </p:nvSpPr>
        <p:spPr>
          <a:xfrm>
            <a:off x="7087283" y="3526851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F371A474-6777-21E6-8586-7EC998EFBAC0}"/>
              </a:ext>
            </a:extLst>
          </p:cNvPr>
          <p:cNvCxnSpPr>
            <a:cxnSpLocks/>
          </p:cNvCxnSpPr>
          <p:nvPr/>
        </p:nvCxnSpPr>
        <p:spPr>
          <a:xfrm flipH="1" flipV="1">
            <a:off x="6925489" y="2463388"/>
            <a:ext cx="993045" cy="1059377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kstfelt 17">
            <a:extLst>
              <a:ext uri="{FF2B5EF4-FFF2-40B4-BE49-F238E27FC236}">
                <a16:creationId xmlns:a16="http://schemas.microsoft.com/office/drawing/2014/main" id="{521A062A-FE86-24E2-1ACC-53B4C8CA4F5B}"/>
              </a:ext>
            </a:extLst>
          </p:cNvPr>
          <p:cNvSpPr txBox="1"/>
          <p:nvPr/>
        </p:nvSpPr>
        <p:spPr>
          <a:xfrm>
            <a:off x="5596524" y="2923004"/>
            <a:ext cx="468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/>
              <a:t>C</a:t>
            </a:r>
            <a:r>
              <a:rPr lang="da-DK" sz="1200" baseline="-25000" dirty="0"/>
              <a:t>9, 10</a:t>
            </a:r>
            <a:endParaRPr lang="da-DK" sz="1200" dirty="0"/>
          </a:p>
        </p:txBody>
      </p:sp>
      <p:sp>
        <p:nvSpPr>
          <p:cNvPr id="16" name="Left Brace 15">
            <a:extLst>
              <a:ext uri="{FF2B5EF4-FFF2-40B4-BE49-F238E27FC236}">
                <a16:creationId xmlns:a16="http://schemas.microsoft.com/office/drawing/2014/main" id="{7E8A7E5D-2220-AF27-54BA-6D5E5868151F}"/>
              </a:ext>
            </a:extLst>
          </p:cNvPr>
          <p:cNvSpPr/>
          <p:nvPr/>
        </p:nvSpPr>
        <p:spPr>
          <a:xfrm rot="16853197">
            <a:off x="5835297" y="2763901"/>
            <a:ext cx="126408" cy="348214"/>
          </a:xfrm>
          <a:prstGeom prst="lef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6DD9360-6B56-9FB4-100F-76FFC81FE3B5}"/>
              </a:ext>
            </a:extLst>
          </p:cNvPr>
          <p:cNvSpPr txBox="1"/>
          <p:nvPr/>
        </p:nvSpPr>
        <p:spPr>
          <a:xfrm>
            <a:off x="991054" y="402836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05145D2-F6ED-27D5-3A9A-9D8A25DA2A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91" t="9670" r="2361" b="31697"/>
          <a:stretch/>
        </p:blipFill>
        <p:spPr>
          <a:xfrm>
            <a:off x="124940" y="710614"/>
            <a:ext cx="4327104" cy="1536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73788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lede 2">
            <a:extLst>
              <a:ext uri="{FF2B5EF4-FFF2-40B4-BE49-F238E27FC236}">
                <a16:creationId xmlns:a16="http://schemas.microsoft.com/office/drawing/2014/main" id="{844D539C-DD69-54FC-F2DB-279CBFD54F1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671" t="31839" r="39077" b="9508"/>
          <a:stretch/>
        </p:blipFill>
        <p:spPr>
          <a:xfrm>
            <a:off x="473086" y="1380447"/>
            <a:ext cx="6716683" cy="484769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69224E5-5BFF-8A7D-B40C-A6F415E304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654" r="2061" b="29988"/>
          <a:stretch/>
        </p:blipFill>
        <p:spPr>
          <a:xfrm>
            <a:off x="57507" y="601793"/>
            <a:ext cx="3662933" cy="1315601"/>
          </a:xfrm>
          <a:prstGeom prst="rect">
            <a:avLst/>
          </a:prstGeom>
        </p:spPr>
      </p:pic>
      <p:pic>
        <p:nvPicPr>
          <p:cNvPr id="35" name="Billede 34">
            <a:extLst>
              <a:ext uri="{FF2B5EF4-FFF2-40B4-BE49-F238E27FC236}">
                <a16:creationId xmlns:a16="http://schemas.microsoft.com/office/drawing/2014/main" id="{F8C1234F-6C93-AEC3-5F96-E3939D2E1F3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839" t="26073" r="29791" b="9001"/>
          <a:stretch/>
        </p:blipFill>
        <p:spPr>
          <a:xfrm>
            <a:off x="6375862" y="2317733"/>
            <a:ext cx="3291944" cy="2176713"/>
          </a:xfrm>
          <a:prstGeom prst="rect">
            <a:avLst/>
          </a:prstGeom>
        </p:spPr>
      </p:pic>
      <p:sp>
        <p:nvSpPr>
          <p:cNvPr id="4" name="TextBox 11">
            <a:extLst>
              <a:ext uri="{FF2B5EF4-FFF2-40B4-BE49-F238E27FC236}">
                <a16:creationId xmlns:a16="http://schemas.microsoft.com/office/drawing/2014/main" id="{323F2526-8826-B158-9A76-5F2A26C027FF}"/>
              </a:ext>
            </a:extLst>
          </p:cNvPr>
          <p:cNvSpPr txBox="1"/>
          <p:nvPr/>
        </p:nvSpPr>
        <p:spPr>
          <a:xfrm>
            <a:off x="4264543" y="503917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</a:t>
            </a:r>
            <a:r>
              <a:rPr lang="da-DK" b="1" dirty="0">
                <a:solidFill>
                  <a:srgbClr val="0A0A0A"/>
                </a:solidFill>
                <a:latin typeface="IBM Plex Sans" panose="020B0503050203000203" pitchFamily="34" charset="0"/>
              </a:rPr>
              <a:t>2</a:t>
            </a:r>
            <a:endParaRPr lang="da-DK" b="1" i="0" dirty="0">
              <a:solidFill>
                <a:srgbClr val="0A0A0A"/>
              </a:solidFill>
              <a:effectLst/>
              <a:latin typeface="IBM Plex Sans" panose="020B0503050203000203" pitchFamily="34" charset="0"/>
            </a:endParaRPr>
          </a:p>
        </p:txBody>
      </p:sp>
      <p:sp>
        <p:nvSpPr>
          <p:cNvPr id="5" name="TextBox 34">
            <a:extLst>
              <a:ext uri="{FF2B5EF4-FFF2-40B4-BE49-F238E27FC236}">
                <a16:creationId xmlns:a16="http://schemas.microsoft.com/office/drawing/2014/main" id="{37D4A72F-1B02-5300-2AC9-EBD032AFF959}"/>
              </a:ext>
            </a:extLst>
          </p:cNvPr>
          <p:cNvSpPr txBox="1"/>
          <p:nvPr/>
        </p:nvSpPr>
        <p:spPr>
          <a:xfrm>
            <a:off x="1596835" y="3326312"/>
            <a:ext cx="1719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/>
              <a:t>Helical</a:t>
            </a:r>
            <a:r>
              <a:rPr lang="da-DK" sz="1200" dirty="0"/>
              <a:t> - </a:t>
            </a:r>
            <a:r>
              <a:rPr lang="da-DK" sz="1200" dirty="0" err="1"/>
              <a:t>transmembrane</a:t>
            </a:r>
            <a:endParaRPr lang="da-DK" sz="1200" dirty="0"/>
          </a:p>
        </p:txBody>
      </p:sp>
      <p:sp>
        <p:nvSpPr>
          <p:cNvPr id="6" name="Tekstfelt 5">
            <a:extLst>
              <a:ext uri="{FF2B5EF4-FFF2-40B4-BE49-F238E27FC236}">
                <a16:creationId xmlns:a16="http://schemas.microsoft.com/office/drawing/2014/main" id="{DAF1DF87-3E2F-DD33-AD36-44E8C1D4B247}"/>
              </a:ext>
            </a:extLst>
          </p:cNvPr>
          <p:cNvSpPr txBox="1"/>
          <p:nvPr/>
        </p:nvSpPr>
        <p:spPr>
          <a:xfrm>
            <a:off x="5356846" y="5319303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56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7" name="Lige pilforbindelse 6">
            <a:extLst>
              <a:ext uri="{FF2B5EF4-FFF2-40B4-BE49-F238E27FC236}">
                <a16:creationId xmlns:a16="http://schemas.microsoft.com/office/drawing/2014/main" id="{3CBB0BFD-5898-7C5D-F4A7-3A60F3C87272}"/>
              </a:ext>
            </a:extLst>
          </p:cNvPr>
          <p:cNvCxnSpPr>
            <a:cxnSpLocks/>
          </p:cNvCxnSpPr>
          <p:nvPr/>
        </p:nvCxnSpPr>
        <p:spPr>
          <a:xfrm flipH="1" flipV="1">
            <a:off x="3957706" y="4115744"/>
            <a:ext cx="1611285" cy="1203559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Ellipse 7">
            <a:extLst>
              <a:ext uri="{FF2B5EF4-FFF2-40B4-BE49-F238E27FC236}">
                <a16:creationId xmlns:a16="http://schemas.microsoft.com/office/drawing/2014/main" id="{CC9FD6E0-DCAB-5513-BBEF-EF2126B8AAD5}"/>
              </a:ext>
            </a:extLst>
          </p:cNvPr>
          <p:cNvSpPr/>
          <p:nvPr/>
        </p:nvSpPr>
        <p:spPr>
          <a:xfrm>
            <a:off x="3712640" y="3789467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9" name="Ellipse 8">
            <a:extLst>
              <a:ext uri="{FF2B5EF4-FFF2-40B4-BE49-F238E27FC236}">
                <a16:creationId xmlns:a16="http://schemas.microsoft.com/office/drawing/2014/main" id="{09475843-532B-5003-954C-57E9C2CFCEAF}"/>
              </a:ext>
            </a:extLst>
          </p:cNvPr>
          <p:cNvSpPr/>
          <p:nvPr/>
        </p:nvSpPr>
        <p:spPr>
          <a:xfrm>
            <a:off x="4077572" y="3633604"/>
            <a:ext cx="1342834" cy="982983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cxnSp>
        <p:nvCxnSpPr>
          <p:cNvPr id="11" name="Lige pilforbindelse 10">
            <a:extLst>
              <a:ext uri="{FF2B5EF4-FFF2-40B4-BE49-F238E27FC236}">
                <a16:creationId xmlns:a16="http://schemas.microsoft.com/office/drawing/2014/main" id="{6E91E86F-D56F-DA05-8166-0DFC2052F922}"/>
              </a:ext>
            </a:extLst>
          </p:cNvPr>
          <p:cNvCxnSpPr>
            <a:cxnSpLocks/>
          </p:cNvCxnSpPr>
          <p:nvPr/>
        </p:nvCxnSpPr>
        <p:spPr>
          <a:xfrm flipH="1" flipV="1">
            <a:off x="5405522" y="4282130"/>
            <a:ext cx="744120" cy="255424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ktangel 11">
            <a:extLst>
              <a:ext uri="{FF2B5EF4-FFF2-40B4-BE49-F238E27FC236}">
                <a16:creationId xmlns:a16="http://schemas.microsoft.com/office/drawing/2014/main" id="{1DCAA140-E00C-714D-4910-E6F64194A73B}"/>
              </a:ext>
            </a:extLst>
          </p:cNvPr>
          <p:cNvSpPr/>
          <p:nvPr/>
        </p:nvSpPr>
        <p:spPr>
          <a:xfrm>
            <a:off x="5390672" y="5804719"/>
            <a:ext cx="1828800" cy="5320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6" name="Tekstfelt 15">
            <a:extLst>
              <a:ext uri="{FF2B5EF4-FFF2-40B4-BE49-F238E27FC236}">
                <a16:creationId xmlns:a16="http://schemas.microsoft.com/office/drawing/2014/main" id="{27B0FA87-9412-565E-6E3B-0F47556BB682}"/>
              </a:ext>
            </a:extLst>
          </p:cNvPr>
          <p:cNvSpPr txBox="1"/>
          <p:nvPr/>
        </p:nvSpPr>
        <p:spPr>
          <a:xfrm>
            <a:off x="1736962" y="6275051"/>
            <a:ext cx="53949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LIKPD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LKM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6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17" name="Rektangel 16">
            <a:extLst>
              <a:ext uri="{FF2B5EF4-FFF2-40B4-BE49-F238E27FC236}">
                <a16:creationId xmlns:a16="http://schemas.microsoft.com/office/drawing/2014/main" id="{B1C1D0A7-431F-88D6-065B-1348125CBF77}"/>
              </a:ext>
            </a:extLst>
          </p:cNvPr>
          <p:cNvSpPr/>
          <p:nvPr/>
        </p:nvSpPr>
        <p:spPr>
          <a:xfrm>
            <a:off x="4959781" y="6338261"/>
            <a:ext cx="858729" cy="2977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pic>
        <p:nvPicPr>
          <p:cNvPr id="22" name="Billede 21">
            <a:extLst>
              <a:ext uri="{FF2B5EF4-FFF2-40B4-BE49-F238E27FC236}">
                <a16:creationId xmlns:a16="http://schemas.microsoft.com/office/drawing/2014/main" id="{CE56DEC5-6880-5EFC-0A0E-DDFDD01BC58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021" t="26751" r="24300" b="2520"/>
          <a:stretch/>
        </p:blipFill>
        <p:spPr>
          <a:xfrm>
            <a:off x="6145871" y="130309"/>
            <a:ext cx="3597437" cy="2078685"/>
          </a:xfrm>
          <a:prstGeom prst="rect">
            <a:avLst/>
          </a:prstGeom>
        </p:spPr>
      </p:pic>
      <p:sp>
        <p:nvSpPr>
          <p:cNvPr id="24" name="Tekstfelt 23">
            <a:extLst>
              <a:ext uri="{FF2B5EF4-FFF2-40B4-BE49-F238E27FC236}">
                <a16:creationId xmlns:a16="http://schemas.microsoft.com/office/drawing/2014/main" id="{1514FAEB-230E-92DC-9246-3296A781B34D}"/>
              </a:ext>
            </a:extLst>
          </p:cNvPr>
          <p:cNvSpPr txBox="1"/>
          <p:nvPr/>
        </p:nvSpPr>
        <p:spPr>
          <a:xfrm>
            <a:off x="8066056" y="804530"/>
            <a:ext cx="420308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  <a:r>
              <a:rPr lang="en-US" sz="1200" baseline="-25000" dirty="0"/>
              <a:t>148</a:t>
            </a:r>
            <a:endParaRPr lang="da-DK" sz="1200" baseline="-25000" dirty="0"/>
          </a:p>
        </p:txBody>
      </p:sp>
      <p:sp>
        <p:nvSpPr>
          <p:cNvPr id="25" name="Tekstfelt 24">
            <a:extLst>
              <a:ext uri="{FF2B5EF4-FFF2-40B4-BE49-F238E27FC236}">
                <a16:creationId xmlns:a16="http://schemas.microsoft.com/office/drawing/2014/main" id="{2E04B9F8-2880-00FD-40C6-9C575F7058C1}"/>
              </a:ext>
            </a:extLst>
          </p:cNvPr>
          <p:cNvSpPr txBox="1"/>
          <p:nvPr/>
        </p:nvSpPr>
        <p:spPr>
          <a:xfrm>
            <a:off x="8620018" y="1449866"/>
            <a:ext cx="420308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  <a:r>
              <a:rPr lang="en-US" sz="1200" baseline="-25000" dirty="0"/>
              <a:t>128</a:t>
            </a:r>
            <a:endParaRPr lang="da-DK" sz="1200" baseline="-25000" dirty="0"/>
          </a:p>
        </p:txBody>
      </p:sp>
      <p:sp>
        <p:nvSpPr>
          <p:cNvPr id="26" name="Tekstfelt 25">
            <a:extLst>
              <a:ext uri="{FF2B5EF4-FFF2-40B4-BE49-F238E27FC236}">
                <a16:creationId xmlns:a16="http://schemas.microsoft.com/office/drawing/2014/main" id="{55F8CDAF-E508-BA32-D0F7-43CE14FFF9AC}"/>
              </a:ext>
            </a:extLst>
          </p:cNvPr>
          <p:cNvSpPr txBox="1"/>
          <p:nvPr/>
        </p:nvSpPr>
        <p:spPr>
          <a:xfrm>
            <a:off x="7928784" y="1800572"/>
            <a:ext cx="420308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  <a:r>
              <a:rPr lang="en-US" sz="1200" baseline="-25000" dirty="0"/>
              <a:t>131</a:t>
            </a:r>
            <a:endParaRPr lang="da-DK" sz="1200" baseline="-25000" dirty="0"/>
          </a:p>
        </p:txBody>
      </p:sp>
      <p:sp>
        <p:nvSpPr>
          <p:cNvPr id="27" name="Tekstfelt 26">
            <a:extLst>
              <a:ext uri="{FF2B5EF4-FFF2-40B4-BE49-F238E27FC236}">
                <a16:creationId xmlns:a16="http://schemas.microsoft.com/office/drawing/2014/main" id="{9C937691-40B4-F90E-3541-AC9D1FD92A72}"/>
              </a:ext>
            </a:extLst>
          </p:cNvPr>
          <p:cNvSpPr txBox="1"/>
          <p:nvPr/>
        </p:nvSpPr>
        <p:spPr>
          <a:xfrm>
            <a:off x="6504193" y="1449865"/>
            <a:ext cx="420308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  <a:r>
              <a:rPr lang="en-US" sz="1200" baseline="-25000" dirty="0"/>
              <a:t>142</a:t>
            </a:r>
            <a:endParaRPr lang="da-DK" sz="1200" baseline="-25000" dirty="0"/>
          </a:p>
        </p:txBody>
      </p:sp>
      <p:sp>
        <p:nvSpPr>
          <p:cNvPr id="31" name="Tekstfelt 30">
            <a:extLst>
              <a:ext uri="{FF2B5EF4-FFF2-40B4-BE49-F238E27FC236}">
                <a16:creationId xmlns:a16="http://schemas.microsoft.com/office/drawing/2014/main" id="{3F78A797-EA64-67AE-DF28-2FD160613EAC}"/>
              </a:ext>
            </a:extLst>
          </p:cNvPr>
          <p:cNvSpPr txBox="1"/>
          <p:nvPr/>
        </p:nvSpPr>
        <p:spPr>
          <a:xfrm>
            <a:off x="8409864" y="2518896"/>
            <a:ext cx="420308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  <a:r>
              <a:rPr lang="en-US" sz="1200" baseline="-25000" dirty="0"/>
              <a:t>142</a:t>
            </a:r>
            <a:endParaRPr lang="da-DK" sz="1200" baseline="-25000" dirty="0"/>
          </a:p>
        </p:txBody>
      </p:sp>
      <p:sp>
        <p:nvSpPr>
          <p:cNvPr id="32" name="Tekstfelt 31">
            <a:extLst>
              <a:ext uri="{FF2B5EF4-FFF2-40B4-BE49-F238E27FC236}">
                <a16:creationId xmlns:a16="http://schemas.microsoft.com/office/drawing/2014/main" id="{EECFC12C-3FFD-6BA0-306C-0E423F7EE18E}"/>
              </a:ext>
            </a:extLst>
          </p:cNvPr>
          <p:cNvSpPr txBox="1"/>
          <p:nvPr/>
        </p:nvSpPr>
        <p:spPr>
          <a:xfrm>
            <a:off x="8123161" y="3152411"/>
            <a:ext cx="420308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  <a:r>
              <a:rPr lang="en-US" sz="1200" baseline="-25000" dirty="0"/>
              <a:t>145</a:t>
            </a:r>
            <a:endParaRPr lang="da-DK" sz="1200" baseline="-25000" dirty="0"/>
          </a:p>
        </p:txBody>
      </p:sp>
      <p:sp>
        <p:nvSpPr>
          <p:cNvPr id="33" name="Tekstfelt 32">
            <a:extLst>
              <a:ext uri="{FF2B5EF4-FFF2-40B4-BE49-F238E27FC236}">
                <a16:creationId xmlns:a16="http://schemas.microsoft.com/office/drawing/2014/main" id="{C9530969-2C2E-9175-B30E-33156A7E2BC9}"/>
              </a:ext>
            </a:extLst>
          </p:cNvPr>
          <p:cNvSpPr txBox="1"/>
          <p:nvPr/>
        </p:nvSpPr>
        <p:spPr>
          <a:xfrm>
            <a:off x="7645748" y="2565062"/>
            <a:ext cx="420308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  <a:r>
              <a:rPr lang="en-US" sz="1200" baseline="-25000" dirty="0"/>
              <a:t>162</a:t>
            </a:r>
            <a:endParaRPr lang="da-DK" sz="1200" baseline="-25000" dirty="0"/>
          </a:p>
        </p:txBody>
      </p:sp>
      <p:sp>
        <p:nvSpPr>
          <p:cNvPr id="36" name="Tekstfelt 35">
            <a:extLst>
              <a:ext uri="{FF2B5EF4-FFF2-40B4-BE49-F238E27FC236}">
                <a16:creationId xmlns:a16="http://schemas.microsoft.com/office/drawing/2014/main" id="{5240A7A7-9E70-041B-2D9A-67D188CEA3D3}"/>
              </a:ext>
            </a:extLst>
          </p:cNvPr>
          <p:cNvSpPr txBox="1"/>
          <p:nvPr/>
        </p:nvSpPr>
        <p:spPr>
          <a:xfrm>
            <a:off x="6822259" y="3780022"/>
            <a:ext cx="420308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  <a:r>
              <a:rPr lang="en-US" sz="1200" baseline="-25000" dirty="0"/>
              <a:t>156</a:t>
            </a:r>
            <a:endParaRPr lang="da-DK" sz="1200" baseline="-25000" dirty="0"/>
          </a:p>
        </p:txBody>
      </p:sp>
      <p:sp>
        <p:nvSpPr>
          <p:cNvPr id="2" name="Tekstfelt 24">
            <a:extLst>
              <a:ext uri="{FF2B5EF4-FFF2-40B4-BE49-F238E27FC236}">
                <a16:creationId xmlns:a16="http://schemas.microsoft.com/office/drawing/2014/main" id="{3D61D5A7-FA35-56D1-B9A4-89FBDCCF79C9}"/>
              </a:ext>
            </a:extLst>
          </p:cNvPr>
          <p:cNvSpPr txBox="1"/>
          <p:nvPr/>
        </p:nvSpPr>
        <p:spPr>
          <a:xfrm>
            <a:off x="5841644" y="4197138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71E5F9-AB63-D66A-EB21-DDEF433868E1}"/>
              </a:ext>
            </a:extLst>
          </p:cNvPr>
          <p:cNvSpPr txBox="1"/>
          <p:nvPr/>
        </p:nvSpPr>
        <p:spPr>
          <a:xfrm>
            <a:off x="536665" y="273657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</p:spTree>
    <p:extLst>
      <p:ext uri="{BB962C8B-B14F-4D97-AF65-F5344CB8AC3E}">
        <p14:creationId xmlns:p14="http://schemas.microsoft.com/office/powerpoint/2010/main" val="341566673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27008F4-46F9-2967-BB94-C133B9C94E4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781" t="32059" r="40974" b="11815"/>
          <a:stretch/>
        </p:blipFill>
        <p:spPr>
          <a:xfrm>
            <a:off x="2199471" y="698383"/>
            <a:ext cx="4907560" cy="4116387"/>
          </a:xfrm>
          <a:prstGeom prst="rect">
            <a:avLst/>
          </a:prstGeom>
        </p:spPr>
      </p:pic>
      <p:sp>
        <p:nvSpPr>
          <p:cNvPr id="4" name="TextBox 6">
            <a:extLst>
              <a:ext uri="{FF2B5EF4-FFF2-40B4-BE49-F238E27FC236}">
                <a16:creationId xmlns:a16="http://schemas.microsoft.com/office/drawing/2014/main" id="{4C146966-6498-9DC6-443E-767D72287F62}"/>
              </a:ext>
            </a:extLst>
          </p:cNvPr>
          <p:cNvSpPr txBox="1"/>
          <p:nvPr/>
        </p:nvSpPr>
        <p:spPr>
          <a:xfrm>
            <a:off x="4253359" y="329051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2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6D6B707-E64E-E0AE-6866-252E81612FEB}"/>
              </a:ext>
            </a:extLst>
          </p:cNvPr>
          <p:cNvSpPr txBox="1"/>
          <p:nvPr/>
        </p:nvSpPr>
        <p:spPr>
          <a:xfrm>
            <a:off x="1990287" y="5473709"/>
            <a:ext cx="55346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LMRPKRSH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RRM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20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INNCVG</a:t>
            </a:r>
            <a:endParaRPr lang="da-DK" dirty="0"/>
          </a:p>
        </p:txBody>
      </p:sp>
      <p:sp>
        <p:nvSpPr>
          <p:cNvPr id="7" name="Rektangel 27">
            <a:extLst>
              <a:ext uri="{FF2B5EF4-FFF2-40B4-BE49-F238E27FC236}">
                <a16:creationId xmlns:a16="http://schemas.microsoft.com/office/drawing/2014/main" id="{342208FD-9785-53FA-BA02-BDCF9FA4A040}"/>
              </a:ext>
            </a:extLst>
          </p:cNvPr>
          <p:cNvSpPr/>
          <p:nvPr/>
        </p:nvSpPr>
        <p:spPr>
          <a:xfrm>
            <a:off x="5444454" y="5486185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E87F1C52-38F7-212C-8436-F67B25364AF4}"/>
              </a:ext>
            </a:extLst>
          </p:cNvPr>
          <p:cNvSpPr txBox="1"/>
          <p:nvPr/>
        </p:nvSpPr>
        <p:spPr>
          <a:xfrm>
            <a:off x="3078850" y="4423665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20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3066E581-F587-1F34-CE4D-D14471271D30}"/>
              </a:ext>
            </a:extLst>
          </p:cNvPr>
          <p:cNvCxnSpPr>
            <a:cxnSpLocks/>
          </p:cNvCxnSpPr>
          <p:nvPr/>
        </p:nvCxnSpPr>
        <p:spPr>
          <a:xfrm flipV="1">
            <a:off x="4032035" y="3394923"/>
            <a:ext cx="1106867" cy="109406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BA19E59F-56AB-3AB1-9309-D8EF1D5F4DFE}"/>
              </a:ext>
            </a:extLst>
          </p:cNvPr>
          <p:cNvSpPr/>
          <p:nvPr/>
        </p:nvSpPr>
        <p:spPr>
          <a:xfrm>
            <a:off x="5024797" y="3025591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8921F14B-3248-3BDE-9476-705B365BF2E1}"/>
              </a:ext>
            </a:extLst>
          </p:cNvPr>
          <p:cNvSpPr/>
          <p:nvPr/>
        </p:nvSpPr>
        <p:spPr>
          <a:xfrm rot="21004595">
            <a:off x="5403150" y="2523798"/>
            <a:ext cx="1697038" cy="972032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E610DEB4-D67E-1458-AC2A-F858596AA22A}"/>
              </a:ext>
            </a:extLst>
          </p:cNvPr>
          <p:cNvSpPr txBox="1"/>
          <p:nvPr/>
        </p:nvSpPr>
        <p:spPr>
          <a:xfrm>
            <a:off x="7307422" y="3572621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23B4FC82-70DA-FC2D-12BD-3CE858F1E24E}"/>
              </a:ext>
            </a:extLst>
          </p:cNvPr>
          <p:cNvCxnSpPr>
            <a:cxnSpLocks/>
          </p:cNvCxnSpPr>
          <p:nvPr/>
        </p:nvCxnSpPr>
        <p:spPr>
          <a:xfrm flipH="1" flipV="1">
            <a:off x="6719835" y="3390682"/>
            <a:ext cx="797394" cy="571198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01E85711-CF7E-EDE0-E4F0-520A9D6987E4}"/>
              </a:ext>
            </a:extLst>
          </p:cNvPr>
          <p:cNvSpPr txBox="1"/>
          <p:nvPr/>
        </p:nvSpPr>
        <p:spPr>
          <a:xfrm>
            <a:off x="999174" y="495092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FCAD566-1C74-6BA5-FA66-75E43DCD75F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50" t="9649" r="1665" b="41258"/>
          <a:stretch/>
        </p:blipFill>
        <p:spPr>
          <a:xfrm>
            <a:off x="216377" y="825297"/>
            <a:ext cx="4083816" cy="12035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720455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D2B1184-BF03-9121-B9D2-977A9E4C1A2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527" t="34718" r="41651" b="11188"/>
          <a:stretch/>
        </p:blipFill>
        <p:spPr>
          <a:xfrm>
            <a:off x="4033955" y="431446"/>
            <a:ext cx="4949505" cy="4048532"/>
          </a:xfrm>
          <a:prstGeom prst="rect">
            <a:avLst/>
          </a:prstGeom>
        </p:spPr>
      </p:pic>
      <p:sp>
        <p:nvSpPr>
          <p:cNvPr id="2" name="TextBox 6">
            <a:extLst>
              <a:ext uri="{FF2B5EF4-FFF2-40B4-BE49-F238E27FC236}">
                <a16:creationId xmlns:a16="http://schemas.microsoft.com/office/drawing/2014/main" id="{CE5E27D2-2DFE-DD1D-083E-0461634B8D78}"/>
              </a:ext>
            </a:extLst>
          </p:cNvPr>
          <p:cNvSpPr txBox="1"/>
          <p:nvPr/>
        </p:nvSpPr>
        <p:spPr>
          <a:xfrm>
            <a:off x="4222883" y="352050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2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DA00367-2112-D3E5-5C97-9FA8F45924B8}"/>
              </a:ext>
            </a:extLst>
          </p:cNvPr>
          <p:cNvSpPr txBox="1"/>
          <p:nvPr/>
        </p:nvSpPr>
        <p:spPr>
          <a:xfrm>
            <a:off x="2239600" y="5364543"/>
            <a:ext cx="52433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MSQRPQCPPPSTHFCR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RVTLR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11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FTG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</a:t>
            </a:r>
            <a:endParaRPr lang="da-DK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DE6697D-DAFD-8C3E-B620-27C2B2DBC19F}"/>
              </a:ext>
            </a:extLst>
          </p:cNvPr>
          <p:cNvSpPr txBox="1"/>
          <p:nvPr/>
        </p:nvSpPr>
        <p:spPr>
          <a:xfrm>
            <a:off x="3556932" y="5970839"/>
            <a:ext cx="3266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/>
              <a:t>Lack</a:t>
            </a:r>
            <a:r>
              <a:rPr lang="da-DK" dirty="0"/>
              <a:t> </a:t>
            </a:r>
            <a:r>
              <a:rPr lang="da-DK" dirty="0" err="1"/>
              <a:t>zDHHC</a:t>
            </a:r>
            <a:r>
              <a:rPr lang="da-DK" dirty="0"/>
              <a:t> </a:t>
            </a:r>
            <a:r>
              <a:rPr lang="da-DK" dirty="0" err="1"/>
              <a:t>consensus</a:t>
            </a:r>
            <a:r>
              <a:rPr lang="da-DK" dirty="0"/>
              <a:t> </a:t>
            </a:r>
            <a:r>
              <a:rPr lang="da-DK" dirty="0" err="1"/>
              <a:t>sequence</a:t>
            </a:r>
            <a:endParaRPr lang="da-DK" dirty="0"/>
          </a:p>
        </p:txBody>
      </p:sp>
      <p:sp>
        <p:nvSpPr>
          <p:cNvPr id="8" name="Rektangel 27">
            <a:extLst>
              <a:ext uri="{FF2B5EF4-FFF2-40B4-BE49-F238E27FC236}">
                <a16:creationId xmlns:a16="http://schemas.microsoft.com/office/drawing/2014/main" id="{E53B3D92-1E7B-C181-576E-92266359B02B}"/>
              </a:ext>
            </a:extLst>
          </p:cNvPr>
          <p:cNvSpPr/>
          <p:nvPr/>
        </p:nvSpPr>
        <p:spPr>
          <a:xfrm>
            <a:off x="5545122" y="5377019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9" name="Tekstfelt 17">
            <a:extLst>
              <a:ext uri="{FF2B5EF4-FFF2-40B4-BE49-F238E27FC236}">
                <a16:creationId xmlns:a16="http://schemas.microsoft.com/office/drawing/2014/main" id="{E573C199-DA01-9A91-FDE2-F80DDA1B1B40}"/>
              </a:ext>
            </a:extLst>
          </p:cNvPr>
          <p:cNvSpPr txBox="1"/>
          <p:nvPr/>
        </p:nvSpPr>
        <p:spPr>
          <a:xfrm>
            <a:off x="5057071" y="4062507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11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0" name="Lige pilforbindelse 19">
            <a:extLst>
              <a:ext uri="{FF2B5EF4-FFF2-40B4-BE49-F238E27FC236}">
                <a16:creationId xmlns:a16="http://schemas.microsoft.com/office/drawing/2014/main" id="{924B17BB-AC54-4E00-4A27-1FF676609729}"/>
              </a:ext>
            </a:extLst>
          </p:cNvPr>
          <p:cNvCxnSpPr>
            <a:cxnSpLocks/>
            <a:endCxn id="11" idx="3"/>
          </p:cNvCxnSpPr>
          <p:nvPr/>
        </p:nvCxnSpPr>
        <p:spPr>
          <a:xfrm flipV="1">
            <a:off x="6001867" y="2984643"/>
            <a:ext cx="1024575" cy="1048626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Ellipse 20">
            <a:extLst>
              <a:ext uri="{FF2B5EF4-FFF2-40B4-BE49-F238E27FC236}">
                <a16:creationId xmlns:a16="http://schemas.microsoft.com/office/drawing/2014/main" id="{096FDA0B-B1CE-9FC2-421C-F194C9C1444C}"/>
              </a:ext>
            </a:extLst>
          </p:cNvPr>
          <p:cNvSpPr/>
          <p:nvPr/>
        </p:nvSpPr>
        <p:spPr>
          <a:xfrm>
            <a:off x="6964153" y="2635195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Ellipse 23">
            <a:extLst>
              <a:ext uri="{FF2B5EF4-FFF2-40B4-BE49-F238E27FC236}">
                <a16:creationId xmlns:a16="http://schemas.microsoft.com/office/drawing/2014/main" id="{EEECF053-B712-4D2E-53AC-E27A54209358}"/>
              </a:ext>
            </a:extLst>
          </p:cNvPr>
          <p:cNvSpPr/>
          <p:nvPr/>
        </p:nvSpPr>
        <p:spPr>
          <a:xfrm rot="403767">
            <a:off x="7338616" y="2066062"/>
            <a:ext cx="1697038" cy="1558584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3" name="Tekstfelt 24">
            <a:extLst>
              <a:ext uri="{FF2B5EF4-FFF2-40B4-BE49-F238E27FC236}">
                <a16:creationId xmlns:a16="http://schemas.microsoft.com/office/drawing/2014/main" id="{7807252E-34D9-3250-3647-139E8C6F94FB}"/>
              </a:ext>
            </a:extLst>
          </p:cNvPr>
          <p:cNvSpPr txBox="1"/>
          <p:nvPr/>
        </p:nvSpPr>
        <p:spPr>
          <a:xfrm>
            <a:off x="7878245" y="3970174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4" name="Lige pilforbindelse 26">
            <a:extLst>
              <a:ext uri="{FF2B5EF4-FFF2-40B4-BE49-F238E27FC236}">
                <a16:creationId xmlns:a16="http://schemas.microsoft.com/office/drawing/2014/main" id="{14A39E0C-5E41-0A8C-FA7C-8DF40D2F0332}"/>
              </a:ext>
            </a:extLst>
          </p:cNvPr>
          <p:cNvCxnSpPr>
            <a:cxnSpLocks/>
            <a:stCxn id="13" idx="0"/>
          </p:cNvCxnSpPr>
          <p:nvPr/>
        </p:nvCxnSpPr>
        <p:spPr>
          <a:xfrm flipH="1" flipV="1">
            <a:off x="8416506" y="3657572"/>
            <a:ext cx="503601" cy="312602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1B66B481-F7A5-0505-5762-80B318CFDF72}"/>
              </a:ext>
            </a:extLst>
          </p:cNvPr>
          <p:cNvSpPr txBox="1"/>
          <p:nvPr/>
        </p:nvSpPr>
        <p:spPr>
          <a:xfrm>
            <a:off x="654852" y="443983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76CF55A0-988C-1BFB-217A-0C9F7A76A2B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50" t="9203" r="1805" b="41547"/>
          <a:stretch/>
        </p:blipFill>
        <p:spPr>
          <a:xfrm>
            <a:off x="106799" y="769332"/>
            <a:ext cx="3924300" cy="1161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262947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">
            <a:extLst>
              <a:ext uri="{FF2B5EF4-FFF2-40B4-BE49-F238E27FC236}">
                <a16:creationId xmlns:a16="http://schemas.microsoft.com/office/drawing/2014/main" id="{F422DB8F-F7D9-A10A-86DD-DD5575A35256}"/>
              </a:ext>
            </a:extLst>
          </p:cNvPr>
          <p:cNvSpPr txBox="1"/>
          <p:nvPr/>
        </p:nvSpPr>
        <p:spPr>
          <a:xfrm>
            <a:off x="4257762" y="264090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2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D7F1BA1-BEEE-438F-9269-72238352A41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938" t="31123" r="38941" b="13376"/>
          <a:stretch/>
        </p:blipFill>
        <p:spPr>
          <a:xfrm>
            <a:off x="2940663" y="645898"/>
            <a:ext cx="5791532" cy="394624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96FB202-4847-C3C8-386E-AA66BBBC6498}"/>
              </a:ext>
            </a:extLst>
          </p:cNvPr>
          <p:cNvSpPr txBox="1"/>
          <p:nvPr/>
        </p:nvSpPr>
        <p:spPr>
          <a:xfrm>
            <a:off x="1730230" y="5654071"/>
            <a:ext cx="54507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LVRPARAW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I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RRM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79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WINS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7" name="Rektangel 27">
            <a:extLst>
              <a:ext uri="{FF2B5EF4-FFF2-40B4-BE49-F238E27FC236}">
                <a16:creationId xmlns:a16="http://schemas.microsoft.com/office/drawing/2014/main" id="{57AD66FC-D390-8373-133D-D7F125D2E0C8}"/>
              </a:ext>
            </a:extLst>
          </p:cNvPr>
          <p:cNvSpPr/>
          <p:nvPr/>
        </p:nvSpPr>
        <p:spPr>
          <a:xfrm>
            <a:off x="5146645" y="5666547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603F8E54-9C6B-E2BF-9622-9940E9C5BDB3}"/>
              </a:ext>
            </a:extLst>
          </p:cNvPr>
          <p:cNvSpPr txBox="1"/>
          <p:nvPr/>
        </p:nvSpPr>
        <p:spPr>
          <a:xfrm>
            <a:off x="3483241" y="4235288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279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9FE6D5F9-6498-9905-694F-06C3B1C6F9B2}"/>
              </a:ext>
            </a:extLst>
          </p:cNvPr>
          <p:cNvCxnSpPr>
            <a:cxnSpLocks/>
            <a:endCxn id="10" idx="3"/>
          </p:cNvCxnSpPr>
          <p:nvPr/>
        </p:nvCxnSpPr>
        <p:spPr>
          <a:xfrm flipV="1">
            <a:off x="4428037" y="3157424"/>
            <a:ext cx="1024575" cy="1048626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42B665D8-4FF4-46AC-53E7-2B1652C8398F}"/>
              </a:ext>
            </a:extLst>
          </p:cNvPr>
          <p:cNvSpPr/>
          <p:nvPr/>
        </p:nvSpPr>
        <p:spPr>
          <a:xfrm>
            <a:off x="5390323" y="2807976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A4C248BC-95CF-B409-79AE-94C72B7CA971}"/>
              </a:ext>
            </a:extLst>
          </p:cNvPr>
          <p:cNvSpPr/>
          <p:nvPr/>
        </p:nvSpPr>
        <p:spPr>
          <a:xfrm rot="403767">
            <a:off x="5741993" y="2626519"/>
            <a:ext cx="1135313" cy="1136542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2A13323A-C392-677F-1AF3-74FB4D15D7BB}"/>
              </a:ext>
            </a:extLst>
          </p:cNvPr>
          <p:cNvSpPr txBox="1"/>
          <p:nvPr/>
        </p:nvSpPr>
        <p:spPr>
          <a:xfrm>
            <a:off x="7703424" y="3289687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D6EEC7E9-95FE-A445-B84D-F8489498138B}"/>
              </a:ext>
            </a:extLst>
          </p:cNvPr>
          <p:cNvCxnSpPr>
            <a:cxnSpLocks/>
          </p:cNvCxnSpPr>
          <p:nvPr/>
        </p:nvCxnSpPr>
        <p:spPr>
          <a:xfrm flipH="1" flipV="1">
            <a:off x="6839446" y="3441476"/>
            <a:ext cx="1073785" cy="237470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Left Brace 16">
            <a:extLst>
              <a:ext uri="{FF2B5EF4-FFF2-40B4-BE49-F238E27FC236}">
                <a16:creationId xmlns:a16="http://schemas.microsoft.com/office/drawing/2014/main" id="{29A67778-51A3-7874-4DA2-E4C15AE1B3AD}"/>
              </a:ext>
            </a:extLst>
          </p:cNvPr>
          <p:cNvSpPr/>
          <p:nvPr/>
        </p:nvSpPr>
        <p:spPr>
          <a:xfrm>
            <a:off x="5029830" y="2047618"/>
            <a:ext cx="159391" cy="392975"/>
          </a:xfrm>
          <a:prstGeom prst="lef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8" name="Tekstfelt 17">
            <a:extLst>
              <a:ext uri="{FF2B5EF4-FFF2-40B4-BE49-F238E27FC236}">
                <a16:creationId xmlns:a16="http://schemas.microsoft.com/office/drawing/2014/main" id="{C462219F-22A2-BA65-E517-ADFCBC429960}"/>
              </a:ext>
            </a:extLst>
          </p:cNvPr>
          <p:cNvSpPr txBox="1"/>
          <p:nvPr/>
        </p:nvSpPr>
        <p:spPr>
          <a:xfrm>
            <a:off x="4268083" y="2018380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/>
              <a:t>C</a:t>
            </a:r>
            <a:r>
              <a:rPr lang="da-DK" sz="1400" baseline="-25000" dirty="0"/>
              <a:t>18, 19, 20</a:t>
            </a:r>
            <a:endParaRPr lang="da-DK" sz="14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AAFAEE1-E916-6540-7962-DD12BCCD2385}"/>
              </a:ext>
            </a:extLst>
          </p:cNvPr>
          <p:cNvSpPr txBox="1"/>
          <p:nvPr/>
        </p:nvSpPr>
        <p:spPr>
          <a:xfrm>
            <a:off x="802215" y="400265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B1581D7-D1CB-56F3-5E69-FC139F36D18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33" t="8772" r="1528" b="24823"/>
          <a:stretch/>
        </p:blipFill>
        <p:spPr>
          <a:xfrm>
            <a:off x="218977" y="708042"/>
            <a:ext cx="3819623" cy="15280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627163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">
            <a:extLst>
              <a:ext uri="{FF2B5EF4-FFF2-40B4-BE49-F238E27FC236}">
                <a16:creationId xmlns:a16="http://schemas.microsoft.com/office/drawing/2014/main" id="{DA44A8D5-2F0B-73B4-EED7-4D549BEEBDCA}"/>
              </a:ext>
            </a:extLst>
          </p:cNvPr>
          <p:cNvSpPr txBox="1"/>
          <p:nvPr/>
        </p:nvSpPr>
        <p:spPr>
          <a:xfrm>
            <a:off x="4359128" y="307725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2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A65AE35-BA53-206E-7DF9-EEB68A5F411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002" t="35030" r="42636" b="13377"/>
          <a:stretch/>
        </p:blipFill>
        <p:spPr>
          <a:xfrm>
            <a:off x="3648791" y="810027"/>
            <a:ext cx="5066951" cy="389425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15B870A-90FB-CCB8-717F-9A37BCCA8747}"/>
              </a:ext>
            </a:extLst>
          </p:cNvPr>
          <p:cNvSpPr txBox="1"/>
          <p:nvPr/>
        </p:nvSpPr>
        <p:spPr>
          <a:xfrm>
            <a:off x="2231471" y="5624602"/>
            <a:ext cx="53018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Q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SQVPPRSG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LR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24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LLGCCVG</a:t>
            </a:r>
            <a:endParaRPr lang="da-DK" dirty="0"/>
          </a:p>
        </p:txBody>
      </p:sp>
      <p:sp>
        <p:nvSpPr>
          <p:cNvPr id="7" name="Rektangel 27">
            <a:extLst>
              <a:ext uri="{FF2B5EF4-FFF2-40B4-BE49-F238E27FC236}">
                <a16:creationId xmlns:a16="http://schemas.microsoft.com/office/drawing/2014/main" id="{EAA583FD-032C-D2DE-2AED-C76EA3C983AD}"/>
              </a:ext>
            </a:extLst>
          </p:cNvPr>
          <p:cNvSpPr/>
          <p:nvPr/>
        </p:nvSpPr>
        <p:spPr>
          <a:xfrm>
            <a:off x="5469621" y="5645467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50E6D383-EEDE-B286-5C84-53A0E5DA936E}"/>
              </a:ext>
            </a:extLst>
          </p:cNvPr>
          <p:cNvSpPr txBox="1"/>
          <p:nvPr/>
        </p:nvSpPr>
        <p:spPr>
          <a:xfrm>
            <a:off x="4593732" y="4063113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24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699B5DEB-C270-6B86-DF1C-93473CBCC9D0}"/>
              </a:ext>
            </a:extLst>
          </p:cNvPr>
          <p:cNvCxnSpPr>
            <a:cxnSpLocks/>
            <a:endCxn id="10" idx="3"/>
          </p:cNvCxnSpPr>
          <p:nvPr/>
        </p:nvCxnSpPr>
        <p:spPr>
          <a:xfrm flipV="1">
            <a:off x="5444890" y="2947757"/>
            <a:ext cx="1024575" cy="111627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0636E11E-E1B0-63DE-483E-CDA73480AB8E}"/>
              </a:ext>
            </a:extLst>
          </p:cNvPr>
          <p:cNvSpPr/>
          <p:nvPr/>
        </p:nvSpPr>
        <p:spPr>
          <a:xfrm>
            <a:off x="6407176" y="2665960"/>
            <a:ext cx="425335" cy="330146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E6DAC0E1-9484-0933-CF7B-A2A972B9B731}"/>
              </a:ext>
            </a:extLst>
          </p:cNvPr>
          <p:cNvSpPr/>
          <p:nvPr/>
        </p:nvSpPr>
        <p:spPr>
          <a:xfrm rot="21423043">
            <a:off x="6678006" y="2288372"/>
            <a:ext cx="1487024" cy="895846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1765F9A1-2318-8835-798C-3773FFE18407}"/>
              </a:ext>
            </a:extLst>
          </p:cNvPr>
          <p:cNvSpPr txBox="1"/>
          <p:nvPr/>
        </p:nvSpPr>
        <p:spPr>
          <a:xfrm>
            <a:off x="8025183" y="3382769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89A45EA1-D64C-7E7C-8BF5-42CE463EC69C}"/>
              </a:ext>
            </a:extLst>
          </p:cNvPr>
          <p:cNvCxnSpPr>
            <a:cxnSpLocks/>
          </p:cNvCxnSpPr>
          <p:nvPr/>
        </p:nvCxnSpPr>
        <p:spPr>
          <a:xfrm flipH="1" flipV="1">
            <a:off x="7971365" y="3053520"/>
            <a:ext cx="822121" cy="336719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30E62F21-FC7C-4732-E4BD-7A64062EE05C}"/>
              </a:ext>
            </a:extLst>
          </p:cNvPr>
          <p:cNvSpPr txBox="1"/>
          <p:nvPr/>
        </p:nvSpPr>
        <p:spPr>
          <a:xfrm>
            <a:off x="936309" y="446819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7946A3D-33F1-3F44-217C-881494307BA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00" t="8743" r="2445" b="42122"/>
          <a:stretch/>
        </p:blipFill>
        <p:spPr>
          <a:xfrm>
            <a:off x="42987" y="756443"/>
            <a:ext cx="4221480" cy="12519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295820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0C9CCE9-19F8-D0F7-47F3-8CFCC2DA19A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801" t="31590" r="38941" b="15409"/>
          <a:stretch/>
        </p:blipFill>
        <p:spPr>
          <a:xfrm>
            <a:off x="2762984" y="760088"/>
            <a:ext cx="5637401" cy="382982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009E10-9C33-68B5-1C14-D640117A2595}"/>
              </a:ext>
            </a:extLst>
          </p:cNvPr>
          <p:cNvSpPr txBox="1"/>
          <p:nvPr/>
        </p:nvSpPr>
        <p:spPr>
          <a:xfrm>
            <a:off x="4379661" y="216950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2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DEC9AF-856F-3CC3-9711-7B4FCFAA6275}"/>
              </a:ext>
            </a:extLst>
          </p:cNvPr>
          <p:cNvSpPr txBox="1"/>
          <p:nvPr/>
        </p:nvSpPr>
        <p:spPr>
          <a:xfrm>
            <a:off x="2339829" y="5599544"/>
            <a:ext cx="52263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D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AIPRTA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RK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9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I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</a:t>
            </a:r>
            <a:endParaRPr lang="da-DK" dirty="0"/>
          </a:p>
        </p:txBody>
      </p:sp>
      <p:sp>
        <p:nvSpPr>
          <p:cNvPr id="7" name="Rektangel 27">
            <a:extLst>
              <a:ext uri="{FF2B5EF4-FFF2-40B4-BE49-F238E27FC236}">
                <a16:creationId xmlns:a16="http://schemas.microsoft.com/office/drawing/2014/main" id="{0B41A670-5D2D-3150-6B4F-B2863F389AC1}"/>
              </a:ext>
            </a:extLst>
          </p:cNvPr>
          <p:cNvSpPr/>
          <p:nvPr/>
        </p:nvSpPr>
        <p:spPr>
          <a:xfrm>
            <a:off x="5520304" y="5620409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A26C5E5A-BAFF-C166-7007-382EBC22DB00}"/>
              </a:ext>
            </a:extLst>
          </p:cNvPr>
          <p:cNvSpPr txBox="1"/>
          <p:nvPr/>
        </p:nvSpPr>
        <p:spPr>
          <a:xfrm>
            <a:off x="3707924" y="4554997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39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E6A806FA-7D5A-749F-CBBF-169CA6056C82}"/>
              </a:ext>
            </a:extLst>
          </p:cNvPr>
          <p:cNvCxnSpPr>
            <a:cxnSpLocks/>
            <a:endCxn id="10" idx="3"/>
          </p:cNvCxnSpPr>
          <p:nvPr/>
        </p:nvCxnSpPr>
        <p:spPr>
          <a:xfrm flipV="1">
            <a:off x="4559082" y="3439641"/>
            <a:ext cx="1024575" cy="111627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13BFA873-0D89-03DE-BF01-302DE6202020}"/>
              </a:ext>
            </a:extLst>
          </p:cNvPr>
          <p:cNvSpPr/>
          <p:nvPr/>
        </p:nvSpPr>
        <p:spPr>
          <a:xfrm>
            <a:off x="5521368" y="3157844"/>
            <a:ext cx="425335" cy="330146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FDE79D31-D743-7D36-3A3B-CFB1E3545F3A}"/>
              </a:ext>
            </a:extLst>
          </p:cNvPr>
          <p:cNvSpPr/>
          <p:nvPr/>
        </p:nvSpPr>
        <p:spPr>
          <a:xfrm rot="21423043">
            <a:off x="5792198" y="2780256"/>
            <a:ext cx="1487024" cy="895846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08610E49-D050-5365-76E0-C31481CAC591}"/>
              </a:ext>
            </a:extLst>
          </p:cNvPr>
          <p:cNvSpPr txBox="1"/>
          <p:nvPr/>
        </p:nvSpPr>
        <p:spPr>
          <a:xfrm>
            <a:off x="7692238" y="3632588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E1E29E65-470A-E13D-0904-56043BB1A933}"/>
              </a:ext>
            </a:extLst>
          </p:cNvPr>
          <p:cNvCxnSpPr>
            <a:cxnSpLocks/>
          </p:cNvCxnSpPr>
          <p:nvPr/>
        </p:nvCxnSpPr>
        <p:spPr>
          <a:xfrm flipH="1" flipV="1">
            <a:off x="7085557" y="3545404"/>
            <a:ext cx="822121" cy="336719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Left Brace 13">
            <a:extLst>
              <a:ext uri="{FF2B5EF4-FFF2-40B4-BE49-F238E27FC236}">
                <a16:creationId xmlns:a16="http://schemas.microsoft.com/office/drawing/2014/main" id="{B4413D59-9917-2EAC-B3B8-F1C31604846F}"/>
              </a:ext>
            </a:extLst>
          </p:cNvPr>
          <p:cNvSpPr/>
          <p:nvPr/>
        </p:nvSpPr>
        <p:spPr>
          <a:xfrm>
            <a:off x="5583657" y="1710305"/>
            <a:ext cx="186479" cy="570452"/>
          </a:xfrm>
          <a:prstGeom prst="lef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5" name="Tekstfelt 17">
            <a:extLst>
              <a:ext uri="{FF2B5EF4-FFF2-40B4-BE49-F238E27FC236}">
                <a16:creationId xmlns:a16="http://schemas.microsoft.com/office/drawing/2014/main" id="{6B78F6E4-18AD-475E-E5E5-718992EBC339}"/>
              </a:ext>
            </a:extLst>
          </p:cNvPr>
          <p:cNvSpPr txBox="1"/>
          <p:nvPr/>
        </p:nvSpPr>
        <p:spPr>
          <a:xfrm>
            <a:off x="4709865" y="1527655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/>
              <a:t>C</a:t>
            </a:r>
            <a:r>
              <a:rPr lang="da-DK" sz="1400" baseline="-25000" dirty="0"/>
              <a:t>245, 252</a:t>
            </a:r>
            <a:endParaRPr lang="da-DK" sz="1400" dirty="0"/>
          </a:p>
        </p:txBody>
      </p:sp>
      <p:cxnSp>
        <p:nvCxnSpPr>
          <p:cNvPr id="16" name="Lige pilforbindelse 19">
            <a:extLst>
              <a:ext uri="{FF2B5EF4-FFF2-40B4-BE49-F238E27FC236}">
                <a16:creationId xmlns:a16="http://schemas.microsoft.com/office/drawing/2014/main" id="{ECB193C8-E934-0F0E-261F-BB780A470496}"/>
              </a:ext>
            </a:extLst>
          </p:cNvPr>
          <p:cNvCxnSpPr>
            <a:cxnSpLocks/>
          </p:cNvCxnSpPr>
          <p:nvPr/>
        </p:nvCxnSpPr>
        <p:spPr>
          <a:xfrm>
            <a:off x="5225502" y="1819443"/>
            <a:ext cx="295866" cy="176088"/>
          </a:xfrm>
          <a:prstGeom prst="straightConnector1">
            <a:avLst/>
          </a:prstGeom>
          <a:ln w="127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C5D1305A-05F7-2E91-193E-75988A30D093}"/>
              </a:ext>
            </a:extLst>
          </p:cNvPr>
          <p:cNvSpPr txBox="1"/>
          <p:nvPr/>
        </p:nvSpPr>
        <p:spPr>
          <a:xfrm>
            <a:off x="832593" y="452311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3FE6864-4E85-C9C6-1398-EFCEC29A6EA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23" t="9506" r="2381" b="41227"/>
          <a:stretch/>
        </p:blipFill>
        <p:spPr>
          <a:xfrm>
            <a:off x="83820" y="739223"/>
            <a:ext cx="4475262" cy="13330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9952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C35A8CC-B327-3F7C-33EE-E5148BAA7E7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307" t="36281" r="35808" b="19474"/>
          <a:stretch/>
        </p:blipFill>
        <p:spPr>
          <a:xfrm>
            <a:off x="1274809" y="1283514"/>
            <a:ext cx="6504284" cy="347304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52F7D63-CB46-6487-378C-86C7D8069B4B}"/>
              </a:ext>
            </a:extLst>
          </p:cNvPr>
          <p:cNvSpPr txBox="1"/>
          <p:nvPr/>
        </p:nvSpPr>
        <p:spPr>
          <a:xfrm>
            <a:off x="1867484" y="5744792"/>
            <a:ext cx="54088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KPDRAH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RKM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7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6" name="Rektangel 27">
            <a:extLst>
              <a:ext uri="{FF2B5EF4-FFF2-40B4-BE49-F238E27FC236}">
                <a16:creationId xmlns:a16="http://schemas.microsoft.com/office/drawing/2014/main" id="{D57F84B0-6941-885F-F872-00E848B39D90}"/>
              </a:ext>
            </a:extLst>
          </p:cNvPr>
          <p:cNvSpPr/>
          <p:nvPr/>
        </p:nvSpPr>
        <p:spPr>
          <a:xfrm>
            <a:off x="5083346" y="5771517"/>
            <a:ext cx="798022" cy="3426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7" name="TextBox 11">
            <a:extLst>
              <a:ext uri="{FF2B5EF4-FFF2-40B4-BE49-F238E27FC236}">
                <a16:creationId xmlns:a16="http://schemas.microsoft.com/office/drawing/2014/main" id="{1D1FB7C9-6362-1E6C-2DE0-BD37BE8A5469}"/>
              </a:ext>
            </a:extLst>
          </p:cNvPr>
          <p:cNvSpPr txBox="1"/>
          <p:nvPr/>
        </p:nvSpPr>
        <p:spPr>
          <a:xfrm>
            <a:off x="4254629" y="502850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3</a:t>
            </a:r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DF88D8E0-7DC1-151A-2E98-808FF20FA150}"/>
              </a:ext>
            </a:extLst>
          </p:cNvPr>
          <p:cNvSpPr txBox="1"/>
          <p:nvPr/>
        </p:nvSpPr>
        <p:spPr>
          <a:xfrm>
            <a:off x="5083346" y="4922127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57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0F25BCE2-C80B-67AC-8403-4783020C9DF5}"/>
              </a:ext>
            </a:extLst>
          </p:cNvPr>
          <p:cNvCxnSpPr/>
          <p:nvPr/>
        </p:nvCxnSpPr>
        <p:spPr>
          <a:xfrm flipH="1" flipV="1">
            <a:off x="4640887" y="3643754"/>
            <a:ext cx="977902" cy="1388225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88BBB0E6-3B9B-1BAC-FD02-0AF5A895ACC5}"/>
              </a:ext>
            </a:extLst>
          </p:cNvPr>
          <p:cNvSpPr/>
          <p:nvPr/>
        </p:nvSpPr>
        <p:spPr>
          <a:xfrm>
            <a:off x="4350829" y="3234350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09035754-EA79-AFCA-2E6D-CF38A9068352}"/>
              </a:ext>
            </a:extLst>
          </p:cNvPr>
          <p:cNvSpPr/>
          <p:nvPr/>
        </p:nvSpPr>
        <p:spPr>
          <a:xfrm>
            <a:off x="4715761" y="2916561"/>
            <a:ext cx="1575982" cy="1009487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B827D26A-8D0E-3293-E1BD-55A80570BE58}"/>
              </a:ext>
            </a:extLst>
          </p:cNvPr>
          <p:cNvSpPr txBox="1"/>
          <p:nvPr/>
        </p:nvSpPr>
        <p:spPr>
          <a:xfrm>
            <a:off x="7064402" y="1752161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F1C9F8C2-5675-49B7-C9EC-8AEC7C86985E}"/>
              </a:ext>
            </a:extLst>
          </p:cNvPr>
          <p:cNvCxnSpPr>
            <a:cxnSpLocks/>
          </p:cNvCxnSpPr>
          <p:nvPr/>
        </p:nvCxnSpPr>
        <p:spPr>
          <a:xfrm flipH="1">
            <a:off x="6291743" y="2675491"/>
            <a:ext cx="1889201" cy="678167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FCFE387-5446-2255-804B-C7EC2AE9BB52}"/>
              </a:ext>
            </a:extLst>
          </p:cNvPr>
          <p:cNvSpPr txBox="1"/>
          <p:nvPr/>
        </p:nvSpPr>
        <p:spPr>
          <a:xfrm>
            <a:off x="540069" y="431446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690F80A-1934-8A05-9B05-D5BC4ACAEC0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80" t="9241" r="2850" b="38130"/>
          <a:stretch/>
        </p:blipFill>
        <p:spPr>
          <a:xfrm>
            <a:off x="101162" y="739223"/>
            <a:ext cx="3767137" cy="12039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64314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69BB7E5-A5A3-F9C3-3CF2-C10CBCB261C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562" t="35412" r="41567" b="4778"/>
          <a:stretch/>
        </p:blipFill>
        <p:spPr>
          <a:xfrm>
            <a:off x="2080469" y="951662"/>
            <a:ext cx="4764947" cy="397139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AFD036F-4FE0-26A5-3AC8-16D33EB068DA}"/>
              </a:ext>
            </a:extLst>
          </p:cNvPr>
          <p:cNvSpPr txBox="1"/>
          <p:nvPr/>
        </p:nvSpPr>
        <p:spPr>
          <a:xfrm>
            <a:off x="2080469" y="5537006"/>
            <a:ext cx="52850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T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LRKPARSK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L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HR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79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WV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</a:t>
            </a:r>
            <a:endParaRPr lang="da-DK" dirty="0"/>
          </a:p>
        </p:txBody>
      </p:sp>
      <p:sp>
        <p:nvSpPr>
          <p:cNvPr id="6" name="Rektangel 27">
            <a:extLst>
              <a:ext uri="{FF2B5EF4-FFF2-40B4-BE49-F238E27FC236}">
                <a16:creationId xmlns:a16="http://schemas.microsoft.com/office/drawing/2014/main" id="{81200004-2C3A-B135-CEEC-5B59A74E8062}"/>
              </a:ext>
            </a:extLst>
          </p:cNvPr>
          <p:cNvSpPr/>
          <p:nvPr/>
        </p:nvSpPr>
        <p:spPr>
          <a:xfrm>
            <a:off x="5314425" y="5556124"/>
            <a:ext cx="79802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7" name="TextBox 11">
            <a:extLst>
              <a:ext uri="{FF2B5EF4-FFF2-40B4-BE49-F238E27FC236}">
                <a16:creationId xmlns:a16="http://schemas.microsoft.com/office/drawing/2014/main" id="{053D151F-BA7E-C25E-CD59-659E8F04F98C}"/>
              </a:ext>
            </a:extLst>
          </p:cNvPr>
          <p:cNvSpPr txBox="1"/>
          <p:nvPr/>
        </p:nvSpPr>
        <p:spPr>
          <a:xfrm>
            <a:off x="4257762" y="365556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</a:t>
            </a:r>
            <a:r>
              <a:rPr lang="da-DK" b="1" dirty="0">
                <a:solidFill>
                  <a:srgbClr val="0A0A0A"/>
                </a:solidFill>
                <a:latin typeface="IBM Plex Sans" panose="020B0503050203000203" pitchFamily="34" charset="0"/>
              </a:rPr>
              <a:t>4</a:t>
            </a:r>
            <a:endParaRPr lang="da-DK" b="1" i="0" dirty="0">
              <a:solidFill>
                <a:srgbClr val="0A0A0A"/>
              </a:solidFill>
              <a:effectLst/>
              <a:latin typeface="IBM Plex Sans" panose="020B0503050203000203" pitchFamily="34" charset="0"/>
            </a:endParaRPr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CBB41C35-B773-A4A8-D5C1-5AF2673E7C09}"/>
              </a:ext>
            </a:extLst>
          </p:cNvPr>
          <p:cNvSpPr txBox="1"/>
          <p:nvPr/>
        </p:nvSpPr>
        <p:spPr>
          <a:xfrm>
            <a:off x="6254335" y="4239129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79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6D2E644F-B4D9-0335-2439-331B049C1CDF}"/>
              </a:ext>
            </a:extLst>
          </p:cNvPr>
          <p:cNvCxnSpPr/>
          <p:nvPr/>
        </p:nvCxnSpPr>
        <p:spPr>
          <a:xfrm flipH="1" flipV="1">
            <a:off x="5558343" y="2880671"/>
            <a:ext cx="977902" cy="1388225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9E1ED080-9E0A-9871-9319-D5D2F44A43AC}"/>
              </a:ext>
            </a:extLst>
          </p:cNvPr>
          <p:cNvSpPr/>
          <p:nvPr/>
        </p:nvSpPr>
        <p:spPr>
          <a:xfrm>
            <a:off x="5235762" y="2479537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67C1ACF3-BAB9-EB74-4502-9CFDEDB47370}"/>
              </a:ext>
            </a:extLst>
          </p:cNvPr>
          <p:cNvSpPr/>
          <p:nvPr/>
        </p:nvSpPr>
        <p:spPr>
          <a:xfrm>
            <a:off x="5448430" y="2590575"/>
            <a:ext cx="1212199" cy="788881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2DAA1292-DC55-58F6-474C-1F6B6962F85B}"/>
              </a:ext>
            </a:extLst>
          </p:cNvPr>
          <p:cNvSpPr txBox="1"/>
          <p:nvPr/>
        </p:nvSpPr>
        <p:spPr>
          <a:xfrm>
            <a:off x="7285571" y="2014028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38C214E6-B51F-5ABF-7089-327A68289376}"/>
              </a:ext>
            </a:extLst>
          </p:cNvPr>
          <p:cNvCxnSpPr>
            <a:cxnSpLocks/>
          </p:cNvCxnSpPr>
          <p:nvPr/>
        </p:nvCxnSpPr>
        <p:spPr>
          <a:xfrm flipH="1">
            <a:off x="6652241" y="2526359"/>
            <a:ext cx="839128" cy="322739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00726100-AB9C-F376-7F92-FE8F2F31DF39}"/>
              </a:ext>
            </a:extLst>
          </p:cNvPr>
          <p:cNvSpPr txBox="1"/>
          <p:nvPr/>
        </p:nvSpPr>
        <p:spPr>
          <a:xfrm>
            <a:off x="440017" y="2937358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364EA77-6193-0AD3-60A1-404BC6E5883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22" t="10132" r="1889" b="32101"/>
          <a:stretch/>
        </p:blipFill>
        <p:spPr>
          <a:xfrm>
            <a:off x="166650" y="3287935"/>
            <a:ext cx="4276794" cy="1486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67488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717FF546-92D6-4980-D0BC-8BA65E6DC0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465" t="39239" r="41363" b="14514"/>
          <a:stretch/>
        </p:blipFill>
        <p:spPr>
          <a:xfrm>
            <a:off x="2941885" y="836989"/>
            <a:ext cx="6317930" cy="4631552"/>
          </a:xfrm>
          <a:prstGeom prst="rect">
            <a:avLst/>
          </a:prstGeom>
        </p:spPr>
      </p:pic>
      <p:pic>
        <p:nvPicPr>
          <p:cNvPr id="2" name="Picture 13">
            <a:extLst>
              <a:ext uri="{FF2B5EF4-FFF2-40B4-BE49-F238E27FC236}">
                <a16:creationId xmlns:a16="http://schemas.microsoft.com/office/drawing/2014/main" id="{7A670AD5-274B-E995-82F3-A1E90E78F91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458" t="34673" r="43514" b="2593"/>
          <a:stretch/>
        </p:blipFill>
        <p:spPr>
          <a:xfrm>
            <a:off x="1775452" y="1024628"/>
            <a:ext cx="1846407" cy="1874815"/>
          </a:xfrm>
          <a:prstGeom prst="rect">
            <a:avLst/>
          </a:prstGeom>
        </p:spPr>
      </p:pic>
      <p:sp>
        <p:nvSpPr>
          <p:cNvPr id="3" name="TextBox 11">
            <a:extLst>
              <a:ext uri="{FF2B5EF4-FFF2-40B4-BE49-F238E27FC236}">
                <a16:creationId xmlns:a16="http://schemas.microsoft.com/office/drawing/2014/main" id="{95361C0C-B409-8CAB-9853-AF321D8E76BA}"/>
              </a:ext>
            </a:extLst>
          </p:cNvPr>
          <p:cNvSpPr txBox="1"/>
          <p:nvPr/>
        </p:nvSpPr>
        <p:spPr>
          <a:xfrm>
            <a:off x="4210657" y="250132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5</a:t>
            </a:r>
          </a:p>
        </p:txBody>
      </p:sp>
      <p:sp>
        <p:nvSpPr>
          <p:cNvPr id="4" name="TextBox 14">
            <a:extLst>
              <a:ext uri="{FF2B5EF4-FFF2-40B4-BE49-F238E27FC236}">
                <a16:creationId xmlns:a16="http://schemas.microsoft.com/office/drawing/2014/main" id="{79E8B1DA-C784-A792-2E03-32159EDAFE66}"/>
              </a:ext>
            </a:extLst>
          </p:cNvPr>
          <p:cNvSpPr txBox="1"/>
          <p:nvPr/>
        </p:nvSpPr>
        <p:spPr>
          <a:xfrm>
            <a:off x="1192828" y="912876"/>
            <a:ext cx="979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/>
              <a:t>C</a:t>
            </a:r>
            <a:r>
              <a:rPr lang="da-DK" sz="1000" baseline="-25000" dirty="0"/>
              <a:t>236</a:t>
            </a:r>
            <a:r>
              <a:rPr lang="da-DK" sz="1000" dirty="0"/>
              <a:t>C</a:t>
            </a:r>
            <a:r>
              <a:rPr lang="da-DK" sz="1000" baseline="-25000" dirty="0"/>
              <a:t>237</a:t>
            </a:r>
            <a:r>
              <a:rPr lang="da-DK" sz="1000" dirty="0"/>
              <a:t>-7x-C</a:t>
            </a:r>
            <a:r>
              <a:rPr lang="da-DK" sz="1000" baseline="-25000" dirty="0"/>
              <a:t>245</a:t>
            </a:r>
          </a:p>
        </p:txBody>
      </p:sp>
      <p:cxnSp>
        <p:nvCxnSpPr>
          <p:cNvPr id="5" name="Straight Arrow Connector 16">
            <a:extLst>
              <a:ext uri="{FF2B5EF4-FFF2-40B4-BE49-F238E27FC236}">
                <a16:creationId xmlns:a16="http://schemas.microsoft.com/office/drawing/2014/main" id="{B3A3E633-05CD-D133-2EB5-76D71F4DE574}"/>
              </a:ext>
            </a:extLst>
          </p:cNvPr>
          <p:cNvCxnSpPr>
            <a:cxnSpLocks/>
          </p:cNvCxnSpPr>
          <p:nvPr/>
        </p:nvCxnSpPr>
        <p:spPr>
          <a:xfrm>
            <a:off x="1902177" y="1176189"/>
            <a:ext cx="610481" cy="4720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247CFE31-60C6-323A-886C-D12BA77FC4E8}"/>
              </a:ext>
            </a:extLst>
          </p:cNvPr>
          <p:cNvSpPr txBox="1"/>
          <p:nvPr/>
        </p:nvSpPr>
        <p:spPr>
          <a:xfrm>
            <a:off x="1929035" y="5717140"/>
            <a:ext cx="62246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FYRPP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E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4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</a:t>
            </a:r>
            <a:endParaRPr lang="da-DK" dirty="0"/>
          </a:p>
        </p:txBody>
      </p:sp>
      <p:sp>
        <p:nvSpPr>
          <p:cNvPr id="12" name="Rektangel 27">
            <a:extLst>
              <a:ext uri="{FF2B5EF4-FFF2-40B4-BE49-F238E27FC236}">
                <a16:creationId xmlns:a16="http://schemas.microsoft.com/office/drawing/2014/main" id="{C6563054-4A10-397F-7C43-316C8FC5EF96}"/>
              </a:ext>
            </a:extLst>
          </p:cNvPr>
          <p:cNvSpPr/>
          <p:nvPr/>
        </p:nvSpPr>
        <p:spPr>
          <a:xfrm>
            <a:off x="5219893" y="5717140"/>
            <a:ext cx="798022" cy="3588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5" name="Tekstfelt 17">
            <a:extLst>
              <a:ext uri="{FF2B5EF4-FFF2-40B4-BE49-F238E27FC236}">
                <a16:creationId xmlns:a16="http://schemas.microsoft.com/office/drawing/2014/main" id="{F1216898-96D6-D39B-4E7B-27902099443C}"/>
              </a:ext>
            </a:extLst>
          </p:cNvPr>
          <p:cNvSpPr txBox="1"/>
          <p:nvPr/>
        </p:nvSpPr>
        <p:spPr>
          <a:xfrm>
            <a:off x="6694088" y="4764544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34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6" name="Lige pilforbindelse 19">
            <a:extLst>
              <a:ext uri="{FF2B5EF4-FFF2-40B4-BE49-F238E27FC236}">
                <a16:creationId xmlns:a16="http://schemas.microsoft.com/office/drawing/2014/main" id="{F33E079A-7776-4510-9C7A-5226FAF660BF}"/>
              </a:ext>
            </a:extLst>
          </p:cNvPr>
          <p:cNvCxnSpPr/>
          <p:nvPr/>
        </p:nvCxnSpPr>
        <p:spPr>
          <a:xfrm flipH="1" flipV="1">
            <a:off x="5998096" y="3406086"/>
            <a:ext cx="977902" cy="1388225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Ellipse 20">
            <a:extLst>
              <a:ext uri="{FF2B5EF4-FFF2-40B4-BE49-F238E27FC236}">
                <a16:creationId xmlns:a16="http://schemas.microsoft.com/office/drawing/2014/main" id="{94516012-0663-EAD0-7CAA-CC5B81239638}"/>
              </a:ext>
            </a:extLst>
          </p:cNvPr>
          <p:cNvSpPr/>
          <p:nvPr/>
        </p:nvSpPr>
        <p:spPr>
          <a:xfrm>
            <a:off x="5675515" y="3004952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8" name="Ellipse 23">
            <a:extLst>
              <a:ext uri="{FF2B5EF4-FFF2-40B4-BE49-F238E27FC236}">
                <a16:creationId xmlns:a16="http://schemas.microsoft.com/office/drawing/2014/main" id="{212C07D4-8BE7-1CEC-C566-D5FDB094DF7E}"/>
              </a:ext>
            </a:extLst>
          </p:cNvPr>
          <p:cNvSpPr/>
          <p:nvPr/>
        </p:nvSpPr>
        <p:spPr>
          <a:xfrm>
            <a:off x="5848091" y="2707052"/>
            <a:ext cx="845997" cy="574877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9" name="Tekstfelt 24">
            <a:extLst>
              <a:ext uri="{FF2B5EF4-FFF2-40B4-BE49-F238E27FC236}">
                <a16:creationId xmlns:a16="http://schemas.microsoft.com/office/drawing/2014/main" id="{C81E295E-A344-4E94-ED7C-FC172C770CCC}"/>
              </a:ext>
            </a:extLst>
          </p:cNvPr>
          <p:cNvSpPr txBox="1"/>
          <p:nvPr/>
        </p:nvSpPr>
        <p:spPr>
          <a:xfrm>
            <a:off x="7725324" y="2539443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20" name="Lige pilforbindelse 26">
            <a:extLst>
              <a:ext uri="{FF2B5EF4-FFF2-40B4-BE49-F238E27FC236}">
                <a16:creationId xmlns:a16="http://schemas.microsoft.com/office/drawing/2014/main" id="{11F83475-4A46-E2EF-124C-85B8E01D9104}"/>
              </a:ext>
            </a:extLst>
          </p:cNvPr>
          <p:cNvCxnSpPr>
            <a:cxnSpLocks/>
            <a:endCxn id="18" idx="6"/>
          </p:cNvCxnSpPr>
          <p:nvPr/>
        </p:nvCxnSpPr>
        <p:spPr>
          <a:xfrm flipH="1" flipV="1">
            <a:off x="6694088" y="2994491"/>
            <a:ext cx="1237034" cy="57283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E37D4992-F3D4-D360-632C-BF3806411779}"/>
              </a:ext>
            </a:extLst>
          </p:cNvPr>
          <p:cNvSpPr txBox="1"/>
          <p:nvPr/>
        </p:nvSpPr>
        <p:spPr>
          <a:xfrm>
            <a:off x="603682" y="3087686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82C7DAC-4CB5-9ED6-CE15-96E6C0007AB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00" t="9469" r="2890" b="8933"/>
          <a:stretch/>
        </p:blipFill>
        <p:spPr>
          <a:xfrm>
            <a:off x="0" y="3385771"/>
            <a:ext cx="3978655" cy="19686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53523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3856982-7B6E-6632-4FD7-E3AFBF5A5D5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982" t="37219" r="39281" b="13377"/>
          <a:stretch/>
        </p:blipFill>
        <p:spPr>
          <a:xfrm>
            <a:off x="2164273" y="566124"/>
            <a:ext cx="5259896" cy="393868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99E5376-4B99-F80C-7C6F-8C4CD5C16E04}"/>
              </a:ext>
            </a:extLst>
          </p:cNvPr>
          <p:cNvSpPr txBox="1"/>
          <p:nvPr/>
        </p:nvSpPr>
        <p:spPr>
          <a:xfrm>
            <a:off x="2046913" y="5600825"/>
            <a:ext cx="54947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AYKAPRSH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MKM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29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INNCCG</a:t>
            </a:r>
            <a:endParaRPr lang="da-DK" dirty="0"/>
          </a:p>
        </p:txBody>
      </p:sp>
      <p:sp>
        <p:nvSpPr>
          <p:cNvPr id="6" name="Rektangel 27">
            <a:extLst>
              <a:ext uri="{FF2B5EF4-FFF2-40B4-BE49-F238E27FC236}">
                <a16:creationId xmlns:a16="http://schemas.microsoft.com/office/drawing/2014/main" id="{B254AD9B-90DB-B6E6-5E25-1F2A06537B01}"/>
              </a:ext>
            </a:extLst>
          </p:cNvPr>
          <p:cNvSpPr/>
          <p:nvPr/>
        </p:nvSpPr>
        <p:spPr>
          <a:xfrm>
            <a:off x="5498982" y="5666002"/>
            <a:ext cx="798022" cy="27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7" name="TextBox 11">
            <a:extLst>
              <a:ext uri="{FF2B5EF4-FFF2-40B4-BE49-F238E27FC236}">
                <a16:creationId xmlns:a16="http://schemas.microsoft.com/office/drawing/2014/main" id="{B1B6493A-E35A-349D-A5AE-E9AA4D507726}"/>
              </a:ext>
            </a:extLst>
          </p:cNvPr>
          <p:cNvSpPr txBox="1"/>
          <p:nvPr/>
        </p:nvSpPr>
        <p:spPr>
          <a:xfrm>
            <a:off x="3706111" y="196792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6</a:t>
            </a:r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6FDEC5B6-66D3-2E5F-983A-0610ED9C3005}"/>
              </a:ext>
            </a:extLst>
          </p:cNvPr>
          <p:cNvSpPr txBox="1"/>
          <p:nvPr/>
        </p:nvSpPr>
        <p:spPr>
          <a:xfrm>
            <a:off x="5622376" y="3887753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29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29635BCA-C331-2E48-47B8-35D96D32F64C}"/>
              </a:ext>
            </a:extLst>
          </p:cNvPr>
          <p:cNvCxnSpPr/>
          <p:nvPr/>
        </p:nvCxnSpPr>
        <p:spPr>
          <a:xfrm flipH="1" flipV="1">
            <a:off x="4926384" y="2529295"/>
            <a:ext cx="977902" cy="1388225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77588AEB-5FC4-0765-7B4C-2CD1C2D154E4}"/>
              </a:ext>
            </a:extLst>
          </p:cNvPr>
          <p:cNvSpPr/>
          <p:nvPr/>
        </p:nvSpPr>
        <p:spPr>
          <a:xfrm>
            <a:off x="4603803" y="2128161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9C78A935-4AE8-954A-1A86-73601F90B31B}"/>
              </a:ext>
            </a:extLst>
          </p:cNvPr>
          <p:cNvSpPr/>
          <p:nvPr/>
        </p:nvSpPr>
        <p:spPr>
          <a:xfrm>
            <a:off x="4814435" y="1893449"/>
            <a:ext cx="1183606" cy="1006204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79863846-10C3-E118-8F42-E846F84F1098}"/>
              </a:ext>
            </a:extLst>
          </p:cNvPr>
          <p:cNvSpPr txBox="1"/>
          <p:nvPr/>
        </p:nvSpPr>
        <p:spPr>
          <a:xfrm>
            <a:off x="7317730" y="2238379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08C41F74-1E02-90C4-E37B-577A824AEDB1}"/>
              </a:ext>
            </a:extLst>
          </p:cNvPr>
          <p:cNvCxnSpPr>
            <a:cxnSpLocks/>
            <a:endCxn id="11" idx="6"/>
          </p:cNvCxnSpPr>
          <p:nvPr/>
        </p:nvCxnSpPr>
        <p:spPr>
          <a:xfrm flipH="1" flipV="1">
            <a:off x="5998041" y="2396551"/>
            <a:ext cx="1470627" cy="353314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ight Brace 15">
            <a:extLst>
              <a:ext uri="{FF2B5EF4-FFF2-40B4-BE49-F238E27FC236}">
                <a16:creationId xmlns:a16="http://schemas.microsoft.com/office/drawing/2014/main" id="{E357F945-B30B-0F94-0AE3-EF9A0587265F}"/>
              </a:ext>
            </a:extLst>
          </p:cNvPr>
          <p:cNvSpPr/>
          <p:nvPr/>
        </p:nvSpPr>
        <p:spPr>
          <a:xfrm rot="16200000">
            <a:off x="6149420" y="388229"/>
            <a:ext cx="268448" cy="1183606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075F0E0-9F49-930A-56E0-67A1981B22E6}"/>
              </a:ext>
            </a:extLst>
          </p:cNvPr>
          <p:cNvSpPr txBox="1"/>
          <p:nvPr/>
        </p:nvSpPr>
        <p:spPr>
          <a:xfrm>
            <a:off x="5871511" y="396002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/>
              <a:t>C</a:t>
            </a:r>
            <a:r>
              <a:rPr lang="da-DK" sz="1200" baseline="-25000" dirty="0"/>
              <a:t>328. 329, 34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3FA66AF-4709-C1BD-3893-ABC307A224C4}"/>
              </a:ext>
            </a:extLst>
          </p:cNvPr>
          <p:cNvSpPr txBox="1"/>
          <p:nvPr/>
        </p:nvSpPr>
        <p:spPr>
          <a:xfrm>
            <a:off x="5871511" y="565027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/>
              <a:t>C</a:t>
            </a:r>
            <a:r>
              <a:rPr lang="da-DK" sz="1200" baseline="-25000" dirty="0"/>
              <a:t>392. 396, 398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F320E8D-0C9E-B4D0-8597-E5E82C324ADA}"/>
              </a:ext>
            </a:extLst>
          </p:cNvPr>
          <p:cNvSpPr txBox="1"/>
          <p:nvPr/>
        </p:nvSpPr>
        <p:spPr>
          <a:xfrm>
            <a:off x="691534" y="3429000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037B785-9A90-917D-01ED-409E1CD7475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55" t="10430" r="1778" b="24110"/>
          <a:stretch/>
        </p:blipFill>
        <p:spPr>
          <a:xfrm>
            <a:off x="278673" y="3813998"/>
            <a:ext cx="3771201" cy="14883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0471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AEA94F7-1222-EA74-D23C-35E82C85419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901" t="39251" r="41397" b="14471"/>
          <a:stretch/>
        </p:blipFill>
        <p:spPr>
          <a:xfrm>
            <a:off x="1902203" y="879183"/>
            <a:ext cx="5863905" cy="379806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CDD3F72-529A-AA93-0B86-2783F9A4DFB7}"/>
              </a:ext>
            </a:extLst>
          </p:cNvPr>
          <p:cNvSpPr txBox="1"/>
          <p:nvPr/>
        </p:nvSpPr>
        <p:spPr>
          <a:xfrm>
            <a:off x="2292292" y="5507264"/>
            <a:ext cx="53249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K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C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KPERAH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RKM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60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N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6" name="Rektangel 27">
            <a:extLst>
              <a:ext uri="{FF2B5EF4-FFF2-40B4-BE49-F238E27FC236}">
                <a16:creationId xmlns:a16="http://schemas.microsoft.com/office/drawing/2014/main" id="{6556609A-479E-948C-C34E-9C6A470CC74D}"/>
              </a:ext>
            </a:extLst>
          </p:cNvPr>
          <p:cNvSpPr/>
          <p:nvPr/>
        </p:nvSpPr>
        <p:spPr>
          <a:xfrm>
            <a:off x="5423481" y="5587285"/>
            <a:ext cx="798022" cy="27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7" name="TextBox 11">
            <a:extLst>
              <a:ext uri="{FF2B5EF4-FFF2-40B4-BE49-F238E27FC236}">
                <a16:creationId xmlns:a16="http://schemas.microsoft.com/office/drawing/2014/main" id="{1240CEA9-641C-454D-23C1-C869935B3035}"/>
              </a:ext>
            </a:extLst>
          </p:cNvPr>
          <p:cNvSpPr txBox="1"/>
          <p:nvPr/>
        </p:nvSpPr>
        <p:spPr>
          <a:xfrm>
            <a:off x="4210657" y="250132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</a:t>
            </a:r>
            <a:r>
              <a:rPr lang="da-DK" b="1" dirty="0">
                <a:solidFill>
                  <a:srgbClr val="0A0A0A"/>
                </a:solidFill>
                <a:latin typeface="IBM Plex Sans" panose="020B0503050203000203" pitchFamily="34" charset="0"/>
              </a:rPr>
              <a:t>7</a:t>
            </a:r>
            <a:endParaRPr lang="da-DK" b="1" i="0" dirty="0">
              <a:solidFill>
                <a:srgbClr val="0A0A0A"/>
              </a:solidFill>
              <a:effectLst/>
              <a:latin typeface="IBM Plex Sans" panose="020B0503050203000203" pitchFamily="34" charset="0"/>
            </a:endParaRPr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AC794205-DD47-832D-E1D9-D3D5960D3EA1}"/>
              </a:ext>
            </a:extLst>
          </p:cNvPr>
          <p:cNvSpPr txBox="1"/>
          <p:nvPr/>
        </p:nvSpPr>
        <p:spPr>
          <a:xfrm>
            <a:off x="5731521" y="3916104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60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AF3059C1-4EA9-9705-F3F5-4E5DB6655DAB}"/>
              </a:ext>
            </a:extLst>
          </p:cNvPr>
          <p:cNvCxnSpPr/>
          <p:nvPr/>
        </p:nvCxnSpPr>
        <p:spPr>
          <a:xfrm flipH="1" flipV="1">
            <a:off x="5035529" y="2557646"/>
            <a:ext cx="977902" cy="1388225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420C9FEA-3149-9A91-D51D-7607B53CB0AB}"/>
              </a:ext>
            </a:extLst>
          </p:cNvPr>
          <p:cNvSpPr/>
          <p:nvPr/>
        </p:nvSpPr>
        <p:spPr>
          <a:xfrm>
            <a:off x="4712948" y="2156512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03C3EDAF-2505-FFF2-461E-2F19892D061A}"/>
              </a:ext>
            </a:extLst>
          </p:cNvPr>
          <p:cNvSpPr/>
          <p:nvPr/>
        </p:nvSpPr>
        <p:spPr>
          <a:xfrm>
            <a:off x="5034054" y="1763628"/>
            <a:ext cx="1183606" cy="1006204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CDD5852B-8F87-4D5A-85E0-EA894B2ECE65}"/>
              </a:ext>
            </a:extLst>
          </p:cNvPr>
          <p:cNvSpPr txBox="1"/>
          <p:nvPr/>
        </p:nvSpPr>
        <p:spPr>
          <a:xfrm>
            <a:off x="7426875" y="2266730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9D72BF28-6E7B-57DF-C0E7-0640D5319757}"/>
              </a:ext>
            </a:extLst>
          </p:cNvPr>
          <p:cNvCxnSpPr>
            <a:cxnSpLocks/>
            <a:endCxn id="11" idx="6"/>
          </p:cNvCxnSpPr>
          <p:nvPr/>
        </p:nvCxnSpPr>
        <p:spPr>
          <a:xfrm flipH="1" flipV="1">
            <a:off x="6217660" y="2266730"/>
            <a:ext cx="1470627" cy="353314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59619311-EB08-D154-667E-1C30E06B5E98}"/>
              </a:ext>
            </a:extLst>
          </p:cNvPr>
          <p:cNvSpPr txBox="1"/>
          <p:nvPr/>
        </p:nvSpPr>
        <p:spPr>
          <a:xfrm>
            <a:off x="701906" y="571406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0BE3299-2C25-56F5-8A3F-4F854F55594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00" t="9570" r="2111" b="30325"/>
          <a:stretch/>
        </p:blipFill>
        <p:spPr>
          <a:xfrm>
            <a:off x="157712" y="879183"/>
            <a:ext cx="3585613" cy="1296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7935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FF5B96C-71E8-5C09-03A5-4577D9F3EA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022" t="28620" r="41476" b="10626"/>
          <a:stretch/>
        </p:blipFill>
        <p:spPr>
          <a:xfrm>
            <a:off x="2158069" y="678512"/>
            <a:ext cx="5721991" cy="453707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F4E907C-C262-735B-EE2E-97AA5AFA1FEF}"/>
              </a:ext>
            </a:extLst>
          </p:cNvPr>
          <p:cNvSpPr txBox="1"/>
          <p:nvPr/>
        </p:nvSpPr>
        <p:spPr>
          <a:xfrm>
            <a:off x="2158069" y="5536626"/>
            <a:ext cx="52997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FYRPPR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V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NCVED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4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NNCIG</a:t>
            </a:r>
            <a:endParaRPr lang="da-DK" dirty="0"/>
          </a:p>
        </p:txBody>
      </p:sp>
      <p:sp>
        <p:nvSpPr>
          <p:cNvPr id="6" name="Rektangel 27">
            <a:extLst>
              <a:ext uri="{FF2B5EF4-FFF2-40B4-BE49-F238E27FC236}">
                <a16:creationId xmlns:a16="http://schemas.microsoft.com/office/drawing/2014/main" id="{963880FE-A079-4BFF-8EAB-B2E3AC080340}"/>
              </a:ext>
            </a:extLst>
          </p:cNvPr>
          <p:cNvSpPr/>
          <p:nvPr/>
        </p:nvSpPr>
        <p:spPr>
          <a:xfrm>
            <a:off x="5490593" y="5595674"/>
            <a:ext cx="798022" cy="27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7" name="TextBox 11">
            <a:extLst>
              <a:ext uri="{FF2B5EF4-FFF2-40B4-BE49-F238E27FC236}">
                <a16:creationId xmlns:a16="http://schemas.microsoft.com/office/drawing/2014/main" id="{F13B9EFC-3ACF-1AA5-EE40-6988806F7981}"/>
              </a:ext>
            </a:extLst>
          </p:cNvPr>
          <p:cNvSpPr txBox="1"/>
          <p:nvPr/>
        </p:nvSpPr>
        <p:spPr>
          <a:xfrm>
            <a:off x="4210657" y="250132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8</a:t>
            </a:r>
          </a:p>
        </p:txBody>
      </p:sp>
      <p:sp>
        <p:nvSpPr>
          <p:cNvPr id="8" name="Tekstfelt 17">
            <a:extLst>
              <a:ext uri="{FF2B5EF4-FFF2-40B4-BE49-F238E27FC236}">
                <a16:creationId xmlns:a16="http://schemas.microsoft.com/office/drawing/2014/main" id="{8CE0DF08-0D87-7905-776C-D29CF10DEF30}"/>
              </a:ext>
            </a:extLst>
          </p:cNvPr>
          <p:cNvSpPr txBox="1"/>
          <p:nvPr/>
        </p:nvSpPr>
        <p:spPr>
          <a:xfrm>
            <a:off x="4431457" y="4780643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34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9" name="Lige pilforbindelse 19">
            <a:extLst>
              <a:ext uri="{FF2B5EF4-FFF2-40B4-BE49-F238E27FC236}">
                <a16:creationId xmlns:a16="http://schemas.microsoft.com/office/drawing/2014/main" id="{8A7CCD11-C661-08CF-BD68-CCDDB9CD87BB}"/>
              </a:ext>
            </a:extLst>
          </p:cNvPr>
          <p:cNvCxnSpPr>
            <a:cxnSpLocks/>
          </p:cNvCxnSpPr>
          <p:nvPr/>
        </p:nvCxnSpPr>
        <p:spPr>
          <a:xfrm flipV="1">
            <a:off x="5045275" y="3015328"/>
            <a:ext cx="239172" cy="1765315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Ellipse 20">
            <a:extLst>
              <a:ext uri="{FF2B5EF4-FFF2-40B4-BE49-F238E27FC236}">
                <a16:creationId xmlns:a16="http://schemas.microsoft.com/office/drawing/2014/main" id="{6951EC2E-ACB3-4BA3-B104-604C7D6FEBE8}"/>
              </a:ext>
            </a:extLst>
          </p:cNvPr>
          <p:cNvSpPr/>
          <p:nvPr/>
        </p:nvSpPr>
        <p:spPr>
          <a:xfrm>
            <a:off x="5071780" y="2610059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Ellipse 23">
            <a:extLst>
              <a:ext uri="{FF2B5EF4-FFF2-40B4-BE49-F238E27FC236}">
                <a16:creationId xmlns:a16="http://schemas.microsoft.com/office/drawing/2014/main" id="{25F4C66E-DB4E-A6F0-A29A-C39579D11187}"/>
              </a:ext>
            </a:extLst>
          </p:cNvPr>
          <p:cNvSpPr/>
          <p:nvPr/>
        </p:nvSpPr>
        <p:spPr>
          <a:xfrm>
            <a:off x="5135551" y="2686144"/>
            <a:ext cx="1183606" cy="1006204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Tekstfelt 24">
            <a:extLst>
              <a:ext uri="{FF2B5EF4-FFF2-40B4-BE49-F238E27FC236}">
                <a16:creationId xmlns:a16="http://schemas.microsoft.com/office/drawing/2014/main" id="{B5D40BCD-3C46-6930-D504-A75D1951BF82}"/>
              </a:ext>
            </a:extLst>
          </p:cNvPr>
          <p:cNvSpPr txBox="1"/>
          <p:nvPr/>
        </p:nvSpPr>
        <p:spPr>
          <a:xfrm>
            <a:off x="7550563" y="3107670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3" name="Lige pilforbindelse 26">
            <a:extLst>
              <a:ext uri="{FF2B5EF4-FFF2-40B4-BE49-F238E27FC236}">
                <a16:creationId xmlns:a16="http://schemas.microsoft.com/office/drawing/2014/main" id="{8B99670F-D712-D7F5-319D-7003E15D443A}"/>
              </a:ext>
            </a:extLst>
          </p:cNvPr>
          <p:cNvCxnSpPr>
            <a:cxnSpLocks/>
            <a:endCxn id="11" idx="6"/>
          </p:cNvCxnSpPr>
          <p:nvPr/>
        </p:nvCxnSpPr>
        <p:spPr>
          <a:xfrm flipH="1" flipV="1">
            <a:off x="6319157" y="3189246"/>
            <a:ext cx="1470627" cy="353314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831BDECC-1173-B29E-739F-1429DC6CFD19}"/>
              </a:ext>
            </a:extLst>
          </p:cNvPr>
          <p:cNvSpPr txBox="1"/>
          <p:nvPr/>
        </p:nvSpPr>
        <p:spPr>
          <a:xfrm>
            <a:off x="540069" y="431446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71C1CCF-3E0A-B166-9EB7-94190E1577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50" t="10135" r="1945" b="6932"/>
          <a:stretch/>
        </p:blipFill>
        <p:spPr>
          <a:xfrm>
            <a:off x="14944" y="748661"/>
            <a:ext cx="3728145" cy="1861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20086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C48CDBE8-A433-02CD-3211-E6C9D42F86C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768" t="32059" r="41375" b="1483"/>
          <a:stretch/>
        </p:blipFill>
        <p:spPr>
          <a:xfrm>
            <a:off x="2564898" y="1542100"/>
            <a:ext cx="4146295" cy="3566035"/>
          </a:xfrm>
          <a:prstGeom prst="rect">
            <a:avLst/>
          </a:prstGeom>
        </p:spPr>
      </p:pic>
      <p:sp>
        <p:nvSpPr>
          <p:cNvPr id="3" name="TextBox 10">
            <a:extLst>
              <a:ext uri="{FF2B5EF4-FFF2-40B4-BE49-F238E27FC236}">
                <a16:creationId xmlns:a16="http://schemas.microsoft.com/office/drawing/2014/main" id="{589604F8-686A-4A5D-4996-E0F8CC8DD6C9}"/>
              </a:ext>
            </a:extLst>
          </p:cNvPr>
          <p:cNvSpPr txBox="1"/>
          <p:nvPr/>
        </p:nvSpPr>
        <p:spPr>
          <a:xfrm>
            <a:off x="4457184" y="208026"/>
            <a:ext cx="13904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a-DK" b="1" i="0" dirty="0">
                <a:solidFill>
                  <a:srgbClr val="0A0A0A"/>
                </a:solidFill>
                <a:effectLst/>
                <a:latin typeface="IBM Plex Sans" panose="020B0503050203000203" pitchFamily="34" charset="0"/>
              </a:rPr>
              <a:t>zDHHC9</a:t>
            </a:r>
          </a:p>
        </p:txBody>
      </p:sp>
      <p:sp>
        <p:nvSpPr>
          <p:cNvPr id="4" name="TextBox 17">
            <a:extLst>
              <a:ext uri="{FF2B5EF4-FFF2-40B4-BE49-F238E27FC236}">
                <a16:creationId xmlns:a16="http://schemas.microsoft.com/office/drawing/2014/main" id="{DD7C68A3-7BCA-25C1-B327-C0CFB9604ACD}"/>
              </a:ext>
            </a:extLst>
          </p:cNvPr>
          <p:cNvSpPr txBox="1"/>
          <p:nvPr/>
        </p:nvSpPr>
        <p:spPr>
          <a:xfrm>
            <a:off x="4346376" y="1178665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/>
              <a:t>C</a:t>
            </a:r>
            <a:r>
              <a:rPr lang="da-DK" sz="1200" baseline="-25000" dirty="0"/>
              <a:t>283</a:t>
            </a:r>
            <a:r>
              <a:rPr lang="da-DK" sz="1200" dirty="0"/>
              <a:t>C</a:t>
            </a:r>
            <a:r>
              <a:rPr lang="da-DK" sz="1200" baseline="-25000" dirty="0"/>
              <a:t>284</a:t>
            </a:r>
            <a:r>
              <a:rPr lang="da-DK" sz="1200" dirty="0"/>
              <a:t>-3x-C</a:t>
            </a:r>
            <a:r>
              <a:rPr lang="da-DK" sz="1200" baseline="-25000" dirty="0"/>
              <a:t>288</a:t>
            </a:r>
          </a:p>
        </p:txBody>
      </p:sp>
      <p:cxnSp>
        <p:nvCxnSpPr>
          <p:cNvPr id="5" name="Straight Arrow Connector 18">
            <a:extLst>
              <a:ext uri="{FF2B5EF4-FFF2-40B4-BE49-F238E27FC236}">
                <a16:creationId xmlns:a16="http://schemas.microsoft.com/office/drawing/2014/main" id="{351AE6AD-2F82-B849-B04D-799C84F8A66D}"/>
              </a:ext>
            </a:extLst>
          </p:cNvPr>
          <p:cNvCxnSpPr>
            <a:cxnSpLocks/>
            <a:stCxn id="4" idx="2"/>
          </p:cNvCxnSpPr>
          <p:nvPr/>
        </p:nvCxnSpPr>
        <p:spPr>
          <a:xfrm flipH="1">
            <a:off x="4766073" y="1455664"/>
            <a:ext cx="145522" cy="6834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28">
            <a:extLst>
              <a:ext uri="{FF2B5EF4-FFF2-40B4-BE49-F238E27FC236}">
                <a16:creationId xmlns:a16="http://schemas.microsoft.com/office/drawing/2014/main" id="{73EA16F8-776A-C534-8D5C-5FAC77F4DB21}"/>
              </a:ext>
            </a:extLst>
          </p:cNvPr>
          <p:cNvSpPr txBox="1"/>
          <p:nvPr/>
        </p:nvSpPr>
        <p:spPr>
          <a:xfrm>
            <a:off x="3305385" y="3320745"/>
            <a:ext cx="12153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800" dirty="0" err="1"/>
              <a:t>Helical</a:t>
            </a:r>
            <a:r>
              <a:rPr lang="da-DK" sz="800" dirty="0"/>
              <a:t> - </a:t>
            </a:r>
            <a:r>
              <a:rPr lang="da-DK" sz="800" dirty="0" err="1"/>
              <a:t>transmembrane</a:t>
            </a:r>
            <a:endParaRPr lang="da-DK" sz="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1AE69CB-8E14-D084-69CD-EF80D752EDA1}"/>
              </a:ext>
            </a:extLst>
          </p:cNvPr>
          <p:cNvSpPr txBox="1"/>
          <p:nvPr/>
        </p:nvSpPr>
        <p:spPr>
          <a:xfrm>
            <a:off x="2359403" y="5791564"/>
            <a:ext cx="52158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T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IFRPPRASH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RF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H</a:t>
            </a:r>
            <a:r>
              <a:rPr lang="en-US" sz="1800" u="sng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u="sng" baseline="-25000" dirty="0">
                <a:solidFill>
                  <a:srgbClr val="222222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69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WVGN</a:t>
            </a:r>
            <a:r>
              <a:rPr lang="en-US" sz="1800" u="sng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</a:t>
            </a:r>
            <a:endParaRPr lang="da-DK" dirty="0"/>
          </a:p>
        </p:txBody>
      </p:sp>
      <p:sp>
        <p:nvSpPr>
          <p:cNvPr id="14" name="Rektangel 27">
            <a:extLst>
              <a:ext uri="{FF2B5EF4-FFF2-40B4-BE49-F238E27FC236}">
                <a16:creationId xmlns:a16="http://schemas.microsoft.com/office/drawing/2014/main" id="{9A7B0C5E-2575-3158-9CCF-0F9E383F53D3}"/>
              </a:ext>
            </a:extLst>
          </p:cNvPr>
          <p:cNvSpPr/>
          <p:nvPr/>
        </p:nvSpPr>
        <p:spPr>
          <a:xfrm>
            <a:off x="5448648" y="5808342"/>
            <a:ext cx="798022" cy="348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5" name="Tekstfelt 17">
            <a:extLst>
              <a:ext uri="{FF2B5EF4-FFF2-40B4-BE49-F238E27FC236}">
                <a16:creationId xmlns:a16="http://schemas.microsoft.com/office/drawing/2014/main" id="{014E7998-A594-A7B2-33D4-4244B4B10D24}"/>
              </a:ext>
            </a:extLst>
          </p:cNvPr>
          <p:cNvSpPr txBox="1"/>
          <p:nvPr/>
        </p:nvSpPr>
        <p:spPr>
          <a:xfrm>
            <a:off x="2817862" y="4137496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C</a:t>
            </a:r>
            <a:r>
              <a:rPr lang="da-DK" baseline="-25000" dirty="0"/>
              <a:t>169</a:t>
            </a:r>
            <a:r>
              <a:rPr lang="da-DK" dirty="0"/>
              <a:t> –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16" name="Lige pilforbindelse 19">
            <a:extLst>
              <a:ext uri="{FF2B5EF4-FFF2-40B4-BE49-F238E27FC236}">
                <a16:creationId xmlns:a16="http://schemas.microsoft.com/office/drawing/2014/main" id="{4A93D0C1-483A-572B-7F20-B43D01B04F09}"/>
              </a:ext>
            </a:extLst>
          </p:cNvPr>
          <p:cNvCxnSpPr>
            <a:cxnSpLocks/>
          </p:cNvCxnSpPr>
          <p:nvPr/>
        </p:nvCxnSpPr>
        <p:spPr>
          <a:xfrm flipV="1">
            <a:off x="4225954" y="3144825"/>
            <a:ext cx="507495" cy="941594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Ellipse 20">
            <a:extLst>
              <a:ext uri="{FF2B5EF4-FFF2-40B4-BE49-F238E27FC236}">
                <a16:creationId xmlns:a16="http://schemas.microsoft.com/office/drawing/2014/main" id="{DD0DC885-80CB-F04E-73A3-75553CB2FF6A}"/>
              </a:ext>
            </a:extLst>
          </p:cNvPr>
          <p:cNvSpPr/>
          <p:nvPr/>
        </p:nvSpPr>
        <p:spPr>
          <a:xfrm>
            <a:off x="4553406" y="2741558"/>
            <a:ext cx="425335" cy="40940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8" name="Ellipse 23">
            <a:extLst>
              <a:ext uri="{FF2B5EF4-FFF2-40B4-BE49-F238E27FC236}">
                <a16:creationId xmlns:a16="http://schemas.microsoft.com/office/drawing/2014/main" id="{16B8FCBF-3509-D566-C04E-7B0F1B6BB74F}"/>
              </a:ext>
            </a:extLst>
          </p:cNvPr>
          <p:cNvSpPr/>
          <p:nvPr/>
        </p:nvSpPr>
        <p:spPr>
          <a:xfrm>
            <a:off x="4766073" y="2435186"/>
            <a:ext cx="911129" cy="758147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9" name="Tekstfelt 24">
            <a:extLst>
              <a:ext uri="{FF2B5EF4-FFF2-40B4-BE49-F238E27FC236}">
                <a16:creationId xmlns:a16="http://schemas.microsoft.com/office/drawing/2014/main" id="{1442E67B-5094-70C5-2D10-E6078F154870}"/>
              </a:ext>
            </a:extLst>
          </p:cNvPr>
          <p:cNvSpPr txBox="1"/>
          <p:nvPr/>
        </p:nvSpPr>
        <p:spPr>
          <a:xfrm>
            <a:off x="6923860" y="2946260"/>
            <a:ext cx="20837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/>
              <a:t>Cysteine</a:t>
            </a:r>
            <a:r>
              <a:rPr lang="da-DK" dirty="0"/>
              <a:t> </a:t>
            </a:r>
            <a:r>
              <a:rPr lang="da-DK" dirty="0" err="1"/>
              <a:t>stack</a:t>
            </a:r>
            <a:r>
              <a:rPr lang="da-DK" dirty="0"/>
              <a:t> - </a:t>
            </a:r>
            <a:r>
              <a:rPr lang="da-DK" dirty="0" err="1"/>
              <a:t>down</a:t>
            </a:r>
            <a:r>
              <a:rPr lang="da-DK" dirty="0"/>
              <a:t>-stream to </a:t>
            </a:r>
            <a:r>
              <a:rPr lang="da-DK" dirty="0" err="1"/>
              <a:t>active</a:t>
            </a:r>
            <a:r>
              <a:rPr lang="da-DK" dirty="0"/>
              <a:t> site</a:t>
            </a:r>
          </a:p>
        </p:txBody>
      </p:sp>
      <p:cxnSp>
        <p:nvCxnSpPr>
          <p:cNvPr id="20" name="Lige pilforbindelse 26">
            <a:extLst>
              <a:ext uri="{FF2B5EF4-FFF2-40B4-BE49-F238E27FC236}">
                <a16:creationId xmlns:a16="http://schemas.microsoft.com/office/drawing/2014/main" id="{59E5C673-1EFF-62A7-93AB-9E82B4B3C60C}"/>
              </a:ext>
            </a:extLst>
          </p:cNvPr>
          <p:cNvCxnSpPr>
            <a:cxnSpLocks/>
            <a:endCxn id="18" idx="6"/>
          </p:cNvCxnSpPr>
          <p:nvPr/>
        </p:nvCxnSpPr>
        <p:spPr>
          <a:xfrm flipH="1" flipV="1">
            <a:off x="5677202" y="2814260"/>
            <a:ext cx="1428273" cy="506485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902B0484-D375-8265-A17D-56B20D7D0111}"/>
              </a:ext>
            </a:extLst>
          </p:cNvPr>
          <p:cNvSpPr txBox="1"/>
          <p:nvPr/>
        </p:nvSpPr>
        <p:spPr>
          <a:xfrm>
            <a:off x="835943" y="445272"/>
            <a:ext cx="2400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ome discoverer coverag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31AF8D2-D23E-E7EE-EF35-A022BD88FBD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72" t="10778" r="2141" b="30287"/>
          <a:stretch/>
        </p:blipFill>
        <p:spPr>
          <a:xfrm>
            <a:off x="41359" y="753049"/>
            <a:ext cx="4066236" cy="1441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035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137</TotalTime>
  <Words>460</Words>
  <Application>Microsoft Office PowerPoint</Application>
  <PresentationFormat>A4 Paper (210x297 mm)</PresentationFormat>
  <Paragraphs>149</Paragraphs>
  <Slides>2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9" baseType="lpstr">
      <vt:lpstr>Arial</vt:lpstr>
      <vt:lpstr>Calibri</vt:lpstr>
      <vt:lpstr>Calibri Light</vt:lpstr>
      <vt:lpstr>IBM Plex San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Røssel Larsen</dc:creator>
  <cp:lastModifiedBy>Martin Røssel Larsen</cp:lastModifiedBy>
  <cp:revision>8</cp:revision>
  <dcterms:created xsi:type="dcterms:W3CDTF">2023-10-22T12:40:59Z</dcterms:created>
  <dcterms:modified xsi:type="dcterms:W3CDTF">2023-12-29T10:27:23Z</dcterms:modified>
</cp:coreProperties>
</file>